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0" r:id="rId5"/>
    <p:sldId id="297" r:id="rId6"/>
    <p:sldId id="299" r:id="rId7"/>
    <p:sldId id="298" r:id="rId8"/>
    <p:sldId id="300" r:id="rId9"/>
    <p:sldId id="321" r:id="rId10"/>
    <p:sldId id="317" r:id="rId11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0A297AA-B46D-C520-63BF-2B33AD158509}" name="MAGNIEN Sibylle" initials="MS" userId="S::sibylle.magnien@etu.univ-amu.fr::00f3f39e-5581-4b0e-a3ce-9b647692d70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799E13-5AD6-49B0-9DFB-6B19AC1E1004}" v="13" dt="2021-11-16T15:41:52.552"/>
    <p1510:client id="{0B251F41-084F-416E-88E5-36950206D137}" v="13" dt="2021-11-24T09:01:55.394"/>
    <p1510:client id="{3EBFB1D1-4A6A-4D63-B7E5-6EB1706DE1AA}" v="12" dt="2021-11-29T13:41:34.948"/>
    <p1510:client id="{4CF20B78-38A4-48F6-AEF0-B98DEA66DD0A}" v="1" dt="2021-11-29T10:17:14.574"/>
    <p1510:client id="{6D749871-2B05-4765-91A1-E9E68DA83802}" v="369" dt="2021-11-29T10:57:47.699"/>
    <p1510:client id="{70CA3314-24EB-49D0-A050-68A74CE3ACAF}" v="53" dt="2021-11-17T15:05:00.828"/>
    <p1510:client id="{71D83699-D5F2-4A17-8024-2370AC764EDA}" v="1" dt="2021-11-18T14:58:21.553"/>
    <p1510:client id="{7FE5AD0F-11D9-4AD0-A304-94419F318E10}" v="7" dt="2021-11-16T15:45:20.414"/>
    <p1510:client id="{9BE275BB-49B1-41A7-A970-1FDCB34A16D1}" v="152" dt="2021-11-16T15:46:51.064"/>
    <p1510:client id="{9F1BC57D-FC8F-4CCD-B6A8-A79B98EED97E}" v="17" dt="2021-11-19T09:05:44.743"/>
    <p1510:client id="{B645C030-3ADA-4865-ACEF-89542BC45270}" v="2" dt="2021-11-29T09:19:57.466"/>
    <p1510:client id="{BB4CBB1B-4145-463A-A12A-0393143911E5}" v="51" dt="2021-11-17T08:59:08.628"/>
    <p1510:client id="{BD834B6A-284F-4285-A0D6-B381F594D429}" v="1" dt="2021-11-29T10:18:41.124"/>
    <p1510:client id="{DE933594-E2B7-470E-BCD2-6E00E2DA19A6}" v="1" dt="2021-11-18T14:56:14.315"/>
    <p1510:client id="{E07327B2-4A9A-45A6-ABE9-48A4059F5A75}" v="215" dt="2021-11-29T14:35:55.40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99"/>
  </p:normalViewPr>
  <p:slideViewPr>
    <p:cSldViewPr snapToGrid="0">
      <p:cViewPr varScale="1">
        <p:scale>
          <a:sx n="103" d="100"/>
          <a:sy n="103" d="100"/>
        </p:scale>
        <p:origin x="8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GNIEN Sibylle" userId="S::sibylle.magnien@etu.univ-amu.fr::00f3f39e-5581-4b0e-a3ce-9b647692d70d" providerId="AD" clId="Web-{BD834B6A-284F-4285-A0D6-B381F594D429}"/>
    <pc:docChg chg="">
      <pc:chgData name="MAGNIEN Sibylle" userId="S::sibylle.magnien@etu.univ-amu.fr::00f3f39e-5581-4b0e-a3ce-9b647692d70d" providerId="AD" clId="Web-{BD834B6A-284F-4285-A0D6-B381F594D429}" dt="2021-11-29T10:18:41.124" v="0"/>
      <pc:docMkLst>
        <pc:docMk/>
      </pc:docMkLst>
      <pc:sldChg chg="addCm">
        <pc:chgData name="MAGNIEN Sibylle" userId="S::sibylle.magnien@etu.univ-amu.fr::00f3f39e-5581-4b0e-a3ce-9b647692d70d" providerId="AD" clId="Web-{BD834B6A-284F-4285-A0D6-B381F594D429}" dt="2021-11-29T10:18:41.124" v="0"/>
        <pc:sldMkLst>
          <pc:docMk/>
          <pc:sldMk cId="1151728771" sldId="300"/>
        </pc:sldMkLst>
      </pc:sldChg>
    </pc:docChg>
  </pc:docChgLst>
  <pc:docChgLst>
    <pc:chgData name="MAGNIEN Sibylle" userId="S::sibylle.magnien@etu.univ-amu.fr::00f3f39e-5581-4b0e-a3ce-9b647692d70d" providerId="AD" clId="Web-{D0FD2A23-5A94-4E63-93A9-FEB48C510C55}"/>
    <pc:docChg chg="mod modSld">
      <pc:chgData name="MAGNIEN Sibylle" userId="S::sibylle.magnien@etu.univ-amu.fr::00f3f39e-5581-4b0e-a3ce-9b647692d70d" providerId="AD" clId="Web-{D0FD2A23-5A94-4E63-93A9-FEB48C510C55}" dt="2021-11-04T12:40:48.570" v="18"/>
      <pc:docMkLst>
        <pc:docMk/>
      </pc:docMkLst>
      <pc:sldChg chg="modSp addCm">
        <pc:chgData name="MAGNIEN Sibylle" userId="S::sibylle.magnien@etu.univ-amu.fr::00f3f39e-5581-4b0e-a3ce-9b647692d70d" providerId="AD" clId="Web-{D0FD2A23-5A94-4E63-93A9-FEB48C510C55}" dt="2021-11-04T12:36:01.030" v="8" actId="20577"/>
        <pc:sldMkLst>
          <pc:docMk/>
          <pc:sldMk cId="1788306010" sldId="297"/>
        </pc:sldMkLst>
        <pc:spChg chg="mod">
          <ac:chgData name="MAGNIEN Sibylle" userId="S::sibylle.magnien@etu.univ-amu.fr::00f3f39e-5581-4b0e-a3ce-9b647692d70d" providerId="AD" clId="Web-{D0FD2A23-5A94-4E63-93A9-FEB48C510C55}" dt="2021-11-04T12:36:01.030" v="8" actId="20577"/>
          <ac:spMkLst>
            <pc:docMk/>
            <pc:sldMk cId="1788306010" sldId="297"/>
            <ac:spMk id="3" creationId="{285B274B-D595-4BF1-9789-CDBAB0B6BBFA}"/>
          </ac:spMkLst>
        </pc:spChg>
      </pc:sldChg>
      <pc:sldChg chg="addCm">
        <pc:chgData name="MAGNIEN Sibylle" userId="S::sibylle.magnien@etu.univ-amu.fr::00f3f39e-5581-4b0e-a3ce-9b647692d70d" providerId="AD" clId="Web-{D0FD2A23-5A94-4E63-93A9-FEB48C510C55}" dt="2021-11-04T12:36:23.593" v="13"/>
        <pc:sldMkLst>
          <pc:docMk/>
          <pc:sldMk cId="2950954147" sldId="298"/>
        </pc:sldMkLst>
      </pc:sldChg>
      <pc:sldChg chg="modSp addCm">
        <pc:chgData name="MAGNIEN Sibylle" userId="S::sibylle.magnien@etu.univ-amu.fr::00f3f39e-5581-4b0e-a3ce-9b647692d70d" providerId="AD" clId="Web-{D0FD2A23-5A94-4E63-93A9-FEB48C510C55}" dt="2021-11-04T12:36:15.328" v="12" actId="20577"/>
        <pc:sldMkLst>
          <pc:docMk/>
          <pc:sldMk cId="1126745183" sldId="299"/>
        </pc:sldMkLst>
        <pc:spChg chg="mod">
          <ac:chgData name="MAGNIEN Sibylle" userId="S::sibylle.magnien@etu.univ-amu.fr::00f3f39e-5581-4b0e-a3ce-9b647692d70d" providerId="AD" clId="Web-{D0FD2A23-5A94-4E63-93A9-FEB48C510C55}" dt="2021-11-04T12:36:15.328" v="12" actId="20577"/>
          <ac:spMkLst>
            <pc:docMk/>
            <pc:sldMk cId="1126745183" sldId="299"/>
            <ac:spMk id="8" creationId="{D030491D-5864-4845-B3B7-82ABD38F0071}"/>
          </ac:spMkLst>
        </pc:spChg>
      </pc:sldChg>
      <pc:sldChg chg="addCm">
        <pc:chgData name="MAGNIEN Sibylle" userId="S::sibylle.magnien@etu.univ-amu.fr::00f3f39e-5581-4b0e-a3ce-9b647692d70d" providerId="AD" clId="Web-{D0FD2A23-5A94-4E63-93A9-FEB48C510C55}" dt="2021-11-04T12:36:36.594" v="14"/>
        <pc:sldMkLst>
          <pc:docMk/>
          <pc:sldMk cId="1151728771" sldId="300"/>
        </pc:sldMkLst>
      </pc:sldChg>
      <pc:sldChg chg="modSp addCm">
        <pc:chgData name="MAGNIEN Sibylle" userId="S::sibylle.magnien@etu.univ-amu.fr::00f3f39e-5581-4b0e-a3ce-9b647692d70d" providerId="AD" clId="Web-{D0FD2A23-5A94-4E63-93A9-FEB48C510C55}" dt="2021-11-04T12:40:48.570" v="18"/>
        <pc:sldMkLst>
          <pc:docMk/>
          <pc:sldMk cId="1804244748" sldId="317"/>
        </pc:sldMkLst>
        <pc:graphicFrameChg chg="mod modGraphic">
          <ac:chgData name="MAGNIEN Sibylle" userId="S::sibylle.magnien@etu.univ-amu.fr::00f3f39e-5581-4b0e-a3ce-9b647692d70d" providerId="AD" clId="Web-{D0FD2A23-5A94-4E63-93A9-FEB48C510C55}" dt="2021-11-04T12:37:16.048" v="17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  <pc:sldChg chg="addCm">
        <pc:chgData name="MAGNIEN Sibylle" userId="S::sibylle.magnien@etu.univ-amu.fr::00f3f39e-5581-4b0e-a3ce-9b647692d70d" providerId="AD" clId="Web-{D0FD2A23-5A94-4E63-93A9-FEB48C510C55}" dt="2021-11-04T12:37:01.188" v="15"/>
        <pc:sldMkLst>
          <pc:docMk/>
          <pc:sldMk cId="1458466154" sldId="321"/>
        </pc:sldMkLst>
      </pc:sldChg>
    </pc:docChg>
  </pc:docChgLst>
  <pc:docChgLst>
    <pc:chgData name="MAGNIEN Sibylle" userId="S::sibylle.magnien@etu.univ-amu.fr::00f3f39e-5581-4b0e-a3ce-9b647692d70d" providerId="AD" clId="Web-{A3B26DB0-4540-4A4A-8D88-6C2B6A84072B}"/>
    <pc:docChg chg="modSld">
      <pc:chgData name="MAGNIEN Sibylle" userId="S::sibylle.magnien@etu.univ-amu.fr::00f3f39e-5581-4b0e-a3ce-9b647692d70d" providerId="AD" clId="Web-{A3B26DB0-4540-4A4A-8D88-6C2B6A84072B}" dt="2021-11-02T15:10:29.154" v="16"/>
      <pc:docMkLst>
        <pc:docMk/>
      </pc:docMkLst>
      <pc:sldChg chg="modSp">
        <pc:chgData name="MAGNIEN Sibylle" userId="S::sibylle.magnien@etu.univ-amu.fr::00f3f39e-5581-4b0e-a3ce-9b647692d70d" providerId="AD" clId="Web-{A3B26DB0-4540-4A4A-8D88-6C2B6A84072B}" dt="2021-11-02T15:09:27.544" v="7"/>
        <pc:sldMkLst>
          <pc:docMk/>
          <pc:sldMk cId="1788306010" sldId="297"/>
        </pc:sldMkLst>
        <pc:graphicFrameChg chg="mod modGraphic">
          <ac:chgData name="MAGNIEN Sibylle" userId="S::sibylle.magnien@etu.univ-amu.fr::00f3f39e-5581-4b0e-a3ce-9b647692d70d" providerId="AD" clId="Web-{A3B26DB0-4540-4A4A-8D88-6C2B6A84072B}" dt="2021-11-02T15:09:27.544" v="7"/>
          <ac:graphicFrameMkLst>
            <pc:docMk/>
            <pc:sldMk cId="1788306010" sldId="297"/>
            <ac:graphicFrameMk id="5" creationId="{20A18186-EEBC-4F1E-9B8C-29EBEB821735}"/>
          </ac:graphicFrameMkLst>
        </pc:graphicFrameChg>
      </pc:sldChg>
      <pc:sldChg chg="modSp">
        <pc:chgData name="MAGNIEN Sibylle" userId="S::sibylle.magnien@etu.univ-amu.fr::00f3f39e-5581-4b0e-a3ce-9b647692d70d" providerId="AD" clId="Web-{A3B26DB0-4540-4A4A-8D88-6C2B6A84072B}" dt="2021-11-02T15:09:54.169" v="8" actId="20577"/>
        <pc:sldMkLst>
          <pc:docMk/>
          <pc:sldMk cId="1126745183" sldId="299"/>
        </pc:sldMkLst>
        <pc:spChg chg="mod">
          <ac:chgData name="MAGNIEN Sibylle" userId="S::sibylle.magnien@etu.univ-amu.fr::00f3f39e-5581-4b0e-a3ce-9b647692d70d" providerId="AD" clId="Web-{A3B26DB0-4540-4A4A-8D88-6C2B6A84072B}" dt="2021-11-02T15:09:54.169" v="8" actId="20577"/>
          <ac:spMkLst>
            <pc:docMk/>
            <pc:sldMk cId="1126745183" sldId="299"/>
            <ac:spMk id="7" creationId="{248D695B-8F56-47D7-8171-D37F349DBBB1}"/>
          </ac:spMkLst>
        </pc:spChg>
      </pc:sldChg>
      <pc:sldChg chg="modSp">
        <pc:chgData name="MAGNIEN Sibylle" userId="S::sibylle.magnien@etu.univ-amu.fr::00f3f39e-5581-4b0e-a3ce-9b647692d70d" providerId="AD" clId="Web-{A3B26DB0-4540-4A4A-8D88-6C2B6A84072B}" dt="2021-11-02T15:10:29.154" v="16"/>
        <pc:sldMkLst>
          <pc:docMk/>
          <pc:sldMk cId="1151728771" sldId="300"/>
        </pc:sldMkLst>
        <pc:graphicFrameChg chg="mod modGraphic">
          <ac:chgData name="MAGNIEN Sibylle" userId="S::sibylle.magnien@etu.univ-amu.fr::00f3f39e-5581-4b0e-a3ce-9b647692d70d" providerId="AD" clId="Web-{A3B26DB0-4540-4A4A-8D88-6C2B6A84072B}" dt="2021-11-02T15:10:29.154" v="16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6BD648D6-68E7-44DD-A444-54735819E673}"/>
    <pc:docChg chg="modSld">
      <pc:chgData name="MAGNIEN Sibylle" userId="S::sibylle.magnien@etu.univ-amu.fr::00f3f39e-5581-4b0e-a3ce-9b647692d70d" providerId="AD" clId="Web-{6BD648D6-68E7-44DD-A444-54735819E673}" dt="2021-11-04T12:18:13.618" v="0" actId="14100"/>
      <pc:docMkLst>
        <pc:docMk/>
      </pc:docMkLst>
      <pc:sldChg chg="modSp">
        <pc:chgData name="MAGNIEN Sibylle" userId="S::sibylle.magnien@etu.univ-amu.fr::00f3f39e-5581-4b0e-a3ce-9b647692d70d" providerId="AD" clId="Web-{6BD648D6-68E7-44DD-A444-54735819E673}" dt="2021-11-04T12:18:13.618" v="0" actId="14100"/>
        <pc:sldMkLst>
          <pc:docMk/>
          <pc:sldMk cId="2950954147" sldId="298"/>
        </pc:sldMkLst>
        <pc:picChg chg="mod">
          <ac:chgData name="MAGNIEN Sibylle" userId="S::sibylle.magnien@etu.univ-amu.fr::00f3f39e-5581-4b0e-a3ce-9b647692d70d" providerId="AD" clId="Web-{6BD648D6-68E7-44DD-A444-54735819E673}" dt="2021-11-04T12:18:13.618" v="0" actId="14100"/>
          <ac:picMkLst>
            <pc:docMk/>
            <pc:sldMk cId="2950954147" sldId="298"/>
            <ac:picMk id="2" creationId="{7B38FB36-4974-43E8-ADFA-476761BF3B9A}"/>
          </ac:picMkLst>
        </pc:picChg>
      </pc:sldChg>
    </pc:docChg>
  </pc:docChgLst>
  <pc:docChgLst>
    <pc:chgData name="MAGNIEN Sibylle" userId="S::sibylle.magnien@etu.univ-amu.fr::00f3f39e-5581-4b0e-a3ce-9b647692d70d" providerId="AD" clId="Web-{71D83699-D5F2-4A17-8024-2370AC764EDA}"/>
    <pc:docChg chg="">
      <pc:chgData name="MAGNIEN Sibylle" userId="S::sibylle.magnien@etu.univ-amu.fr::00f3f39e-5581-4b0e-a3ce-9b647692d70d" providerId="AD" clId="Web-{71D83699-D5F2-4A17-8024-2370AC764EDA}" dt="2021-11-18T14:58:21.553" v="0"/>
      <pc:docMkLst>
        <pc:docMk/>
      </pc:docMkLst>
      <pc:sldChg chg="addCm">
        <pc:chgData name="MAGNIEN Sibylle" userId="S::sibylle.magnien@etu.univ-amu.fr::00f3f39e-5581-4b0e-a3ce-9b647692d70d" providerId="AD" clId="Web-{71D83699-D5F2-4A17-8024-2370AC764EDA}" dt="2021-11-18T14:58:21.553" v="0"/>
        <pc:sldMkLst>
          <pc:docMk/>
          <pc:sldMk cId="1804244748" sldId="317"/>
        </pc:sldMkLst>
      </pc:sldChg>
    </pc:docChg>
  </pc:docChgLst>
  <pc:docChgLst>
    <pc:chgData name="BOXBERGER Manon" userId="S::manon.boxberger@etu.univ-amu.fr::dcd9534c-6486-47eb-b404-c4522e1a425a" providerId="AD" clId="Web-{9BE275BB-49B1-41A7-A970-1FDCB34A16D1}"/>
    <pc:docChg chg="delSld modSld">
      <pc:chgData name="BOXBERGER Manon" userId="S::manon.boxberger@etu.univ-amu.fr::dcd9534c-6486-47eb-b404-c4522e1a425a" providerId="AD" clId="Web-{9BE275BB-49B1-41A7-A970-1FDCB34A16D1}" dt="2021-11-16T15:46:51.064" v="48"/>
      <pc:docMkLst>
        <pc:docMk/>
      </pc:docMkLst>
      <pc:sldChg chg="modSp delCm">
        <pc:chgData name="BOXBERGER Manon" userId="S::manon.boxberger@etu.univ-amu.fr::dcd9534c-6486-47eb-b404-c4522e1a425a" providerId="AD" clId="Web-{9BE275BB-49B1-41A7-A970-1FDCB34A16D1}" dt="2021-11-16T15:46:43.704" v="47"/>
        <pc:sldMkLst>
          <pc:docMk/>
          <pc:sldMk cId="1788306010" sldId="297"/>
        </pc:sldMkLst>
        <pc:spChg chg="mod">
          <ac:chgData name="BOXBERGER Manon" userId="S::manon.boxberger@etu.univ-amu.fr::dcd9534c-6486-47eb-b404-c4522e1a425a" providerId="AD" clId="Web-{9BE275BB-49B1-41A7-A970-1FDCB34A16D1}" dt="2021-11-16T15:43:25.965" v="8" actId="20577"/>
          <ac:spMkLst>
            <pc:docMk/>
            <pc:sldMk cId="1788306010" sldId="297"/>
            <ac:spMk id="3" creationId="{285B274B-D595-4BF1-9789-CDBAB0B6BBFA}"/>
          </ac:spMkLst>
        </pc:spChg>
      </pc:sldChg>
      <pc:sldChg chg="modSp delCm">
        <pc:chgData name="BOXBERGER Manon" userId="S::manon.boxberger@etu.univ-amu.fr::dcd9534c-6486-47eb-b404-c4522e1a425a" providerId="AD" clId="Web-{9BE275BB-49B1-41A7-A970-1FDCB34A16D1}" dt="2021-11-16T15:46:39.735" v="46"/>
        <pc:sldMkLst>
          <pc:docMk/>
          <pc:sldMk cId="2950954147" sldId="298"/>
        </pc:sldMkLst>
        <pc:spChg chg="mod">
          <ac:chgData name="BOXBERGER Manon" userId="S::manon.boxberger@etu.univ-amu.fr::dcd9534c-6486-47eb-b404-c4522e1a425a" providerId="AD" clId="Web-{9BE275BB-49B1-41A7-A970-1FDCB34A16D1}" dt="2021-11-16T15:43:40.028" v="14" actId="20577"/>
          <ac:spMkLst>
            <pc:docMk/>
            <pc:sldMk cId="2950954147" sldId="298"/>
            <ac:spMk id="3" creationId="{1967B0A9-1895-478D-93AC-44B5B1D0F4FA}"/>
          </ac:spMkLst>
        </pc:spChg>
      </pc:sldChg>
      <pc:sldChg chg="modSp delCm">
        <pc:chgData name="BOXBERGER Manon" userId="S::manon.boxberger@etu.univ-amu.fr::dcd9534c-6486-47eb-b404-c4522e1a425a" providerId="AD" clId="Web-{9BE275BB-49B1-41A7-A970-1FDCB34A16D1}" dt="2021-11-16T15:46:51.064" v="48"/>
        <pc:sldMkLst>
          <pc:docMk/>
          <pc:sldMk cId="1126745183" sldId="299"/>
        </pc:sldMkLst>
        <pc:spChg chg="mod">
          <ac:chgData name="BOXBERGER Manon" userId="S::manon.boxberger@etu.univ-amu.fr::dcd9534c-6486-47eb-b404-c4522e1a425a" providerId="AD" clId="Web-{9BE275BB-49B1-41A7-A970-1FDCB34A16D1}" dt="2021-11-16T15:43:22.684" v="6" actId="20577"/>
          <ac:spMkLst>
            <pc:docMk/>
            <pc:sldMk cId="1126745183" sldId="299"/>
            <ac:spMk id="8" creationId="{D030491D-5864-4845-B3B7-82ABD38F0071}"/>
          </ac:spMkLst>
        </pc:spChg>
      </pc:sldChg>
      <pc:sldChg chg="modSp delCm">
        <pc:chgData name="BOXBERGER Manon" userId="S::manon.boxberger@etu.univ-amu.fr::dcd9534c-6486-47eb-b404-c4522e1a425a" providerId="AD" clId="Web-{9BE275BB-49B1-41A7-A970-1FDCB34A16D1}" dt="2021-11-16T15:46:34.626" v="45"/>
        <pc:sldMkLst>
          <pc:docMk/>
          <pc:sldMk cId="1151728771" sldId="300"/>
        </pc:sldMkLst>
        <pc:spChg chg="mod">
          <ac:chgData name="BOXBERGER Manon" userId="S::manon.boxberger@etu.univ-amu.fr::dcd9534c-6486-47eb-b404-c4522e1a425a" providerId="AD" clId="Web-{9BE275BB-49B1-41A7-A970-1FDCB34A16D1}" dt="2021-11-16T15:43:44.715" v="17" actId="20577"/>
          <ac:spMkLst>
            <pc:docMk/>
            <pc:sldMk cId="1151728771" sldId="300"/>
            <ac:spMk id="3" creationId="{B41B8D2F-CDBE-4D9D-A08A-1E598664E786}"/>
          </ac:spMkLst>
        </pc:spChg>
      </pc:sldChg>
      <pc:sldChg chg="addSp modSp delCm">
        <pc:chgData name="BOXBERGER Manon" userId="S::manon.boxberger@etu.univ-amu.fr::dcd9534c-6486-47eb-b404-c4522e1a425a" providerId="AD" clId="Web-{9BE275BB-49B1-41A7-A970-1FDCB34A16D1}" dt="2021-11-16T15:46:23.954" v="43"/>
        <pc:sldMkLst>
          <pc:docMk/>
          <pc:sldMk cId="1804244748" sldId="317"/>
        </pc:sldMkLst>
        <pc:spChg chg="add mod">
          <ac:chgData name="BOXBERGER Manon" userId="S::manon.boxberger@etu.univ-amu.fr::dcd9534c-6486-47eb-b404-c4522e1a425a" providerId="AD" clId="Web-{9BE275BB-49B1-41A7-A970-1FDCB34A16D1}" dt="2021-11-16T15:46:15.235" v="42" actId="1076"/>
          <ac:spMkLst>
            <pc:docMk/>
            <pc:sldMk cId="1804244748" sldId="317"/>
            <ac:spMk id="2" creationId="{892DF8FF-4D99-4526-BA88-A2AC6772D690}"/>
          </ac:spMkLst>
        </pc:spChg>
        <pc:graphicFrameChg chg="mod modGraphic">
          <ac:chgData name="BOXBERGER Manon" userId="S::manon.boxberger@etu.univ-amu.fr::dcd9534c-6486-47eb-b404-c4522e1a425a" providerId="AD" clId="Web-{9BE275BB-49B1-41A7-A970-1FDCB34A16D1}" dt="2021-11-16T15:45:49.141" v="41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  <pc:sldChg chg="modSp delCm">
        <pc:chgData name="BOXBERGER Manon" userId="S::manon.boxberger@etu.univ-amu.fr::dcd9534c-6486-47eb-b404-c4522e1a425a" providerId="AD" clId="Web-{9BE275BB-49B1-41A7-A970-1FDCB34A16D1}" dt="2021-11-16T15:46:28.688" v="44"/>
        <pc:sldMkLst>
          <pc:docMk/>
          <pc:sldMk cId="1458466154" sldId="321"/>
        </pc:sldMkLst>
        <pc:spChg chg="mod">
          <ac:chgData name="BOXBERGER Manon" userId="S::manon.boxberger@etu.univ-amu.fr::dcd9534c-6486-47eb-b404-c4522e1a425a" providerId="AD" clId="Web-{9BE275BB-49B1-41A7-A970-1FDCB34A16D1}" dt="2021-11-16T15:43:47.887" v="19" actId="20577"/>
          <ac:spMkLst>
            <pc:docMk/>
            <pc:sldMk cId="1458466154" sldId="321"/>
            <ac:spMk id="3" creationId="{4AF18DD0-3CDE-46F3-B12F-7718A385427E}"/>
          </ac:spMkLst>
        </pc:spChg>
      </pc:sldChg>
      <pc:sldChg chg="del">
        <pc:chgData name="BOXBERGER Manon" userId="S::manon.boxberger@etu.univ-amu.fr::dcd9534c-6486-47eb-b404-c4522e1a425a" providerId="AD" clId="Web-{9BE275BB-49B1-41A7-A970-1FDCB34A16D1}" dt="2021-11-16T15:42:40.761" v="3"/>
        <pc:sldMkLst>
          <pc:docMk/>
          <pc:sldMk cId="1267952891" sldId="322"/>
        </pc:sldMkLst>
      </pc:sldChg>
    </pc:docChg>
  </pc:docChgLst>
  <pc:docChgLst>
    <pc:chgData name="MAGNIEN Sibylle" userId="S::sibylle.magnien@etu.univ-amu.fr::00f3f39e-5581-4b0e-a3ce-9b647692d70d" providerId="AD" clId="Web-{6D749871-2B05-4765-91A1-E9E68DA83802}"/>
    <pc:docChg chg="modSld">
      <pc:chgData name="MAGNIEN Sibylle" userId="S::sibylle.magnien@etu.univ-amu.fr::00f3f39e-5581-4b0e-a3ce-9b647692d70d" providerId="AD" clId="Web-{6D749871-2B05-4765-91A1-E9E68DA83802}" dt="2021-11-29T10:52:37.301" v="323"/>
      <pc:docMkLst>
        <pc:docMk/>
      </pc:docMkLst>
      <pc:sldChg chg="modSp addCm">
        <pc:chgData name="MAGNIEN Sibylle" userId="S::sibylle.magnien@etu.univ-amu.fr::00f3f39e-5581-4b0e-a3ce-9b647692d70d" providerId="AD" clId="Web-{6D749871-2B05-4765-91A1-E9E68DA83802}" dt="2021-11-29T10:52:37.301" v="323"/>
        <pc:sldMkLst>
          <pc:docMk/>
          <pc:sldMk cId="1151728771" sldId="300"/>
        </pc:sldMkLst>
        <pc:graphicFrameChg chg="mod modGraphic">
          <ac:chgData name="MAGNIEN Sibylle" userId="S::sibylle.magnien@etu.univ-amu.fr::00f3f39e-5581-4b0e-a3ce-9b647692d70d" providerId="AD" clId="Web-{6D749871-2B05-4765-91A1-E9E68DA83802}" dt="2021-11-29T10:50:34.673" v="322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954B54DF-0CEE-47B1-865F-CD365661EEDA}"/>
    <pc:docChg chg="modSld">
      <pc:chgData name="MAGNIEN Sibylle" userId="S::sibylle.magnien@etu.univ-amu.fr::00f3f39e-5581-4b0e-a3ce-9b647692d70d" providerId="AD" clId="Web-{954B54DF-0CEE-47B1-865F-CD365661EEDA}" dt="2021-11-04T10:58:37.345" v="1"/>
      <pc:docMkLst>
        <pc:docMk/>
      </pc:docMkLst>
      <pc:sldChg chg="modSp">
        <pc:chgData name="MAGNIEN Sibylle" userId="S::sibylle.magnien@etu.univ-amu.fr::00f3f39e-5581-4b0e-a3ce-9b647692d70d" providerId="AD" clId="Web-{954B54DF-0CEE-47B1-865F-CD365661EEDA}" dt="2021-11-04T10:58:37.345" v="1"/>
        <pc:sldMkLst>
          <pc:docMk/>
          <pc:sldMk cId="1151728771" sldId="300"/>
        </pc:sldMkLst>
        <pc:graphicFrameChg chg="mod modGraphic">
          <ac:chgData name="MAGNIEN Sibylle" userId="S::sibylle.magnien@etu.univ-amu.fr::00f3f39e-5581-4b0e-a3ce-9b647692d70d" providerId="AD" clId="Web-{954B54DF-0CEE-47B1-865F-CD365661EEDA}" dt="2021-11-04T10:58:37.345" v="1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889537B8-C416-4EEF-89C5-D8181DF40350}"/>
    <pc:docChg chg="modSld">
      <pc:chgData name="MAGNIEN Sibylle" userId="S::sibylle.magnien@etu.univ-amu.fr::00f3f39e-5581-4b0e-a3ce-9b647692d70d" providerId="AD" clId="Web-{889537B8-C416-4EEF-89C5-D8181DF40350}" dt="2021-11-03T10:57:07.248" v="8"/>
      <pc:docMkLst>
        <pc:docMk/>
      </pc:docMkLst>
      <pc:sldChg chg="modSp">
        <pc:chgData name="MAGNIEN Sibylle" userId="S::sibylle.magnien@etu.univ-amu.fr::00f3f39e-5581-4b0e-a3ce-9b647692d70d" providerId="AD" clId="Web-{889537B8-C416-4EEF-89C5-D8181DF40350}" dt="2021-11-03T10:57:07.248" v="8"/>
        <pc:sldMkLst>
          <pc:docMk/>
          <pc:sldMk cId="1151728771" sldId="300"/>
        </pc:sldMkLst>
        <pc:graphicFrameChg chg="mod modGraphic">
          <ac:chgData name="MAGNIEN Sibylle" userId="S::sibylle.magnien@etu.univ-amu.fr::00f3f39e-5581-4b0e-a3ce-9b647692d70d" providerId="AD" clId="Web-{889537B8-C416-4EEF-89C5-D8181DF40350}" dt="2021-11-03T10:57:07.248" v="8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1D1FF1CE-2D3A-4ED5-AE4E-3771C2ACD38C}"/>
    <pc:docChg chg="modSld">
      <pc:chgData name="MAGNIEN Sibylle" userId="S::sibylle.magnien@etu.univ-amu.fr::00f3f39e-5581-4b0e-a3ce-9b647692d70d" providerId="AD" clId="Web-{1D1FF1CE-2D3A-4ED5-AE4E-3771C2ACD38C}" dt="2021-11-02T15:19:17.032" v="1"/>
      <pc:docMkLst>
        <pc:docMk/>
      </pc:docMkLst>
      <pc:sldChg chg="modSp">
        <pc:chgData name="MAGNIEN Sibylle" userId="S::sibylle.magnien@etu.univ-amu.fr::00f3f39e-5581-4b0e-a3ce-9b647692d70d" providerId="AD" clId="Web-{1D1FF1CE-2D3A-4ED5-AE4E-3771C2ACD38C}" dt="2021-11-02T15:19:17.032" v="1"/>
        <pc:sldMkLst>
          <pc:docMk/>
          <pc:sldMk cId="1804244748" sldId="317"/>
        </pc:sldMkLst>
        <pc:graphicFrameChg chg="mod modGraphic">
          <ac:chgData name="MAGNIEN Sibylle" userId="S::sibylle.magnien@etu.univ-amu.fr::00f3f39e-5581-4b0e-a3ce-9b647692d70d" providerId="AD" clId="Web-{1D1FF1CE-2D3A-4ED5-AE4E-3771C2ACD38C}" dt="2021-11-02T15:19:17.032" v="1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3EBFB1D1-4A6A-4D63-B7E5-6EB1706DE1AA}"/>
    <pc:docChg chg="modSld">
      <pc:chgData name="MAGNIEN Sibylle" userId="S::sibylle.magnien@etu.univ-amu.fr::00f3f39e-5581-4b0e-a3ce-9b647692d70d" providerId="AD" clId="Web-{3EBFB1D1-4A6A-4D63-B7E5-6EB1706DE1AA}" dt="2021-11-29T13:41:32.995" v="3"/>
      <pc:docMkLst>
        <pc:docMk/>
      </pc:docMkLst>
      <pc:sldChg chg="modSp modCm">
        <pc:chgData name="MAGNIEN Sibylle" userId="S::sibylle.magnien@etu.univ-amu.fr::00f3f39e-5581-4b0e-a3ce-9b647692d70d" providerId="AD" clId="Web-{3EBFB1D1-4A6A-4D63-B7E5-6EB1706DE1AA}" dt="2021-11-29T13:41:32.995" v="3"/>
        <pc:sldMkLst>
          <pc:docMk/>
          <pc:sldMk cId="1151728771" sldId="300"/>
        </pc:sldMkLst>
        <pc:graphicFrameChg chg="mod modGraphic">
          <ac:chgData name="MAGNIEN Sibylle" userId="S::sibylle.magnien@etu.univ-amu.fr::00f3f39e-5581-4b0e-a3ce-9b647692d70d" providerId="AD" clId="Web-{3EBFB1D1-4A6A-4D63-B7E5-6EB1706DE1AA}" dt="2021-11-29T13:41:32.995" v="3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</pc:docChg>
  </pc:docChgLst>
  <pc:docChgLst>
    <pc:chgData name="Manon" userId="dcd9534c-6486-47eb-b404-c4522e1a425a" providerId="ADAL" clId="{06799E13-5AD6-49B0-9DFB-6B19AC1E1004}"/>
    <pc:docChg chg="modSld">
      <pc:chgData name="Manon" userId="dcd9534c-6486-47eb-b404-c4522e1a425a" providerId="ADAL" clId="{06799E13-5AD6-49B0-9DFB-6B19AC1E1004}" dt="2021-11-16T15:41:52.552" v="12" actId="20577"/>
      <pc:docMkLst>
        <pc:docMk/>
      </pc:docMkLst>
      <pc:sldChg chg="modSp">
        <pc:chgData name="Manon" userId="dcd9534c-6486-47eb-b404-c4522e1a425a" providerId="ADAL" clId="{06799E13-5AD6-49B0-9DFB-6B19AC1E1004}" dt="2021-11-16T15:41:52.552" v="12" actId="20577"/>
        <pc:sldMkLst>
          <pc:docMk/>
          <pc:sldMk cId="4083763800" sldId="270"/>
        </pc:sldMkLst>
        <pc:spChg chg="mod">
          <ac:chgData name="Manon" userId="dcd9534c-6486-47eb-b404-c4522e1a425a" providerId="ADAL" clId="{06799E13-5AD6-49B0-9DFB-6B19AC1E1004}" dt="2021-11-16T15:41:52.552" v="12" actId="20577"/>
          <ac:spMkLst>
            <pc:docMk/>
            <pc:sldMk cId="4083763800" sldId="270"/>
            <ac:spMk id="2" creationId="{C828E9F6-DE85-48ED-9FC7-8D9346584008}"/>
          </ac:spMkLst>
        </pc:spChg>
      </pc:sldChg>
    </pc:docChg>
  </pc:docChgLst>
  <pc:docChgLst>
    <pc:chgData name="MAGNIEN Sibylle" userId="S::sibylle.magnien@etu.univ-amu.fr::00f3f39e-5581-4b0e-a3ce-9b647692d70d" providerId="AD" clId="Web-{9F1BC57D-FC8F-4CCD-B6A8-A79B98EED97E}"/>
    <pc:docChg chg="modSld">
      <pc:chgData name="MAGNIEN Sibylle" userId="S::sibylle.magnien@etu.univ-amu.fr::00f3f39e-5581-4b0e-a3ce-9b647692d70d" providerId="AD" clId="Web-{9F1BC57D-FC8F-4CCD-B6A8-A79B98EED97E}" dt="2021-11-19T09:05:43.446" v="6" actId="20577"/>
      <pc:docMkLst>
        <pc:docMk/>
      </pc:docMkLst>
      <pc:sldChg chg="addCm">
        <pc:chgData name="MAGNIEN Sibylle" userId="S::sibylle.magnien@etu.univ-amu.fr::00f3f39e-5581-4b0e-a3ce-9b647692d70d" providerId="AD" clId="Web-{9F1BC57D-FC8F-4CCD-B6A8-A79B98EED97E}" dt="2021-11-19T09:04:30.007" v="0"/>
        <pc:sldMkLst>
          <pc:docMk/>
          <pc:sldMk cId="1788306010" sldId="297"/>
        </pc:sldMkLst>
      </pc:sldChg>
      <pc:sldChg chg="modSp">
        <pc:chgData name="MAGNIEN Sibylle" userId="S::sibylle.magnien@etu.univ-amu.fr::00f3f39e-5581-4b0e-a3ce-9b647692d70d" providerId="AD" clId="Web-{9F1BC57D-FC8F-4CCD-B6A8-A79B98EED97E}" dt="2021-11-19T09:05:19.321" v="3" actId="20577"/>
        <pc:sldMkLst>
          <pc:docMk/>
          <pc:sldMk cId="1126745183" sldId="299"/>
        </pc:sldMkLst>
        <pc:spChg chg="mod">
          <ac:chgData name="MAGNIEN Sibylle" userId="S::sibylle.magnien@etu.univ-amu.fr::00f3f39e-5581-4b0e-a3ce-9b647692d70d" providerId="AD" clId="Web-{9F1BC57D-FC8F-4CCD-B6A8-A79B98EED97E}" dt="2021-11-19T09:05:19.321" v="3" actId="20577"/>
          <ac:spMkLst>
            <pc:docMk/>
            <pc:sldMk cId="1126745183" sldId="299"/>
            <ac:spMk id="8" creationId="{D030491D-5864-4845-B3B7-82ABD38F0071}"/>
          </ac:spMkLst>
        </pc:spChg>
      </pc:sldChg>
      <pc:sldChg chg="modSp">
        <pc:chgData name="MAGNIEN Sibylle" userId="S::sibylle.magnien@etu.univ-amu.fr::00f3f39e-5581-4b0e-a3ce-9b647692d70d" providerId="AD" clId="Web-{9F1BC57D-FC8F-4CCD-B6A8-A79B98EED97E}" dt="2021-11-19T09:05:37.306" v="5" actId="20577"/>
        <pc:sldMkLst>
          <pc:docMk/>
          <pc:sldMk cId="1151728771" sldId="300"/>
        </pc:sldMkLst>
        <pc:spChg chg="mod">
          <ac:chgData name="MAGNIEN Sibylle" userId="S::sibylle.magnien@etu.univ-amu.fr::00f3f39e-5581-4b0e-a3ce-9b647692d70d" providerId="AD" clId="Web-{9F1BC57D-FC8F-4CCD-B6A8-A79B98EED97E}" dt="2021-11-19T09:05:37.306" v="5" actId="20577"/>
          <ac:spMkLst>
            <pc:docMk/>
            <pc:sldMk cId="1151728771" sldId="300"/>
            <ac:spMk id="3" creationId="{B41B8D2F-CDBE-4D9D-A08A-1E598664E786}"/>
          </ac:spMkLst>
        </pc:spChg>
      </pc:sldChg>
      <pc:sldChg chg="modSp">
        <pc:chgData name="MAGNIEN Sibylle" userId="S::sibylle.magnien@etu.univ-amu.fr::00f3f39e-5581-4b0e-a3ce-9b647692d70d" providerId="AD" clId="Web-{9F1BC57D-FC8F-4CCD-B6A8-A79B98EED97E}" dt="2021-11-19T09:05:43.446" v="6" actId="20577"/>
        <pc:sldMkLst>
          <pc:docMk/>
          <pc:sldMk cId="1804244748" sldId="317"/>
        </pc:sldMkLst>
        <pc:spChg chg="mod">
          <ac:chgData name="MAGNIEN Sibylle" userId="S::sibylle.magnien@etu.univ-amu.fr::00f3f39e-5581-4b0e-a3ce-9b647692d70d" providerId="AD" clId="Web-{9F1BC57D-FC8F-4CCD-B6A8-A79B98EED97E}" dt="2021-11-19T09:05:43.446" v="6" actId="20577"/>
          <ac:spMkLst>
            <pc:docMk/>
            <pc:sldMk cId="1804244748" sldId="317"/>
            <ac:spMk id="2" creationId="{892DF8FF-4D99-4526-BA88-A2AC6772D690}"/>
          </ac:spMkLst>
        </pc:spChg>
      </pc:sldChg>
    </pc:docChg>
  </pc:docChgLst>
  <pc:docChgLst>
    <pc:chgData name="MAGNIEN Sibylle" userId="S::sibylle.magnien@etu.univ-amu.fr::00f3f39e-5581-4b0e-a3ce-9b647692d70d" providerId="AD" clId="Web-{DF3D5AA4-5DBF-4CC2-BFA2-C60CAF60ACC0}"/>
    <pc:docChg chg="modSld">
      <pc:chgData name="MAGNIEN Sibylle" userId="S::sibylle.magnien@etu.univ-amu.fr::00f3f39e-5581-4b0e-a3ce-9b647692d70d" providerId="AD" clId="Web-{DF3D5AA4-5DBF-4CC2-BFA2-C60CAF60ACC0}" dt="2021-11-02T12:39:26.575" v="3"/>
      <pc:docMkLst>
        <pc:docMk/>
      </pc:docMkLst>
      <pc:sldChg chg="modSp">
        <pc:chgData name="MAGNIEN Sibylle" userId="S::sibylle.magnien@etu.univ-amu.fr::00f3f39e-5581-4b0e-a3ce-9b647692d70d" providerId="AD" clId="Web-{DF3D5AA4-5DBF-4CC2-BFA2-C60CAF60ACC0}" dt="2021-11-02T12:39:26.575" v="3"/>
        <pc:sldMkLst>
          <pc:docMk/>
          <pc:sldMk cId="1804244748" sldId="317"/>
        </pc:sldMkLst>
        <pc:graphicFrameChg chg="mod modGraphic">
          <ac:chgData name="MAGNIEN Sibylle" userId="S::sibylle.magnien@etu.univ-amu.fr::00f3f39e-5581-4b0e-a3ce-9b647692d70d" providerId="AD" clId="Web-{DF3D5AA4-5DBF-4CC2-BFA2-C60CAF60ACC0}" dt="2021-11-02T12:39:26.575" v="3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8A989AC3-4D28-4097-8B41-1B115BFA3954}"/>
    <pc:docChg chg="addSld modSld sldOrd">
      <pc:chgData name="MAGNIEN Sibylle" userId="S::sibylle.magnien@etu.univ-amu.fr::00f3f39e-5581-4b0e-a3ce-9b647692d70d" providerId="AD" clId="Web-{8A989AC3-4D28-4097-8B41-1B115BFA3954}" dt="2021-11-05T13:14:51.913" v="91"/>
      <pc:docMkLst>
        <pc:docMk/>
      </pc:docMkLst>
      <pc:sldChg chg="addCm">
        <pc:chgData name="MAGNIEN Sibylle" userId="S::sibylle.magnien@etu.univ-amu.fr::00f3f39e-5581-4b0e-a3ce-9b647692d70d" providerId="AD" clId="Web-{8A989AC3-4D28-4097-8B41-1B115BFA3954}" dt="2021-11-05T13:12:44.957" v="2"/>
        <pc:sldMkLst>
          <pc:docMk/>
          <pc:sldMk cId="1788306010" sldId="297"/>
        </pc:sldMkLst>
      </pc:sldChg>
      <pc:sldChg chg="addCm">
        <pc:chgData name="MAGNIEN Sibylle" userId="S::sibylle.magnien@etu.univ-amu.fr::00f3f39e-5581-4b0e-a3ce-9b647692d70d" providerId="AD" clId="Web-{8A989AC3-4D28-4097-8B41-1B115BFA3954}" dt="2021-11-05T13:13:11.458" v="4"/>
        <pc:sldMkLst>
          <pc:docMk/>
          <pc:sldMk cId="2950954147" sldId="298"/>
        </pc:sldMkLst>
      </pc:sldChg>
      <pc:sldChg chg="addCm">
        <pc:chgData name="MAGNIEN Sibylle" userId="S::sibylle.magnien@etu.univ-amu.fr::00f3f39e-5581-4b0e-a3ce-9b647692d70d" providerId="AD" clId="Web-{8A989AC3-4D28-4097-8B41-1B115BFA3954}" dt="2021-11-05T13:13:04.723" v="3"/>
        <pc:sldMkLst>
          <pc:docMk/>
          <pc:sldMk cId="1126745183" sldId="299"/>
        </pc:sldMkLst>
      </pc:sldChg>
      <pc:sldChg chg="addCm">
        <pc:chgData name="MAGNIEN Sibylle" userId="S::sibylle.magnien@etu.univ-amu.fr::00f3f39e-5581-4b0e-a3ce-9b647692d70d" providerId="AD" clId="Web-{8A989AC3-4D28-4097-8B41-1B115BFA3954}" dt="2021-11-05T13:13:20.661" v="5"/>
        <pc:sldMkLst>
          <pc:docMk/>
          <pc:sldMk cId="1151728771" sldId="300"/>
        </pc:sldMkLst>
      </pc:sldChg>
      <pc:sldChg chg="modSp addCm">
        <pc:chgData name="MAGNIEN Sibylle" userId="S::sibylle.magnien@etu.univ-amu.fr::00f3f39e-5581-4b0e-a3ce-9b647692d70d" providerId="AD" clId="Web-{8A989AC3-4D28-4097-8B41-1B115BFA3954}" dt="2021-11-05T13:14:51.913" v="91"/>
        <pc:sldMkLst>
          <pc:docMk/>
          <pc:sldMk cId="1804244748" sldId="317"/>
        </pc:sldMkLst>
        <pc:graphicFrameChg chg="mod modGraphic">
          <ac:chgData name="MAGNIEN Sibylle" userId="S::sibylle.magnien@etu.univ-amu.fr::00f3f39e-5581-4b0e-a3ce-9b647692d70d" providerId="AD" clId="Web-{8A989AC3-4D28-4097-8B41-1B115BFA3954}" dt="2021-11-05T13:14:51.913" v="91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  <pc:sldChg chg="addCm">
        <pc:chgData name="MAGNIEN Sibylle" userId="S::sibylle.magnien@etu.univ-amu.fr::00f3f39e-5581-4b0e-a3ce-9b647692d70d" providerId="AD" clId="Web-{8A989AC3-4D28-4097-8B41-1B115BFA3954}" dt="2021-11-05T13:13:36.990" v="6"/>
        <pc:sldMkLst>
          <pc:docMk/>
          <pc:sldMk cId="1458466154" sldId="321"/>
        </pc:sldMkLst>
      </pc:sldChg>
      <pc:sldChg chg="add ord">
        <pc:chgData name="MAGNIEN Sibylle" userId="S::sibylle.magnien@etu.univ-amu.fr::00f3f39e-5581-4b0e-a3ce-9b647692d70d" providerId="AD" clId="Web-{8A989AC3-4D28-4097-8B41-1B115BFA3954}" dt="2021-11-05T13:12:31.582" v="1"/>
        <pc:sldMkLst>
          <pc:docMk/>
          <pc:sldMk cId="1267952891" sldId="322"/>
        </pc:sldMkLst>
      </pc:sldChg>
    </pc:docChg>
  </pc:docChgLst>
  <pc:docChgLst>
    <pc:chgData name="MAGNIEN Sibylle" userId="S::sibylle.magnien@etu.univ-amu.fr::00f3f39e-5581-4b0e-a3ce-9b647692d70d" providerId="AD" clId="Web-{7FE5AD0F-11D9-4AD0-A304-94419F318E10}"/>
    <pc:docChg chg="modSld">
      <pc:chgData name="MAGNIEN Sibylle" userId="S::sibylle.magnien@etu.univ-amu.fr::00f3f39e-5581-4b0e-a3ce-9b647692d70d" providerId="AD" clId="Web-{7FE5AD0F-11D9-4AD0-A304-94419F318E10}" dt="2021-11-16T15:45:19.899" v="2" actId="20577"/>
      <pc:docMkLst>
        <pc:docMk/>
      </pc:docMkLst>
      <pc:sldChg chg="modSp">
        <pc:chgData name="MAGNIEN Sibylle" userId="S::sibylle.magnien@etu.univ-amu.fr::00f3f39e-5581-4b0e-a3ce-9b647692d70d" providerId="AD" clId="Web-{7FE5AD0F-11D9-4AD0-A304-94419F318E10}" dt="2021-11-16T15:45:19.899" v="2" actId="20577"/>
        <pc:sldMkLst>
          <pc:docMk/>
          <pc:sldMk cId="1151728771" sldId="300"/>
        </pc:sldMkLst>
        <pc:spChg chg="mod">
          <ac:chgData name="MAGNIEN Sibylle" userId="S::sibylle.magnien@etu.univ-amu.fr::00f3f39e-5581-4b0e-a3ce-9b647692d70d" providerId="AD" clId="Web-{7FE5AD0F-11D9-4AD0-A304-94419F318E10}" dt="2021-11-16T15:45:19.899" v="2" actId="20577"/>
          <ac:spMkLst>
            <pc:docMk/>
            <pc:sldMk cId="1151728771" sldId="300"/>
            <ac:spMk id="3" creationId="{B41B8D2F-CDBE-4D9D-A08A-1E598664E786}"/>
          </ac:spMkLst>
        </pc:spChg>
      </pc:sldChg>
    </pc:docChg>
  </pc:docChgLst>
  <pc:docChgLst>
    <pc:chgData name="MAGNIEN Sibylle" userId="S::sibylle.magnien@etu.univ-amu.fr::00f3f39e-5581-4b0e-a3ce-9b647692d70d" providerId="AD" clId="Web-{4CF20B78-38A4-48F6-AEF0-B98DEA66DD0A}"/>
    <pc:docChg chg="">
      <pc:chgData name="MAGNIEN Sibylle" userId="S::sibylle.magnien@etu.univ-amu.fr::00f3f39e-5581-4b0e-a3ce-9b647692d70d" providerId="AD" clId="Web-{4CF20B78-38A4-48F6-AEF0-B98DEA66DD0A}" dt="2021-11-29T10:17:14.574" v="0"/>
      <pc:docMkLst>
        <pc:docMk/>
      </pc:docMkLst>
      <pc:sldChg chg="addCm">
        <pc:chgData name="MAGNIEN Sibylle" userId="S::sibylle.magnien@etu.univ-amu.fr::00f3f39e-5581-4b0e-a3ce-9b647692d70d" providerId="AD" clId="Web-{4CF20B78-38A4-48F6-AEF0-B98DEA66DD0A}" dt="2021-11-29T10:17:14.574" v="0"/>
        <pc:sldMkLst>
          <pc:docMk/>
          <pc:sldMk cId="1151728771" sldId="300"/>
        </pc:sldMkLst>
      </pc:sldChg>
    </pc:docChg>
  </pc:docChgLst>
  <pc:docChgLst>
    <pc:chgData name="MAGNIEN Sibylle" userId="S::sibylle.magnien@etu.univ-amu.fr::00f3f39e-5581-4b0e-a3ce-9b647692d70d" providerId="AD" clId="Web-{B645C030-3ADA-4865-ACEF-89542BC45270}"/>
    <pc:docChg chg="">
      <pc:chgData name="MAGNIEN Sibylle" userId="S::sibylle.magnien@etu.univ-amu.fr::00f3f39e-5581-4b0e-a3ce-9b647692d70d" providerId="AD" clId="Web-{B645C030-3ADA-4865-ACEF-89542BC45270}" dt="2021-11-29T09:19:57.466" v="1"/>
      <pc:docMkLst>
        <pc:docMk/>
      </pc:docMkLst>
      <pc:sldChg chg="addCm">
        <pc:chgData name="MAGNIEN Sibylle" userId="S::sibylle.magnien@etu.univ-amu.fr::00f3f39e-5581-4b0e-a3ce-9b647692d70d" providerId="AD" clId="Web-{B645C030-3ADA-4865-ACEF-89542BC45270}" dt="2021-11-29T09:18:26.136" v="0"/>
        <pc:sldMkLst>
          <pc:docMk/>
          <pc:sldMk cId="4083763800" sldId="270"/>
        </pc:sldMkLst>
      </pc:sldChg>
      <pc:sldChg chg="addCm">
        <pc:chgData name="MAGNIEN Sibylle" userId="S::sibylle.magnien@etu.univ-amu.fr::00f3f39e-5581-4b0e-a3ce-9b647692d70d" providerId="AD" clId="Web-{B645C030-3ADA-4865-ACEF-89542BC45270}" dt="2021-11-29T09:19:57.466" v="1"/>
        <pc:sldMkLst>
          <pc:docMk/>
          <pc:sldMk cId="1151728771" sldId="300"/>
        </pc:sldMkLst>
      </pc:sldChg>
    </pc:docChg>
  </pc:docChgLst>
  <pc:docChgLst>
    <pc:chgData name="MAGNIEN Sibylle" userId="S::sibylle.magnien@etu.univ-amu.fr::00f3f39e-5581-4b0e-a3ce-9b647692d70d" providerId="AD" clId="Web-{FF65B89D-7BD1-46E7-9474-76E0B9A3C75F}"/>
    <pc:docChg chg="">
      <pc:chgData name="MAGNIEN Sibylle" userId="S::sibylle.magnien@etu.univ-amu.fr::00f3f39e-5581-4b0e-a3ce-9b647692d70d" providerId="AD" clId="Web-{FF65B89D-7BD1-46E7-9474-76E0B9A3C75F}" dt="2021-11-04T12:42:23.173" v="5"/>
      <pc:docMkLst>
        <pc:docMk/>
      </pc:docMkLst>
      <pc:sldChg chg="delCm">
        <pc:chgData name="MAGNIEN Sibylle" userId="S::sibylle.magnien@etu.univ-amu.fr::00f3f39e-5581-4b0e-a3ce-9b647692d70d" providerId="AD" clId="Web-{FF65B89D-7BD1-46E7-9474-76E0B9A3C75F}" dt="2021-11-04T12:41:59.516" v="0"/>
        <pc:sldMkLst>
          <pc:docMk/>
          <pc:sldMk cId="1788306010" sldId="297"/>
        </pc:sldMkLst>
      </pc:sldChg>
      <pc:sldChg chg="delCm">
        <pc:chgData name="MAGNIEN Sibylle" userId="S::sibylle.magnien@etu.univ-amu.fr::00f3f39e-5581-4b0e-a3ce-9b647692d70d" providerId="AD" clId="Web-{FF65B89D-7BD1-46E7-9474-76E0B9A3C75F}" dt="2021-11-04T12:42:09.110" v="2"/>
        <pc:sldMkLst>
          <pc:docMk/>
          <pc:sldMk cId="2950954147" sldId="298"/>
        </pc:sldMkLst>
      </pc:sldChg>
      <pc:sldChg chg="delCm">
        <pc:chgData name="MAGNIEN Sibylle" userId="S::sibylle.magnien@etu.univ-amu.fr::00f3f39e-5581-4b0e-a3ce-9b647692d70d" providerId="AD" clId="Web-{FF65B89D-7BD1-46E7-9474-76E0B9A3C75F}" dt="2021-11-04T12:42:05.220" v="1"/>
        <pc:sldMkLst>
          <pc:docMk/>
          <pc:sldMk cId="1126745183" sldId="299"/>
        </pc:sldMkLst>
      </pc:sldChg>
      <pc:sldChg chg="delCm">
        <pc:chgData name="MAGNIEN Sibylle" userId="S::sibylle.magnien@etu.univ-amu.fr::00f3f39e-5581-4b0e-a3ce-9b647692d70d" providerId="AD" clId="Web-{FF65B89D-7BD1-46E7-9474-76E0B9A3C75F}" dt="2021-11-04T12:42:14.657" v="3"/>
        <pc:sldMkLst>
          <pc:docMk/>
          <pc:sldMk cId="1151728771" sldId="300"/>
        </pc:sldMkLst>
      </pc:sldChg>
      <pc:sldChg chg="delCm">
        <pc:chgData name="MAGNIEN Sibylle" userId="S::sibylle.magnien@etu.univ-amu.fr::00f3f39e-5581-4b0e-a3ce-9b647692d70d" providerId="AD" clId="Web-{FF65B89D-7BD1-46E7-9474-76E0B9A3C75F}" dt="2021-11-04T12:42:23.173" v="5"/>
        <pc:sldMkLst>
          <pc:docMk/>
          <pc:sldMk cId="1804244748" sldId="317"/>
        </pc:sldMkLst>
      </pc:sldChg>
      <pc:sldChg chg="delCm">
        <pc:chgData name="MAGNIEN Sibylle" userId="S::sibylle.magnien@etu.univ-amu.fr::00f3f39e-5581-4b0e-a3ce-9b647692d70d" providerId="AD" clId="Web-{FF65B89D-7BD1-46E7-9474-76E0B9A3C75F}" dt="2021-11-04T12:42:18.923" v="4"/>
        <pc:sldMkLst>
          <pc:docMk/>
          <pc:sldMk cId="1458466154" sldId="321"/>
        </pc:sldMkLst>
      </pc:sldChg>
    </pc:docChg>
  </pc:docChgLst>
  <pc:docChgLst>
    <pc:chgData name="MAGNIEN Sibylle" userId="S::sibylle.magnien@etu.univ-amu.fr::00f3f39e-5581-4b0e-a3ce-9b647692d70d" providerId="AD" clId="Web-{70CA3314-24EB-49D0-A050-68A74CE3ACAF}"/>
    <pc:docChg chg="modSld">
      <pc:chgData name="MAGNIEN Sibylle" userId="S::sibylle.magnien@etu.univ-amu.fr::00f3f39e-5581-4b0e-a3ce-9b647692d70d" providerId="AD" clId="Web-{70CA3314-24EB-49D0-A050-68A74CE3ACAF}" dt="2021-11-17T15:04:58.485" v="5" actId="20577"/>
      <pc:docMkLst>
        <pc:docMk/>
      </pc:docMkLst>
      <pc:sldChg chg="modSp">
        <pc:chgData name="MAGNIEN Sibylle" userId="S::sibylle.magnien@etu.univ-amu.fr::00f3f39e-5581-4b0e-a3ce-9b647692d70d" providerId="AD" clId="Web-{70CA3314-24EB-49D0-A050-68A74CE3ACAF}" dt="2021-11-17T15:04:43.453" v="3" actId="1076"/>
        <pc:sldMkLst>
          <pc:docMk/>
          <pc:sldMk cId="1788306010" sldId="297"/>
        </pc:sldMkLst>
        <pc:graphicFrameChg chg="mod modGraphic">
          <ac:chgData name="MAGNIEN Sibylle" userId="S::sibylle.magnien@etu.univ-amu.fr::00f3f39e-5581-4b0e-a3ce-9b647692d70d" providerId="AD" clId="Web-{70CA3314-24EB-49D0-A050-68A74CE3ACAF}" dt="2021-11-17T15:04:43.453" v="3" actId="1076"/>
          <ac:graphicFrameMkLst>
            <pc:docMk/>
            <pc:sldMk cId="1788306010" sldId="297"/>
            <ac:graphicFrameMk id="5" creationId="{20A18186-EEBC-4F1E-9B8C-29EBEB821735}"/>
          </ac:graphicFrameMkLst>
        </pc:graphicFrameChg>
      </pc:sldChg>
      <pc:sldChg chg="modSp">
        <pc:chgData name="MAGNIEN Sibylle" userId="S::sibylle.magnien@etu.univ-amu.fr::00f3f39e-5581-4b0e-a3ce-9b647692d70d" providerId="AD" clId="Web-{70CA3314-24EB-49D0-A050-68A74CE3ACAF}" dt="2021-11-17T15:04:58.485" v="5" actId="20577"/>
        <pc:sldMkLst>
          <pc:docMk/>
          <pc:sldMk cId="1126745183" sldId="299"/>
        </pc:sldMkLst>
        <pc:spChg chg="mod">
          <ac:chgData name="MAGNIEN Sibylle" userId="S::sibylle.magnien@etu.univ-amu.fr::00f3f39e-5581-4b0e-a3ce-9b647692d70d" providerId="AD" clId="Web-{70CA3314-24EB-49D0-A050-68A74CE3ACAF}" dt="2021-11-17T15:04:58.485" v="5" actId="20577"/>
          <ac:spMkLst>
            <pc:docMk/>
            <pc:sldMk cId="1126745183" sldId="299"/>
            <ac:spMk id="8" creationId="{D030491D-5864-4845-B3B7-82ABD38F0071}"/>
          </ac:spMkLst>
        </pc:spChg>
      </pc:sldChg>
    </pc:docChg>
  </pc:docChgLst>
  <pc:docChgLst>
    <pc:chgData name="MAGNIEN Sibylle" userId="S::sibylle.magnien@etu.univ-amu.fr::00f3f39e-5581-4b0e-a3ce-9b647692d70d" providerId="AD" clId="Web-{0B251F41-084F-416E-88E5-36950206D137}"/>
    <pc:docChg chg="modSld">
      <pc:chgData name="MAGNIEN Sibylle" userId="S::sibylle.magnien@etu.univ-amu.fr::00f3f39e-5581-4b0e-a3ce-9b647692d70d" providerId="AD" clId="Web-{0B251F41-084F-416E-88E5-36950206D137}" dt="2021-11-24T09:01:55.394" v="8"/>
      <pc:docMkLst>
        <pc:docMk/>
      </pc:docMkLst>
      <pc:sldChg chg="modSp">
        <pc:chgData name="MAGNIEN Sibylle" userId="S::sibylle.magnien@etu.univ-amu.fr::00f3f39e-5581-4b0e-a3ce-9b647692d70d" providerId="AD" clId="Web-{0B251F41-084F-416E-88E5-36950206D137}" dt="2021-11-24T08:56:08.685" v="2" actId="20577"/>
        <pc:sldMkLst>
          <pc:docMk/>
          <pc:sldMk cId="4083763800" sldId="270"/>
        </pc:sldMkLst>
        <pc:spChg chg="mod">
          <ac:chgData name="MAGNIEN Sibylle" userId="S::sibylle.magnien@etu.univ-amu.fr::00f3f39e-5581-4b0e-a3ce-9b647692d70d" providerId="AD" clId="Web-{0B251F41-084F-416E-88E5-36950206D137}" dt="2021-11-24T08:56:08.685" v="2" actId="20577"/>
          <ac:spMkLst>
            <pc:docMk/>
            <pc:sldMk cId="4083763800" sldId="270"/>
            <ac:spMk id="2" creationId="{C828E9F6-DE85-48ED-9FC7-8D9346584008}"/>
          </ac:spMkLst>
        </pc:spChg>
      </pc:sldChg>
      <pc:sldChg chg="addCm">
        <pc:chgData name="MAGNIEN Sibylle" userId="S::sibylle.magnien@etu.univ-amu.fr::00f3f39e-5581-4b0e-a3ce-9b647692d70d" providerId="AD" clId="Web-{0B251F41-084F-416E-88E5-36950206D137}" dt="2021-11-24T09:01:55.394" v="8"/>
        <pc:sldMkLst>
          <pc:docMk/>
          <pc:sldMk cId="1804244748" sldId="317"/>
        </pc:sldMkLst>
      </pc:sldChg>
    </pc:docChg>
  </pc:docChgLst>
  <pc:docChgLst>
    <pc:chgData name="MAGNIEN Sibylle" userId="S::sibylle.magnien@etu.univ-amu.fr::00f3f39e-5581-4b0e-a3ce-9b647692d70d" providerId="AD" clId="Web-{F8398815-182D-43E8-BB3E-C74B6B7B29BF}"/>
    <pc:docChg chg="modSld">
      <pc:chgData name="MAGNIEN Sibylle" userId="S::sibylle.magnien@etu.univ-amu.fr::00f3f39e-5581-4b0e-a3ce-9b647692d70d" providerId="AD" clId="Web-{F8398815-182D-43E8-BB3E-C74B6B7B29BF}" dt="2021-11-05T14:10:22.803" v="7"/>
      <pc:docMkLst>
        <pc:docMk/>
      </pc:docMkLst>
      <pc:sldChg chg="modSp">
        <pc:chgData name="MAGNIEN Sibylle" userId="S::sibylle.magnien@etu.univ-amu.fr::00f3f39e-5581-4b0e-a3ce-9b647692d70d" providerId="AD" clId="Web-{F8398815-182D-43E8-BB3E-C74B6B7B29BF}" dt="2021-11-05T14:10:22.803" v="7"/>
        <pc:sldMkLst>
          <pc:docMk/>
          <pc:sldMk cId="1151728771" sldId="300"/>
        </pc:sldMkLst>
        <pc:graphicFrameChg chg="mod modGraphic">
          <ac:chgData name="MAGNIEN Sibylle" userId="S::sibylle.magnien@etu.univ-amu.fr::00f3f39e-5581-4b0e-a3ce-9b647692d70d" providerId="AD" clId="Web-{F8398815-182D-43E8-BB3E-C74B6B7B29BF}" dt="2021-11-05T14:10:22.803" v="7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</pc:docChg>
  </pc:docChgLst>
  <pc:docChgLst>
    <pc:chgData name="BOXBERGER Manon" userId="S::manon.boxberger@etu.univ-amu.fr::dcd9534c-6486-47eb-b404-c4522e1a425a" providerId="AD" clId="Web-{E07327B2-4A9A-45A6-ABE9-48A4059F5A75}"/>
    <pc:docChg chg="modSld">
      <pc:chgData name="BOXBERGER Manon" userId="S::manon.boxberger@etu.univ-amu.fr::dcd9534c-6486-47eb-b404-c4522e1a425a" providerId="AD" clId="Web-{E07327B2-4A9A-45A6-ABE9-48A4059F5A75}" dt="2021-11-29T14:35:55.405" v="94"/>
      <pc:docMkLst>
        <pc:docMk/>
      </pc:docMkLst>
      <pc:sldChg chg="modSp delCm modCm">
        <pc:chgData name="BOXBERGER Manon" userId="S::manon.boxberger@etu.univ-amu.fr::dcd9534c-6486-47eb-b404-c4522e1a425a" providerId="AD" clId="Web-{E07327B2-4A9A-45A6-ABE9-48A4059F5A75}" dt="2021-11-29T14:28:57.298" v="2" actId="20577"/>
        <pc:sldMkLst>
          <pc:docMk/>
          <pc:sldMk cId="4083763800" sldId="270"/>
        </pc:sldMkLst>
        <pc:spChg chg="mod">
          <ac:chgData name="BOXBERGER Manon" userId="S::manon.boxberger@etu.univ-amu.fr::dcd9534c-6486-47eb-b404-c4522e1a425a" providerId="AD" clId="Web-{E07327B2-4A9A-45A6-ABE9-48A4059F5A75}" dt="2021-11-29T14:28:57.298" v="2" actId="20577"/>
          <ac:spMkLst>
            <pc:docMk/>
            <pc:sldMk cId="4083763800" sldId="270"/>
            <ac:spMk id="2" creationId="{C828E9F6-DE85-48ED-9FC7-8D9346584008}"/>
          </ac:spMkLst>
        </pc:spChg>
      </pc:sldChg>
      <pc:sldChg chg="modSp delCm">
        <pc:chgData name="BOXBERGER Manon" userId="S::manon.boxberger@etu.univ-amu.fr::dcd9534c-6486-47eb-b404-c4522e1a425a" providerId="AD" clId="Web-{E07327B2-4A9A-45A6-ABE9-48A4059F5A75}" dt="2021-11-29T14:29:48.956" v="45"/>
        <pc:sldMkLst>
          <pc:docMk/>
          <pc:sldMk cId="1788306010" sldId="297"/>
        </pc:sldMkLst>
        <pc:graphicFrameChg chg="mod modGraphic">
          <ac:chgData name="BOXBERGER Manon" userId="S::manon.boxberger@etu.univ-amu.fr::dcd9534c-6486-47eb-b404-c4522e1a425a" providerId="AD" clId="Web-{E07327B2-4A9A-45A6-ABE9-48A4059F5A75}" dt="2021-11-29T14:29:45.784" v="44"/>
          <ac:graphicFrameMkLst>
            <pc:docMk/>
            <pc:sldMk cId="1788306010" sldId="297"/>
            <ac:graphicFrameMk id="5" creationId="{20A18186-EEBC-4F1E-9B8C-29EBEB821735}"/>
          </ac:graphicFrameMkLst>
        </pc:graphicFrameChg>
      </pc:sldChg>
      <pc:sldChg chg="modSp delCm modCm">
        <pc:chgData name="BOXBERGER Manon" userId="S::manon.boxberger@etu.univ-amu.fr::dcd9534c-6486-47eb-b404-c4522e1a425a" providerId="AD" clId="Web-{E07327B2-4A9A-45A6-ABE9-48A4059F5A75}" dt="2021-11-29T14:31:43.475" v="61"/>
        <pc:sldMkLst>
          <pc:docMk/>
          <pc:sldMk cId="1151728771" sldId="300"/>
        </pc:sldMkLst>
        <pc:graphicFrameChg chg="mod modGraphic">
          <ac:chgData name="BOXBERGER Manon" userId="S::manon.boxberger@etu.univ-amu.fr::dcd9534c-6486-47eb-b404-c4522e1a425a" providerId="AD" clId="Web-{E07327B2-4A9A-45A6-ABE9-48A4059F5A75}" dt="2021-11-29T14:30:56.739" v="58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  <pc:sldChg chg="modSp delCm modCm">
        <pc:chgData name="BOXBERGER Manon" userId="S::manon.boxberger@etu.univ-amu.fr::dcd9534c-6486-47eb-b404-c4522e1a425a" providerId="AD" clId="Web-{E07327B2-4A9A-45A6-ABE9-48A4059F5A75}" dt="2021-11-29T14:35:55.405" v="94"/>
        <pc:sldMkLst>
          <pc:docMk/>
          <pc:sldMk cId="1804244748" sldId="317"/>
        </pc:sldMkLst>
        <pc:graphicFrameChg chg="mod modGraphic">
          <ac:chgData name="BOXBERGER Manon" userId="S::manon.boxberger@etu.univ-amu.fr::dcd9534c-6486-47eb-b404-c4522e1a425a" providerId="AD" clId="Web-{E07327B2-4A9A-45A6-ABE9-48A4059F5A75}" dt="2021-11-29T14:34:42.496" v="91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BFB78B31-B244-4173-98B7-21275F26BAA5}"/>
    <pc:docChg chg="modSld">
      <pc:chgData name="MAGNIEN Sibylle" userId="S::sibylle.magnien@etu.univ-amu.fr::00f3f39e-5581-4b0e-a3ce-9b647692d70d" providerId="AD" clId="Web-{BFB78B31-B244-4173-98B7-21275F26BAA5}" dt="2021-11-04T08:29:15.548" v="1" actId="1076"/>
      <pc:docMkLst>
        <pc:docMk/>
      </pc:docMkLst>
      <pc:sldChg chg="modSp">
        <pc:chgData name="MAGNIEN Sibylle" userId="S::sibylle.magnien@etu.univ-amu.fr::00f3f39e-5581-4b0e-a3ce-9b647692d70d" providerId="AD" clId="Web-{BFB78B31-B244-4173-98B7-21275F26BAA5}" dt="2021-11-04T08:29:15.548" v="1" actId="1076"/>
        <pc:sldMkLst>
          <pc:docMk/>
          <pc:sldMk cId="1151728771" sldId="300"/>
        </pc:sldMkLst>
        <pc:graphicFrameChg chg="mod modGraphic">
          <ac:chgData name="MAGNIEN Sibylle" userId="S::sibylle.magnien@etu.univ-amu.fr::00f3f39e-5581-4b0e-a3ce-9b647692d70d" providerId="AD" clId="Web-{BFB78B31-B244-4173-98B7-21275F26BAA5}" dt="2021-11-04T08:29:15.548" v="1" actId="1076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BB4CBB1B-4145-463A-A12A-0393143911E5}"/>
    <pc:docChg chg="modSld">
      <pc:chgData name="MAGNIEN Sibylle" userId="S::sibylle.magnien@etu.univ-amu.fr::00f3f39e-5581-4b0e-a3ce-9b647692d70d" providerId="AD" clId="Web-{BB4CBB1B-4145-463A-A12A-0393143911E5}" dt="2021-11-17T08:59:08.628" v="31" actId="1076"/>
      <pc:docMkLst>
        <pc:docMk/>
      </pc:docMkLst>
      <pc:sldChg chg="modSp">
        <pc:chgData name="MAGNIEN Sibylle" userId="S::sibylle.magnien@etu.univ-amu.fr::00f3f39e-5581-4b0e-a3ce-9b647692d70d" providerId="AD" clId="Web-{BB4CBB1B-4145-463A-A12A-0393143911E5}" dt="2021-11-17T08:56:56.510" v="1" actId="14100"/>
        <pc:sldMkLst>
          <pc:docMk/>
          <pc:sldMk cId="1788306010" sldId="297"/>
        </pc:sldMkLst>
        <pc:spChg chg="mod">
          <ac:chgData name="MAGNIEN Sibylle" userId="S::sibylle.magnien@etu.univ-amu.fr::00f3f39e-5581-4b0e-a3ce-9b647692d70d" providerId="AD" clId="Web-{BB4CBB1B-4145-463A-A12A-0393143911E5}" dt="2021-11-17T08:56:56.510" v="1" actId="14100"/>
          <ac:spMkLst>
            <pc:docMk/>
            <pc:sldMk cId="1788306010" sldId="297"/>
            <ac:spMk id="3" creationId="{285B274B-D595-4BF1-9789-CDBAB0B6BBFA}"/>
          </ac:spMkLst>
        </pc:spChg>
      </pc:sldChg>
      <pc:sldChg chg="modSp">
        <pc:chgData name="MAGNIEN Sibylle" userId="S::sibylle.magnien@etu.univ-amu.fr::00f3f39e-5581-4b0e-a3ce-9b647692d70d" providerId="AD" clId="Web-{BB4CBB1B-4145-463A-A12A-0393143911E5}" dt="2021-11-17T08:57:35.013" v="7" actId="20577"/>
        <pc:sldMkLst>
          <pc:docMk/>
          <pc:sldMk cId="2950954147" sldId="298"/>
        </pc:sldMkLst>
        <pc:spChg chg="mod">
          <ac:chgData name="MAGNIEN Sibylle" userId="S::sibylle.magnien@etu.univ-amu.fr::00f3f39e-5581-4b0e-a3ce-9b647692d70d" providerId="AD" clId="Web-{BB4CBB1B-4145-463A-A12A-0393143911E5}" dt="2021-11-17T08:57:35.013" v="7" actId="20577"/>
          <ac:spMkLst>
            <pc:docMk/>
            <pc:sldMk cId="2950954147" sldId="298"/>
            <ac:spMk id="3" creationId="{1967B0A9-1895-478D-93AC-44B5B1D0F4FA}"/>
          </ac:spMkLst>
        </pc:spChg>
        <pc:picChg chg="mod">
          <ac:chgData name="MAGNIEN Sibylle" userId="S::sibylle.magnien@etu.univ-amu.fr::00f3f39e-5581-4b0e-a3ce-9b647692d70d" providerId="AD" clId="Web-{BB4CBB1B-4145-463A-A12A-0393143911E5}" dt="2021-11-17T08:57:18.387" v="2" actId="1076"/>
          <ac:picMkLst>
            <pc:docMk/>
            <pc:sldMk cId="2950954147" sldId="298"/>
            <ac:picMk id="2" creationId="{7B38FB36-4974-43E8-ADFA-476761BF3B9A}"/>
          </ac:picMkLst>
        </pc:picChg>
      </pc:sldChg>
      <pc:sldChg chg="modSp">
        <pc:chgData name="MAGNIEN Sibylle" userId="S::sibylle.magnien@etu.univ-amu.fr::00f3f39e-5581-4b0e-a3ce-9b647692d70d" providerId="AD" clId="Web-{BB4CBB1B-4145-463A-A12A-0393143911E5}" dt="2021-11-17T08:57:50.842" v="12" actId="20577"/>
        <pc:sldMkLst>
          <pc:docMk/>
          <pc:sldMk cId="1151728771" sldId="300"/>
        </pc:sldMkLst>
        <pc:spChg chg="mod">
          <ac:chgData name="MAGNIEN Sibylle" userId="S::sibylle.magnien@etu.univ-amu.fr::00f3f39e-5581-4b0e-a3ce-9b647692d70d" providerId="AD" clId="Web-{BB4CBB1B-4145-463A-A12A-0393143911E5}" dt="2021-11-17T08:57:50.842" v="12" actId="20577"/>
          <ac:spMkLst>
            <pc:docMk/>
            <pc:sldMk cId="1151728771" sldId="300"/>
            <ac:spMk id="3" creationId="{B41B8D2F-CDBE-4D9D-A08A-1E598664E786}"/>
          </ac:spMkLst>
        </pc:spChg>
      </pc:sldChg>
      <pc:sldChg chg="modSp">
        <pc:chgData name="MAGNIEN Sibylle" userId="S::sibylle.magnien@etu.univ-amu.fr::00f3f39e-5581-4b0e-a3ce-9b647692d70d" providerId="AD" clId="Web-{BB4CBB1B-4145-463A-A12A-0393143911E5}" dt="2021-11-17T08:58:24.703" v="29" actId="20577"/>
        <pc:sldMkLst>
          <pc:docMk/>
          <pc:sldMk cId="1804244748" sldId="317"/>
        </pc:sldMkLst>
        <pc:spChg chg="mod">
          <ac:chgData name="MAGNIEN Sibylle" userId="S::sibylle.magnien@etu.univ-amu.fr::00f3f39e-5581-4b0e-a3ce-9b647692d70d" providerId="AD" clId="Web-{BB4CBB1B-4145-463A-A12A-0393143911E5}" dt="2021-11-17T08:58:24.703" v="29" actId="20577"/>
          <ac:spMkLst>
            <pc:docMk/>
            <pc:sldMk cId="1804244748" sldId="317"/>
            <ac:spMk id="2" creationId="{892DF8FF-4D99-4526-BA88-A2AC6772D690}"/>
          </ac:spMkLst>
        </pc:spChg>
        <pc:graphicFrameChg chg="mod">
          <ac:chgData name="MAGNIEN Sibylle" userId="S::sibylle.magnien@etu.univ-amu.fr::00f3f39e-5581-4b0e-a3ce-9b647692d70d" providerId="AD" clId="Web-{BB4CBB1B-4145-463A-A12A-0393143911E5}" dt="2021-11-17T08:58:16.453" v="25" actId="1076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  <pc:sldChg chg="modSp">
        <pc:chgData name="MAGNIEN Sibylle" userId="S::sibylle.magnien@etu.univ-amu.fr::00f3f39e-5581-4b0e-a3ce-9b647692d70d" providerId="AD" clId="Web-{BB4CBB1B-4145-463A-A12A-0393143911E5}" dt="2021-11-17T08:59:08.628" v="31" actId="1076"/>
        <pc:sldMkLst>
          <pc:docMk/>
          <pc:sldMk cId="1458466154" sldId="321"/>
        </pc:sldMkLst>
        <pc:spChg chg="mod">
          <ac:chgData name="MAGNIEN Sibylle" userId="S::sibylle.magnien@etu.univ-amu.fr::00f3f39e-5581-4b0e-a3ce-9b647692d70d" providerId="AD" clId="Web-{BB4CBB1B-4145-463A-A12A-0393143911E5}" dt="2021-11-17T08:59:08.628" v="31" actId="1076"/>
          <ac:spMkLst>
            <pc:docMk/>
            <pc:sldMk cId="1458466154" sldId="321"/>
            <ac:spMk id="3" creationId="{4AF18DD0-3CDE-46F3-B12F-7718A385427E}"/>
          </ac:spMkLst>
        </pc:spChg>
        <pc:graphicFrameChg chg="mod">
          <ac:chgData name="MAGNIEN Sibylle" userId="S::sibylle.magnien@etu.univ-amu.fr::00f3f39e-5581-4b0e-a3ce-9b647692d70d" providerId="AD" clId="Web-{BB4CBB1B-4145-463A-A12A-0393143911E5}" dt="2021-11-17T08:59:05.393" v="30" actId="1076"/>
          <ac:graphicFrameMkLst>
            <pc:docMk/>
            <pc:sldMk cId="1458466154" sldId="321"/>
            <ac:graphicFrameMk id="2" creationId="{C66A288E-44D7-4AA3-9AFC-9356997877D8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5E443611-C886-4C20-B5FC-233E335B83CC}"/>
    <pc:docChg chg="modSld">
      <pc:chgData name="MAGNIEN Sibylle" userId="S::sibylle.magnien@etu.univ-amu.fr::00f3f39e-5581-4b0e-a3ce-9b647692d70d" providerId="AD" clId="Web-{5E443611-C886-4C20-B5FC-233E335B83CC}" dt="2021-11-02T10:19:16.685" v="47"/>
      <pc:docMkLst>
        <pc:docMk/>
      </pc:docMkLst>
      <pc:sldChg chg="modSp">
        <pc:chgData name="MAGNIEN Sibylle" userId="S::sibylle.magnien@etu.univ-amu.fr::00f3f39e-5581-4b0e-a3ce-9b647692d70d" providerId="AD" clId="Web-{5E443611-C886-4C20-B5FC-233E335B83CC}" dt="2021-11-02T10:17:17.292" v="41"/>
        <pc:sldMkLst>
          <pc:docMk/>
          <pc:sldMk cId="1151728771" sldId="300"/>
        </pc:sldMkLst>
        <pc:spChg chg="mod">
          <ac:chgData name="MAGNIEN Sibylle" userId="S::sibylle.magnien@etu.univ-amu.fr::00f3f39e-5581-4b0e-a3ce-9b647692d70d" providerId="AD" clId="Web-{5E443611-C886-4C20-B5FC-233E335B83CC}" dt="2021-11-02T10:16:19.462" v="33" actId="20577"/>
          <ac:spMkLst>
            <pc:docMk/>
            <pc:sldMk cId="1151728771" sldId="300"/>
            <ac:spMk id="3" creationId="{B41B8D2F-CDBE-4D9D-A08A-1E598664E786}"/>
          </ac:spMkLst>
        </pc:spChg>
        <pc:graphicFrameChg chg="mod modGraphic">
          <ac:chgData name="MAGNIEN Sibylle" userId="S::sibylle.magnien@etu.univ-amu.fr::00f3f39e-5581-4b0e-a3ce-9b647692d70d" providerId="AD" clId="Web-{5E443611-C886-4C20-B5FC-233E335B83CC}" dt="2021-11-02T10:17:17.292" v="41"/>
          <ac:graphicFrameMkLst>
            <pc:docMk/>
            <pc:sldMk cId="1151728771" sldId="300"/>
            <ac:graphicFrameMk id="2" creationId="{14197C3D-3E89-4E21-BBF2-BC658EC0E989}"/>
          </ac:graphicFrameMkLst>
        </pc:graphicFrameChg>
      </pc:sldChg>
      <pc:sldChg chg="modSp">
        <pc:chgData name="MAGNIEN Sibylle" userId="S::sibylle.magnien@etu.univ-amu.fr::00f3f39e-5581-4b0e-a3ce-9b647692d70d" providerId="AD" clId="Web-{5E443611-C886-4C20-B5FC-233E335B83CC}" dt="2021-11-02T10:19:16.685" v="47"/>
        <pc:sldMkLst>
          <pc:docMk/>
          <pc:sldMk cId="1804244748" sldId="317"/>
        </pc:sldMkLst>
        <pc:graphicFrameChg chg="mod modGraphic">
          <ac:chgData name="MAGNIEN Sibylle" userId="S::sibylle.magnien@etu.univ-amu.fr::00f3f39e-5581-4b0e-a3ce-9b647692d70d" providerId="AD" clId="Web-{5E443611-C886-4C20-B5FC-233E335B83CC}" dt="2021-11-02T10:19:16.685" v="47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</pc:docChg>
  </pc:docChgLst>
  <pc:docChgLst>
    <pc:chgData name="MAGNIEN Sibylle" userId="S::sibylle.magnien@etu.univ-amu.fr::00f3f39e-5581-4b0e-a3ce-9b647692d70d" providerId="AD" clId="Web-{DE933594-E2B7-470E-BCD2-6E00E2DA19A6}"/>
    <pc:docChg chg="">
      <pc:chgData name="MAGNIEN Sibylle" userId="S::sibylle.magnien@etu.univ-amu.fr::00f3f39e-5581-4b0e-a3ce-9b647692d70d" providerId="AD" clId="Web-{DE933594-E2B7-470E-BCD2-6E00E2DA19A6}" dt="2021-11-18T14:56:14.315" v="0"/>
      <pc:docMkLst>
        <pc:docMk/>
      </pc:docMkLst>
      <pc:sldChg chg="addCm">
        <pc:chgData name="MAGNIEN Sibylle" userId="S::sibylle.magnien@etu.univ-amu.fr::00f3f39e-5581-4b0e-a3ce-9b647692d70d" providerId="AD" clId="Web-{DE933594-E2B7-470E-BCD2-6E00E2DA19A6}" dt="2021-11-18T14:56:14.315" v="0"/>
        <pc:sldMkLst>
          <pc:docMk/>
          <pc:sldMk cId="1151728771" sldId="300"/>
        </pc:sldMkLst>
      </pc:sldChg>
    </pc:docChg>
  </pc:docChgLst>
  <pc:docChgLst>
    <pc:chgData name="MAGNIEN Sibylle" userId="S::sibylle.magnien@etu.univ-amu.fr::00f3f39e-5581-4b0e-a3ce-9b647692d70d" providerId="AD" clId="Web-{9F6F65D8-54B8-4C73-9301-ADCE669624DD}"/>
    <pc:docChg chg="modSld">
      <pc:chgData name="MAGNIEN Sibylle" userId="S::sibylle.magnien@etu.univ-amu.fr::00f3f39e-5581-4b0e-a3ce-9b647692d70d" providerId="AD" clId="Web-{9F6F65D8-54B8-4C73-9301-ADCE669624DD}" dt="2021-11-12T11:28:25.713" v="18"/>
      <pc:docMkLst>
        <pc:docMk/>
      </pc:docMkLst>
      <pc:sldChg chg="modSp addCm">
        <pc:chgData name="MAGNIEN Sibylle" userId="S::sibylle.magnien@etu.univ-amu.fr::00f3f39e-5581-4b0e-a3ce-9b647692d70d" providerId="AD" clId="Web-{9F6F65D8-54B8-4C73-9301-ADCE669624DD}" dt="2021-11-12T11:28:25.713" v="18"/>
        <pc:sldMkLst>
          <pc:docMk/>
          <pc:sldMk cId="1804244748" sldId="317"/>
        </pc:sldMkLst>
        <pc:graphicFrameChg chg="mod modGraphic">
          <ac:chgData name="MAGNIEN Sibylle" userId="S::sibylle.magnien@etu.univ-amu.fr::00f3f39e-5581-4b0e-a3ce-9b647692d70d" providerId="AD" clId="Web-{9F6F65D8-54B8-4C73-9301-ADCE669624DD}" dt="2021-11-12T11:28:25.713" v="18"/>
          <ac:graphicFrameMkLst>
            <pc:docMk/>
            <pc:sldMk cId="1804244748" sldId="317"/>
            <ac:graphicFrameMk id="3" creationId="{7EEC5E58-FCD5-432E-943B-2CB4B7D5FF85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boxberger\AppData\Local\Temp\Temp1_wetransfer-ae4413.zip\cog_result\Leucobacter\Leucobacter_manosquensis.fasta.faa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radarChart>
        <c:radarStyle val="marker"/>
        <c:varyColors val="0"/>
        <c:ser>
          <c:idx val="0"/>
          <c:order val="0"/>
          <c:tx>
            <c:strRef>
              <c:f>Feuil6!$B$1</c:f>
              <c:strCache>
                <c:ptCount val="1"/>
                <c:pt idx="0">
                  <c:v>Leucobacter_manosquensis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Feuil6!$A$2:$A$83</c:f>
              <c:strCache>
                <c:ptCount val="82"/>
                <c:pt idx="0">
                  <c:v>[A]</c:v>
                </c:pt>
                <c:pt idx="1">
                  <c:v>[BQ]</c:v>
                </c:pt>
                <c:pt idx="2">
                  <c:v>[C]</c:v>
                </c:pt>
                <c:pt idx="3">
                  <c:v>[CE]</c:v>
                </c:pt>
                <c:pt idx="4">
                  <c:v>[CHR]</c:v>
                </c:pt>
                <c:pt idx="5">
                  <c:v>[CO]</c:v>
                </c:pt>
                <c:pt idx="6">
                  <c:v>[CP]</c:v>
                </c:pt>
                <c:pt idx="7">
                  <c:v>[CR]</c:v>
                </c:pt>
                <c:pt idx="8">
                  <c:v>[D]</c:v>
                </c:pt>
                <c:pt idx="9">
                  <c:v>[E]</c:v>
                </c:pt>
                <c:pt idx="10">
                  <c:v>[EF]</c:v>
                </c:pt>
                <c:pt idx="11">
                  <c:v>[EG]</c:v>
                </c:pt>
                <c:pt idx="12">
                  <c:v>[EH]</c:v>
                </c:pt>
                <c:pt idx="13">
                  <c:v>[EJ]</c:v>
                </c:pt>
                <c:pt idx="14">
                  <c:v>[EM]</c:v>
                </c:pt>
                <c:pt idx="15">
                  <c:v>[EP]</c:v>
                </c:pt>
                <c:pt idx="16">
                  <c:v>[EQ]</c:v>
                </c:pt>
                <c:pt idx="17">
                  <c:v>[ER]</c:v>
                </c:pt>
                <c:pt idx="18">
                  <c:v>[ET]</c:v>
                </c:pt>
                <c:pt idx="19">
                  <c:v>[F]</c:v>
                </c:pt>
                <c:pt idx="20">
                  <c:v>[FE]</c:v>
                </c:pt>
                <c:pt idx="21">
                  <c:v>[FGR]</c:v>
                </c:pt>
                <c:pt idx="22">
                  <c:v>[FJ]</c:v>
                </c:pt>
                <c:pt idx="23">
                  <c:v>[FP]</c:v>
                </c:pt>
                <c:pt idx="24">
                  <c:v>[FR]</c:v>
                </c:pt>
                <c:pt idx="25">
                  <c:v>[G]</c:v>
                </c:pt>
                <c:pt idx="26">
                  <c:v>[GC]</c:v>
                </c:pt>
                <c:pt idx="27">
                  <c:v>[GE]</c:v>
                </c:pt>
                <c:pt idx="28">
                  <c:v>[GEPR]</c:v>
                </c:pt>
                <c:pt idx="29">
                  <c:v>[GER]</c:v>
                </c:pt>
                <c:pt idx="30">
                  <c:v>[GM]</c:v>
                </c:pt>
                <c:pt idx="31">
                  <c:v>[GR]</c:v>
                </c:pt>
                <c:pt idx="32">
                  <c:v>[GT]</c:v>
                </c:pt>
                <c:pt idx="33">
                  <c:v>[H]</c:v>
                </c:pt>
                <c:pt idx="34">
                  <c:v>[HC]</c:v>
                </c:pt>
                <c:pt idx="35">
                  <c:v>[HE]</c:v>
                </c:pt>
                <c:pt idx="36">
                  <c:v>[HI]</c:v>
                </c:pt>
                <c:pt idx="37">
                  <c:v>[HJ]</c:v>
                </c:pt>
                <c:pt idx="38">
                  <c:v>[HQ]</c:v>
                </c:pt>
                <c:pt idx="39">
                  <c:v>[I]</c:v>
                </c:pt>
                <c:pt idx="40">
                  <c:v>[IM]</c:v>
                </c:pt>
                <c:pt idx="41">
                  <c:v>[IQ]</c:v>
                </c:pt>
                <c:pt idx="42">
                  <c:v>[IQR]</c:v>
                </c:pt>
                <c:pt idx="43">
                  <c:v>[IR]</c:v>
                </c:pt>
                <c:pt idx="44">
                  <c:v>[J]</c:v>
                </c:pt>
                <c:pt idx="45">
                  <c:v>[JD]</c:v>
                </c:pt>
                <c:pt idx="46">
                  <c:v>[K]</c:v>
                </c:pt>
                <c:pt idx="47">
                  <c:v>[KE]</c:v>
                </c:pt>
                <c:pt idx="48">
                  <c:v>[KG]</c:v>
                </c:pt>
                <c:pt idx="49">
                  <c:v>[KL]</c:v>
                </c:pt>
                <c:pt idx="50">
                  <c:v>[KR]</c:v>
                </c:pt>
                <c:pt idx="51">
                  <c:v>[KT]</c:v>
                </c:pt>
                <c:pt idx="52">
                  <c:v>[L]</c:v>
                </c:pt>
                <c:pt idx="53">
                  <c:v>[LK]</c:v>
                </c:pt>
                <c:pt idx="54">
                  <c:v>[LKJ]</c:v>
                </c:pt>
                <c:pt idx="55">
                  <c:v>[LR]</c:v>
                </c:pt>
                <c:pt idx="56">
                  <c:v>[LU]</c:v>
                </c:pt>
                <c:pt idx="57">
                  <c:v>[M]</c:v>
                </c:pt>
                <c:pt idx="58">
                  <c:v>[MG]</c:v>
                </c:pt>
                <c:pt idx="59">
                  <c:v>[MI]</c:v>
                </c:pt>
                <c:pt idx="60">
                  <c:v>[MR]</c:v>
                </c:pt>
                <c:pt idx="61">
                  <c:v>[MU]</c:v>
                </c:pt>
                <c:pt idx="62">
                  <c:v>[NOU]</c:v>
                </c:pt>
                <c:pt idx="63">
                  <c:v>[O]</c:v>
                </c:pt>
                <c:pt idx="64">
                  <c:v>[OC]</c:v>
                </c:pt>
                <c:pt idx="65">
                  <c:v>[OT]</c:v>
                </c:pt>
                <c:pt idx="66">
                  <c:v>[OU]</c:v>
                </c:pt>
                <c:pt idx="67">
                  <c:v>[P]</c:v>
                </c:pt>
                <c:pt idx="68">
                  <c:v>[PH]</c:v>
                </c:pt>
                <c:pt idx="69">
                  <c:v>[PR]</c:v>
                </c:pt>
                <c:pt idx="70">
                  <c:v>[Q]</c:v>
                </c:pt>
                <c:pt idx="71">
                  <c:v>[QK]</c:v>
                </c:pt>
                <c:pt idx="72">
                  <c:v>[QP]</c:v>
                </c:pt>
                <c:pt idx="73">
                  <c:v>[QR]</c:v>
                </c:pt>
                <c:pt idx="74">
                  <c:v>[R]</c:v>
                </c:pt>
                <c:pt idx="75">
                  <c:v>[RTKL]</c:v>
                </c:pt>
                <c:pt idx="76">
                  <c:v>[S]</c:v>
                </c:pt>
                <c:pt idx="77">
                  <c:v>[T]</c:v>
                </c:pt>
                <c:pt idx="78">
                  <c:v>[TK]</c:v>
                </c:pt>
                <c:pt idx="79">
                  <c:v>[TQ]</c:v>
                </c:pt>
                <c:pt idx="80">
                  <c:v>[U]</c:v>
                </c:pt>
                <c:pt idx="81">
                  <c:v>[V]</c:v>
                </c:pt>
              </c:strCache>
            </c:strRef>
          </c:cat>
          <c:val>
            <c:numRef>
              <c:f>Feuil6!$B$2:$B$83</c:f>
              <c:numCache>
                <c:formatCode>General</c:formatCode>
                <c:ptCount val="82"/>
                <c:pt idx="0">
                  <c:v>1</c:v>
                </c:pt>
                <c:pt idx="1">
                  <c:v>1</c:v>
                </c:pt>
                <c:pt idx="2">
                  <c:v>109</c:v>
                </c:pt>
                <c:pt idx="3">
                  <c:v>2</c:v>
                </c:pt>
                <c:pt idx="4">
                  <c:v>0</c:v>
                </c:pt>
                <c:pt idx="5">
                  <c:v>2</c:v>
                </c:pt>
                <c:pt idx="6">
                  <c:v>1</c:v>
                </c:pt>
                <c:pt idx="7">
                  <c:v>2</c:v>
                </c:pt>
                <c:pt idx="8">
                  <c:v>18</c:v>
                </c:pt>
                <c:pt idx="9">
                  <c:v>262</c:v>
                </c:pt>
                <c:pt idx="10">
                  <c:v>2</c:v>
                </c:pt>
                <c:pt idx="11">
                  <c:v>1</c:v>
                </c:pt>
                <c:pt idx="12">
                  <c:v>12</c:v>
                </c:pt>
                <c:pt idx="13">
                  <c:v>1</c:v>
                </c:pt>
                <c:pt idx="14">
                  <c:v>4</c:v>
                </c:pt>
                <c:pt idx="15">
                  <c:v>35</c:v>
                </c:pt>
                <c:pt idx="16">
                  <c:v>6</c:v>
                </c:pt>
                <c:pt idx="17">
                  <c:v>12</c:v>
                </c:pt>
                <c:pt idx="18">
                  <c:v>9</c:v>
                </c:pt>
                <c:pt idx="19">
                  <c:v>65</c:v>
                </c:pt>
                <c:pt idx="20">
                  <c:v>1</c:v>
                </c:pt>
                <c:pt idx="21">
                  <c:v>2</c:v>
                </c:pt>
                <c:pt idx="22">
                  <c:v>2</c:v>
                </c:pt>
                <c:pt idx="23">
                  <c:v>1</c:v>
                </c:pt>
                <c:pt idx="24">
                  <c:v>4</c:v>
                </c:pt>
                <c:pt idx="25">
                  <c:v>119</c:v>
                </c:pt>
                <c:pt idx="26">
                  <c:v>1</c:v>
                </c:pt>
                <c:pt idx="27">
                  <c:v>0</c:v>
                </c:pt>
                <c:pt idx="28">
                  <c:v>40</c:v>
                </c:pt>
                <c:pt idx="29">
                  <c:v>1</c:v>
                </c:pt>
                <c:pt idx="30">
                  <c:v>3</c:v>
                </c:pt>
                <c:pt idx="31">
                  <c:v>0</c:v>
                </c:pt>
                <c:pt idx="32">
                  <c:v>0</c:v>
                </c:pt>
                <c:pt idx="33">
                  <c:v>67</c:v>
                </c:pt>
                <c:pt idx="34">
                  <c:v>3</c:v>
                </c:pt>
                <c:pt idx="35">
                  <c:v>5</c:v>
                </c:pt>
                <c:pt idx="36">
                  <c:v>1</c:v>
                </c:pt>
                <c:pt idx="37">
                  <c:v>1</c:v>
                </c:pt>
                <c:pt idx="38">
                  <c:v>0</c:v>
                </c:pt>
                <c:pt idx="39">
                  <c:v>60</c:v>
                </c:pt>
                <c:pt idx="40">
                  <c:v>1</c:v>
                </c:pt>
                <c:pt idx="41">
                  <c:v>7</c:v>
                </c:pt>
                <c:pt idx="42">
                  <c:v>20</c:v>
                </c:pt>
                <c:pt idx="43">
                  <c:v>3</c:v>
                </c:pt>
                <c:pt idx="44">
                  <c:v>143</c:v>
                </c:pt>
                <c:pt idx="45">
                  <c:v>0</c:v>
                </c:pt>
                <c:pt idx="46">
                  <c:v>156</c:v>
                </c:pt>
                <c:pt idx="47">
                  <c:v>3</c:v>
                </c:pt>
                <c:pt idx="48">
                  <c:v>4</c:v>
                </c:pt>
                <c:pt idx="49">
                  <c:v>4</c:v>
                </c:pt>
                <c:pt idx="50">
                  <c:v>6</c:v>
                </c:pt>
                <c:pt idx="51">
                  <c:v>6</c:v>
                </c:pt>
                <c:pt idx="52">
                  <c:v>83</c:v>
                </c:pt>
                <c:pt idx="53">
                  <c:v>2</c:v>
                </c:pt>
                <c:pt idx="54">
                  <c:v>4</c:v>
                </c:pt>
                <c:pt idx="55">
                  <c:v>3</c:v>
                </c:pt>
                <c:pt idx="56">
                  <c:v>2</c:v>
                </c:pt>
                <c:pt idx="57">
                  <c:v>72</c:v>
                </c:pt>
                <c:pt idx="58">
                  <c:v>6</c:v>
                </c:pt>
                <c:pt idx="59">
                  <c:v>1</c:v>
                </c:pt>
                <c:pt idx="60">
                  <c:v>2</c:v>
                </c:pt>
                <c:pt idx="61">
                  <c:v>1</c:v>
                </c:pt>
                <c:pt idx="62">
                  <c:v>0</c:v>
                </c:pt>
                <c:pt idx="63">
                  <c:v>52</c:v>
                </c:pt>
                <c:pt idx="64">
                  <c:v>3</c:v>
                </c:pt>
                <c:pt idx="65">
                  <c:v>1</c:v>
                </c:pt>
                <c:pt idx="66">
                  <c:v>2</c:v>
                </c:pt>
                <c:pt idx="67">
                  <c:v>110</c:v>
                </c:pt>
                <c:pt idx="68">
                  <c:v>1</c:v>
                </c:pt>
                <c:pt idx="69">
                  <c:v>1</c:v>
                </c:pt>
                <c:pt idx="70">
                  <c:v>21</c:v>
                </c:pt>
                <c:pt idx="71">
                  <c:v>0</c:v>
                </c:pt>
                <c:pt idx="72">
                  <c:v>0</c:v>
                </c:pt>
                <c:pt idx="73">
                  <c:v>3</c:v>
                </c:pt>
                <c:pt idx="74">
                  <c:v>209</c:v>
                </c:pt>
                <c:pt idx="75">
                  <c:v>2</c:v>
                </c:pt>
                <c:pt idx="76">
                  <c:v>122</c:v>
                </c:pt>
                <c:pt idx="77">
                  <c:v>26</c:v>
                </c:pt>
                <c:pt idx="78">
                  <c:v>19</c:v>
                </c:pt>
                <c:pt idx="79">
                  <c:v>3</c:v>
                </c:pt>
                <c:pt idx="80">
                  <c:v>15</c:v>
                </c:pt>
                <c:pt idx="81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9A-4A60-9563-D781A00A551B}"/>
            </c:ext>
          </c:extLst>
        </c:ser>
        <c:ser>
          <c:idx val="1"/>
          <c:order val="1"/>
          <c:tx>
            <c:strRef>
              <c:f>Feuil6!$C$1</c:f>
              <c:strCache>
                <c:ptCount val="1"/>
                <c:pt idx="0">
                  <c:v>Leucobacter_musarum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Feuil6!$A$2:$A$83</c:f>
              <c:strCache>
                <c:ptCount val="82"/>
                <c:pt idx="0">
                  <c:v>[A]</c:v>
                </c:pt>
                <c:pt idx="1">
                  <c:v>[BQ]</c:v>
                </c:pt>
                <c:pt idx="2">
                  <c:v>[C]</c:v>
                </c:pt>
                <c:pt idx="3">
                  <c:v>[CE]</c:v>
                </c:pt>
                <c:pt idx="4">
                  <c:v>[CHR]</c:v>
                </c:pt>
                <c:pt idx="5">
                  <c:v>[CO]</c:v>
                </c:pt>
                <c:pt idx="6">
                  <c:v>[CP]</c:v>
                </c:pt>
                <c:pt idx="7">
                  <c:v>[CR]</c:v>
                </c:pt>
                <c:pt idx="8">
                  <c:v>[D]</c:v>
                </c:pt>
                <c:pt idx="9">
                  <c:v>[E]</c:v>
                </c:pt>
                <c:pt idx="10">
                  <c:v>[EF]</c:v>
                </c:pt>
                <c:pt idx="11">
                  <c:v>[EG]</c:v>
                </c:pt>
                <c:pt idx="12">
                  <c:v>[EH]</c:v>
                </c:pt>
                <c:pt idx="13">
                  <c:v>[EJ]</c:v>
                </c:pt>
                <c:pt idx="14">
                  <c:v>[EM]</c:v>
                </c:pt>
                <c:pt idx="15">
                  <c:v>[EP]</c:v>
                </c:pt>
                <c:pt idx="16">
                  <c:v>[EQ]</c:v>
                </c:pt>
                <c:pt idx="17">
                  <c:v>[ER]</c:v>
                </c:pt>
                <c:pt idx="18">
                  <c:v>[ET]</c:v>
                </c:pt>
                <c:pt idx="19">
                  <c:v>[F]</c:v>
                </c:pt>
                <c:pt idx="20">
                  <c:v>[FE]</c:v>
                </c:pt>
                <c:pt idx="21">
                  <c:v>[FGR]</c:v>
                </c:pt>
                <c:pt idx="22">
                  <c:v>[FJ]</c:v>
                </c:pt>
                <c:pt idx="23">
                  <c:v>[FP]</c:v>
                </c:pt>
                <c:pt idx="24">
                  <c:v>[FR]</c:v>
                </c:pt>
                <c:pt idx="25">
                  <c:v>[G]</c:v>
                </c:pt>
                <c:pt idx="26">
                  <c:v>[GC]</c:v>
                </c:pt>
                <c:pt idx="27">
                  <c:v>[GE]</c:v>
                </c:pt>
                <c:pt idx="28">
                  <c:v>[GEPR]</c:v>
                </c:pt>
                <c:pt idx="29">
                  <c:v>[GER]</c:v>
                </c:pt>
                <c:pt idx="30">
                  <c:v>[GM]</c:v>
                </c:pt>
                <c:pt idx="31">
                  <c:v>[GR]</c:v>
                </c:pt>
                <c:pt idx="32">
                  <c:v>[GT]</c:v>
                </c:pt>
                <c:pt idx="33">
                  <c:v>[H]</c:v>
                </c:pt>
                <c:pt idx="34">
                  <c:v>[HC]</c:v>
                </c:pt>
                <c:pt idx="35">
                  <c:v>[HE]</c:v>
                </c:pt>
                <c:pt idx="36">
                  <c:v>[HI]</c:v>
                </c:pt>
                <c:pt idx="37">
                  <c:v>[HJ]</c:v>
                </c:pt>
                <c:pt idx="38">
                  <c:v>[HQ]</c:v>
                </c:pt>
                <c:pt idx="39">
                  <c:v>[I]</c:v>
                </c:pt>
                <c:pt idx="40">
                  <c:v>[IM]</c:v>
                </c:pt>
                <c:pt idx="41">
                  <c:v>[IQ]</c:v>
                </c:pt>
                <c:pt idx="42">
                  <c:v>[IQR]</c:v>
                </c:pt>
                <c:pt idx="43">
                  <c:v>[IR]</c:v>
                </c:pt>
                <c:pt idx="44">
                  <c:v>[J]</c:v>
                </c:pt>
                <c:pt idx="45">
                  <c:v>[JD]</c:v>
                </c:pt>
                <c:pt idx="46">
                  <c:v>[K]</c:v>
                </c:pt>
                <c:pt idx="47">
                  <c:v>[KE]</c:v>
                </c:pt>
                <c:pt idx="48">
                  <c:v>[KG]</c:v>
                </c:pt>
                <c:pt idx="49">
                  <c:v>[KL]</c:v>
                </c:pt>
                <c:pt idx="50">
                  <c:v>[KR]</c:v>
                </c:pt>
                <c:pt idx="51">
                  <c:v>[KT]</c:v>
                </c:pt>
                <c:pt idx="52">
                  <c:v>[L]</c:v>
                </c:pt>
                <c:pt idx="53">
                  <c:v>[LK]</c:v>
                </c:pt>
                <c:pt idx="54">
                  <c:v>[LKJ]</c:v>
                </c:pt>
                <c:pt idx="55">
                  <c:v>[LR]</c:v>
                </c:pt>
                <c:pt idx="56">
                  <c:v>[LU]</c:v>
                </c:pt>
                <c:pt idx="57">
                  <c:v>[M]</c:v>
                </c:pt>
                <c:pt idx="58">
                  <c:v>[MG]</c:v>
                </c:pt>
                <c:pt idx="59">
                  <c:v>[MI]</c:v>
                </c:pt>
                <c:pt idx="60">
                  <c:v>[MR]</c:v>
                </c:pt>
                <c:pt idx="61">
                  <c:v>[MU]</c:v>
                </c:pt>
                <c:pt idx="62">
                  <c:v>[NOU]</c:v>
                </c:pt>
                <c:pt idx="63">
                  <c:v>[O]</c:v>
                </c:pt>
                <c:pt idx="64">
                  <c:v>[OC]</c:v>
                </c:pt>
                <c:pt idx="65">
                  <c:v>[OT]</c:v>
                </c:pt>
                <c:pt idx="66">
                  <c:v>[OU]</c:v>
                </c:pt>
                <c:pt idx="67">
                  <c:v>[P]</c:v>
                </c:pt>
                <c:pt idx="68">
                  <c:v>[PH]</c:v>
                </c:pt>
                <c:pt idx="69">
                  <c:v>[PR]</c:v>
                </c:pt>
                <c:pt idx="70">
                  <c:v>[Q]</c:v>
                </c:pt>
                <c:pt idx="71">
                  <c:v>[QK]</c:v>
                </c:pt>
                <c:pt idx="72">
                  <c:v>[QP]</c:v>
                </c:pt>
                <c:pt idx="73">
                  <c:v>[QR]</c:v>
                </c:pt>
                <c:pt idx="74">
                  <c:v>[R]</c:v>
                </c:pt>
                <c:pt idx="75">
                  <c:v>[RTKL]</c:v>
                </c:pt>
                <c:pt idx="76">
                  <c:v>[S]</c:v>
                </c:pt>
                <c:pt idx="77">
                  <c:v>[T]</c:v>
                </c:pt>
                <c:pt idx="78">
                  <c:v>[TK]</c:v>
                </c:pt>
                <c:pt idx="79">
                  <c:v>[TQ]</c:v>
                </c:pt>
                <c:pt idx="80">
                  <c:v>[U]</c:v>
                </c:pt>
                <c:pt idx="81">
                  <c:v>[V]</c:v>
                </c:pt>
              </c:strCache>
            </c:strRef>
          </c:cat>
          <c:val>
            <c:numRef>
              <c:f>Feuil6!$C$2:$C$83</c:f>
              <c:numCache>
                <c:formatCode>General</c:formatCode>
                <c:ptCount val="82"/>
                <c:pt idx="0">
                  <c:v>1</c:v>
                </c:pt>
                <c:pt idx="1">
                  <c:v>0</c:v>
                </c:pt>
                <c:pt idx="2">
                  <c:v>115</c:v>
                </c:pt>
                <c:pt idx="3">
                  <c:v>2</c:v>
                </c:pt>
                <c:pt idx="4">
                  <c:v>0</c:v>
                </c:pt>
                <c:pt idx="5">
                  <c:v>2</c:v>
                </c:pt>
                <c:pt idx="6">
                  <c:v>2</c:v>
                </c:pt>
                <c:pt idx="7">
                  <c:v>5</c:v>
                </c:pt>
                <c:pt idx="8">
                  <c:v>19</c:v>
                </c:pt>
                <c:pt idx="9">
                  <c:v>256</c:v>
                </c:pt>
                <c:pt idx="10">
                  <c:v>2</c:v>
                </c:pt>
                <c:pt idx="11">
                  <c:v>3</c:v>
                </c:pt>
                <c:pt idx="12">
                  <c:v>11</c:v>
                </c:pt>
                <c:pt idx="13">
                  <c:v>2</c:v>
                </c:pt>
                <c:pt idx="14">
                  <c:v>3</c:v>
                </c:pt>
                <c:pt idx="15">
                  <c:v>30</c:v>
                </c:pt>
                <c:pt idx="16">
                  <c:v>4</c:v>
                </c:pt>
                <c:pt idx="17">
                  <c:v>10</c:v>
                </c:pt>
                <c:pt idx="18">
                  <c:v>6</c:v>
                </c:pt>
                <c:pt idx="19">
                  <c:v>58</c:v>
                </c:pt>
                <c:pt idx="20">
                  <c:v>1</c:v>
                </c:pt>
                <c:pt idx="21">
                  <c:v>2</c:v>
                </c:pt>
                <c:pt idx="22">
                  <c:v>2</c:v>
                </c:pt>
                <c:pt idx="23">
                  <c:v>1</c:v>
                </c:pt>
                <c:pt idx="24">
                  <c:v>5</c:v>
                </c:pt>
                <c:pt idx="25">
                  <c:v>125</c:v>
                </c:pt>
                <c:pt idx="26">
                  <c:v>1</c:v>
                </c:pt>
                <c:pt idx="27">
                  <c:v>0</c:v>
                </c:pt>
                <c:pt idx="28">
                  <c:v>46</c:v>
                </c:pt>
                <c:pt idx="29">
                  <c:v>2</c:v>
                </c:pt>
                <c:pt idx="30">
                  <c:v>4</c:v>
                </c:pt>
                <c:pt idx="31">
                  <c:v>0</c:v>
                </c:pt>
                <c:pt idx="32">
                  <c:v>1</c:v>
                </c:pt>
                <c:pt idx="33">
                  <c:v>62</c:v>
                </c:pt>
                <c:pt idx="34">
                  <c:v>2</c:v>
                </c:pt>
                <c:pt idx="35">
                  <c:v>12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62</c:v>
                </c:pt>
                <c:pt idx="40">
                  <c:v>1</c:v>
                </c:pt>
                <c:pt idx="41">
                  <c:v>4</c:v>
                </c:pt>
                <c:pt idx="42">
                  <c:v>30</c:v>
                </c:pt>
                <c:pt idx="43">
                  <c:v>2</c:v>
                </c:pt>
                <c:pt idx="44">
                  <c:v>141</c:v>
                </c:pt>
                <c:pt idx="45">
                  <c:v>1</c:v>
                </c:pt>
                <c:pt idx="46">
                  <c:v>176</c:v>
                </c:pt>
                <c:pt idx="47">
                  <c:v>2</c:v>
                </c:pt>
                <c:pt idx="48">
                  <c:v>5</c:v>
                </c:pt>
                <c:pt idx="49">
                  <c:v>4</c:v>
                </c:pt>
                <c:pt idx="50">
                  <c:v>10</c:v>
                </c:pt>
                <c:pt idx="51">
                  <c:v>6</c:v>
                </c:pt>
                <c:pt idx="52">
                  <c:v>84</c:v>
                </c:pt>
                <c:pt idx="53">
                  <c:v>2</c:v>
                </c:pt>
                <c:pt idx="54">
                  <c:v>4</c:v>
                </c:pt>
                <c:pt idx="55">
                  <c:v>3</c:v>
                </c:pt>
                <c:pt idx="56">
                  <c:v>1</c:v>
                </c:pt>
                <c:pt idx="57">
                  <c:v>68</c:v>
                </c:pt>
                <c:pt idx="58">
                  <c:v>8</c:v>
                </c:pt>
                <c:pt idx="59">
                  <c:v>1</c:v>
                </c:pt>
                <c:pt idx="60">
                  <c:v>2</c:v>
                </c:pt>
                <c:pt idx="61">
                  <c:v>1</c:v>
                </c:pt>
                <c:pt idx="62">
                  <c:v>0</c:v>
                </c:pt>
                <c:pt idx="63">
                  <c:v>54</c:v>
                </c:pt>
                <c:pt idx="64">
                  <c:v>2</c:v>
                </c:pt>
                <c:pt idx="65">
                  <c:v>1</c:v>
                </c:pt>
                <c:pt idx="66">
                  <c:v>2</c:v>
                </c:pt>
                <c:pt idx="67">
                  <c:v>135</c:v>
                </c:pt>
                <c:pt idx="68">
                  <c:v>8</c:v>
                </c:pt>
                <c:pt idx="69">
                  <c:v>1</c:v>
                </c:pt>
                <c:pt idx="70">
                  <c:v>17</c:v>
                </c:pt>
                <c:pt idx="71">
                  <c:v>1</c:v>
                </c:pt>
                <c:pt idx="72">
                  <c:v>0</c:v>
                </c:pt>
                <c:pt idx="73">
                  <c:v>3</c:v>
                </c:pt>
                <c:pt idx="74">
                  <c:v>225</c:v>
                </c:pt>
                <c:pt idx="75">
                  <c:v>2</c:v>
                </c:pt>
                <c:pt idx="76">
                  <c:v>130</c:v>
                </c:pt>
                <c:pt idx="77">
                  <c:v>23</c:v>
                </c:pt>
                <c:pt idx="78">
                  <c:v>19</c:v>
                </c:pt>
                <c:pt idx="79">
                  <c:v>5</c:v>
                </c:pt>
                <c:pt idx="80">
                  <c:v>11</c:v>
                </c:pt>
                <c:pt idx="81">
                  <c:v>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F9A-4A60-9563-D781A00A551B}"/>
            </c:ext>
          </c:extLst>
        </c:ser>
        <c:ser>
          <c:idx val="2"/>
          <c:order val="2"/>
          <c:tx>
            <c:strRef>
              <c:f>Feuil6!$D$1</c:f>
              <c:strCache>
                <c:ptCount val="1"/>
                <c:pt idx="0">
                  <c:v>Leucobacter_japonicu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Feuil6!$A$2:$A$83</c:f>
              <c:strCache>
                <c:ptCount val="82"/>
                <c:pt idx="0">
                  <c:v>[A]</c:v>
                </c:pt>
                <c:pt idx="1">
                  <c:v>[BQ]</c:v>
                </c:pt>
                <c:pt idx="2">
                  <c:v>[C]</c:v>
                </c:pt>
                <c:pt idx="3">
                  <c:v>[CE]</c:v>
                </c:pt>
                <c:pt idx="4">
                  <c:v>[CHR]</c:v>
                </c:pt>
                <c:pt idx="5">
                  <c:v>[CO]</c:v>
                </c:pt>
                <c:pt idx="6">
                  <c:v>[CP]</c:v>
                </c:pt>
                <c:pt idx="7">
                  <c:v>[CR]</c:v>
                </c:pt>
                <c:pt idx="8">
                  <c:v>[D]</c:v>
                </c:pt>
                <c:pt idx="9">
                  <c:v>[E]</c:v>
                </c:pt>
                <c:pt idx="10">
                  <c:v>[EF]</c:v>
                </c:pt>
                <c:pt idx="11">
                  <c:v>[EG]</c:v>
                </c:pt>
                <c:pt idx="12">
                  <c:v>[EH]</c:v>
                </c:pt>
                <c:pt idx="13">
                  <c:v>[EJ]</c:v>
                </c:pt>
                <c:pt idx="14">
                  <c:v>[EM]</c:v>
                </c:pt>
                <c:pt idx="15">
                  <c:v>[EP]</c:v>
                </c:pt>
                <c:pt idx="16">
                  <c:v>[EQ]</c:v>
                </c:pt>
                <c:pt idx="17">
                  <c:v>[ER]</c:v>
                </c:pt>
                <c:pt idx="18">
                  <c:v>[ET]</c:v>
                </c:pt>
                <c:pt idx="19">
                  <c:v>[F]</c:v>
                </c:pt>
                <c:pt idx="20">
                  <c:v>[FE]</c:v>
                </c:pt>
                <c:pt idx="21">
                  <c:v>[FGR]</c:v>
                </c:pt>
                <c:pt idx="22">
                  <c:v>[FJ]</c:v>
                </c:pt>
                <c:pt idx="23">
                  <c:v>[FP]</c:v>
                </c:pt>
                <c:pt idx="24">
                  <c:v>[FR]</c:v>
                </c:pt>
                <c:pt idx="25">
                  <c:v>[G]</c:v>
                </c:pt>
                <c:pt idx="26">
                  <c:v>[GC]</c:v>
                </c:pt>
                <c:pt idx="27">
                  <c:v>[GE]</c:v>
                </c:pt>
                <c:pt idx="28">
                  <c:v>[GEPR]</c:v>
                </c:pt>
                <c:pt idx="29">
                  <c:v>[GER]</c:v>
                </c:pt>
                <c:pt idx="30">
                  <c:v>[GM]</c:v>
                </c:pt>
                <c:pt idx="31">
                  <c:v>[GR]</c:v>
                </c:pt>
                <c:pt idx="32">
                  <c:v>[GT]</c:v>
                </c:pt>
                <c:pt idx="33">
                  <c:v>[H]</c:v>
                </c:pt>
                <c:pt idx="34">
                  <c:v>[HC]</c:v>
                </c:pt>
                <c:pt idx="35">
                  <c:v>[HE]</c:v>
                </c:pt>
                <c:pt idx="36">
                  <c:v>[HI]</c:v>
                </c:pt>
                <c:pt idx="37">
                  <c:v>[HJ]</c:v>
                </c:pt>
                <c:pt idx="38">
                  <c:v>[HQ]</c:v>
                </c:pt>
                <c:pt idx="39">
                  <c:v>[I]</c:v>
                </c:pt>
                <c:pt idx="40">
                  <c:v>[IM]</c:v>
                </c:pt>
                <c:pt idx="41">
                  <c:v>[IQ]</c:v>
                </c:pt>
                <c:pt idx="42">
                  <c:v>[IQR]</c:v>
                </c:pt>
                <c:pt idx="43">
                  <c:v>[IR]</c:v>
                </c:pt>
                <c:pt idx="44">
                  <c:v>[J]</c:v>
                </c:pt>
                <c:pt idx="45">
                  <c:v>[JD]</c:v>
                </c:pt>
                <c:pt idx="46">
                  <c:v>[K]</c:v>
                </c:pt>
                <c:pt idx="47">
                  <c:v>[KE]</c:v>
                </c:pt>
                <c:pt idx="48">
                  <c:v>[KG]</c:v>
                </c:pt>
                <c:pt idx="49">
                  <c:v>[KL]</c:v>
                </c:pt>
                <c:pt idx="50">
                  <c:v>[KR]</c:v>
                </c:pt>
                <c:pt idx="51">
                  <c:v>[KT]</c:v>
                </c:pt>
                <c:pt idx="52">
                  <c:v>[L]</c:v>
                </c:pt>
                <c:pt idx="53">
                  <c:v>[LK]</c:v>
                </c:pt>
                <c:pt idx="54">
                  <c:v>[LKJ]</c:v>
                </c:pt>
                <c:pt idx="55">
                  <c:v>[LR]</c:v>
                </c:pt>
                <c:pt idx="56">
                  <c:v>[LU]</c:v>
                </c:pt>
                <c:pt idx="57">
                  <c:v>[M]</c:v>
                </c:pt>
                <c:pt idx="58">
                  <c:v>[MG]</c:v>
                </c:pt>
                <c:pt idx="59">
                  <c:v>[MI]</c:v>
                </c:pt>
                <c:pt idx="60">
                  <c:v>[MR]</c:v>
                </c:pt>
                <c:pt idx="61">
                  <c:v>[MU]</c:v>
                </c:pt>
                <c:pt idx="62">
                  <c:v>[NOU]</c:v>
                </c:pt>
                <c:pt idx="63">
                  <c:v>[O]</c:v>
                </c:pt>
                <c:pt idx="64">
                  <c:v>[OC]</c:v>
                </c:pt>
                <c:pt idx="65">
                  <c:v>[OT]</c:v>
                </c:pt>
                <c:pt idx="66">
                  <c:v>[OU]</c:v>
                </c:pt>
                <c:pt idx="67">
                  <c:v>[P]</c:v>
                </c:pt>
                <c:pt idx="68">
                  <c:v>[PH]</c:v>
                </c:pt>
                <c:pt idx="69">
                  <c:v>[PR]</c:v>
                </c:pt>
                <c:pt idx="70">
                  <c:v>[Q]</c:v>
                </c:pt>
                <c:pt idx="71">
                  <c:v>[QK]</c:v>
                </c:pt>
                <c:pt idx="72">
                  <c:v>[QP]</c:v>
                </c:pt>
                <c:pt idx="73">
                  <c:v>[QR]</c:v>
                </c:pt>
                <c:pt idx="74">
                  <c:v>[R]</c:v>
                </c:pt>
                <c:pt idx="75">
                  <c:v>[RTKL]</c:v>
                </c:pt>
                <c:pt idx="76">
                  <c:v>[S]</c:v>
                </c:pt>
                <c:pt idx="77">
                  <c:v>[T]</c:v>
                </c:pt>
                <c:pt idx="78">
                  <c:v>[TK]</c:v>
                </c:pt>
                <c:pt idx="79">
                  <c:v>[TQ]</c:v>
                </c:pt>
                <c:pt idx="80">
                  <c:v>[U]</c:v>
                </c:pt>
                <c:pt idx="81">
                  <c:v>[V]</c:v>
                </c:pt>
              </c:strCache>
            </c:strRef>
          </c:cat>
          <c:val>
            <c:numRef>
              <c:f>Feuil6!$D$2:$D$83</c:f>
              <c:numCache>
                <c:formatCode>General</c:formatCode>
                <c:ptCount val="82"/>
                <c:pt idx="0">
                  <c:v>1</c:v>
                </c:pt>
                <c:pt idx="1">
                  <c:v>0</c:v>
                </c:pt>
                <c:pt idx="2">
                  <c:v>122</c:v>
                </c:pt>
                <c:pt idx="3">
                  <c:v>2</c:v>
                </c:pt>
                <c:pt idx="4">
                  <c:v>1</c:v>
                </c:pt>
                <c:pt idx="5">
                  <c:v>2</c:v>
                </c:pt>
                <c:pt idx="6">
                  <c:v>2</c:v>
                </c:pt>
                <c:pt idx="7">
                  <c:v>5</c:v>
                </c:pt>
                <c:pt idx="8">
                  <c:v>16</c:v>
                </c:pt>
                <c:pt idx="9">
                  <c:v>278</c:v>
                </c:pt>
                <c:pt idx="10">
                  <c:v>2</c:v>
                </c:pt>
                <c:pt idx="11">
                  <c:v>3</c:v>
                </c:pt>
                <c:pt idx="12">
                  <c:v>12</c:v>
                </c:pt>
                <c:pt idx="13">
                  <c:v>2</c:v>
                </c:pt>
                <c:pt idx="14">
                  <c:v>3</c:v>
                </c:pt>
                <c:pt idx="15">
                  <c:v>32</c:v>
                </c:pt>
                <c:pt idx="16">
                  <c:v>9</c:v>
                </c:pt>
                <c:pt idx="17">
                  <c:v>13</c:v>
                </c:pt>
                <c:pt idx="18">
                  <c:v>10</c:v>
                </c:pt>
                <c:pt idx="19">
                  <c:v>57</c:v>
                </c:pt>
                <c:pt idx="20">
                  <c:v>1</c:v>
                </c:pt>
                <c:pt idx="21">
                  <c:v>2</c:v>
                </c:pt>
                <c:pt idx="22">
                  <c:v>2</c:v>
                </c:pt>
                <c:pt idx="23">
                  <c:v>1</c:v>
                </c:pt>
                <c:pt idx="24">
                  <c:v>4</c:v>
                </c:pt>
                <c:pt idx="25">
                  <c:v>139</c:v>
                </c:pt>
                <c:pt idx="26">
                  <c:v>0</c:v>
                </c:pt>
                <c:pt idx="27">
                  <c:v>0</c:v>
                </c:pt>
                <c:pt idx="28">
                  <c:v>49</c:v>
                </c:pt>
                <c:pt idx="29">
                  <c:v>3</c:v>
                </c:pt>
                <c:pt idx="30">
                  <c:v>4</c:v>
                </c:pt>
                <c:pt idx="31">
                  <c:v>0</c:v>
                </c:pt>
                <c:pt idx="32">
                  <c:v>0</c:v>
                </c:pt>
                <c:pt idx="33">
                  <c:v>69</c:v>
                </c:pt>
                <c:pt idx="34">
                  <c:v>2</c:v>
                </c:pt>
                <c:pt idx="35">
                  <c:v>11</c:v>
                </c:pt>
                <c:pt idx="36">
                  <c:v>1</c:v>
                </c:pt>
                <c:pt idx="37">
                  <c:v>1</c:v>
                </c:pt>
                <c:pt idx="38">
                  <c:v>0</c:v>
                </c:pt>
                <c:pt idx="39">
                  <c:v>66</c:v>
                </c:pt>
                <c:pt idx="40">
                  <c:v>1</c:v>
                </c:pt>
                <c:pt idx="41">
                  <c:v>8</c:v>
                </c:pt>
                <c:pt idx="42">
                  <c:v>39</c:v>
                </c:pt>
                <c:pt idx="43">
                  <c:v>2</c:v>
                </c:pt>
                <c:pt idx="44">
                  <c:v>144</c:v>
                </c:pt>
                <c:pt idx="45">
                  <c:v>0</c:v>
                </c:pt>
                <c:pt idx="46">
                  <c:v>187</c:v>
                </c:pt>
                <c:pt idx="47">
                  <c:v>2</c:v>
                </c:pt>
                <c:pt idx="48">
                  <c:v>5</c:v>
                </c:pt>
                <c:pt idx="49">
                  <c:v>2</c:v>
                </c:pt>
                <c:pt idx="50">
                  <c:v>12</c:v>
                </c:pt>
                <c:pt idx="51">
                  <c:v>5</c:v>
                </c:pt>
                <c:pt idx="52">
                  <c:v>84</c:v>
                </c:pt>
                <c:pt idx="53">
                  <c:v>2</c:v>
                </c:pt>
                <c:pt idx="54">
                  <c:v>4</c:v>
                </c:pt>
                <c:pt idx="55">
                  <c:v>3</c:v>
                </c:pt>
                <c:pt idx="56">
                  <c:v>3</c:v>
                </c:pt>
                <c:pt idx="57">
                  <c:v>69</c:v>
                </c:pt>
                <c:pt idx="58">
                  <c:v>6</c:v>
                </c:pt>
                <c:pt idx="59">
                  <c:v>1</c:v>
                </c:pt>
                <c:pt idx="60">
                  <c:v>2</c:v>
                </c:pt>
                <c:pt idx="61">
                  <c:v>1</c:v>
                </c:pt>
                <c:pt idx="62">
                  <c:v>0</c:v>
                </c:pt>
                <c:pt idx="63">
                  <c:v>53</c:v>
                </c:pt>
                <c:pt idx="64">
                  <c:v>2</c:v>
                </c:pt>
                <c:pt idx="65">
                  <c:v>1</c:v>
                </c:pt>
                <c:pt idx="66">
                  <c:v>2</c:v>
                </c:pt>
                <c:pt idx="67">
                  <c:v>150</c:v>
                </c:pt>
                <c:pt idx="68">
                  <c:v>11</c:v>
                </c:pt>
                <c:pt idx="69">
                  <c:v>1</c:v>
                </c:pt>
                <c:pt idx="70">
                  <c:v>22</c:v>
                </c:pt>
                <c:pt idx="71">
                  <c:v>1</c:v>
                </c:pt>
                <c:pt idx="72">
                  <c:v>0</c:v>
                </c:pt>
                <c:pt idx="73">
                  <c:v>3</c:v>
                </c:pt>
                <c:pt idx="74">
                  <c:v>232</c:v>
                </c:pt>
                <c:pt idx="75">
                  <c:v>4</c:v>
                </c:pt>
                <c:pt idx="76">
                  <c:v>136</c:v>
                </c:pt>
                <c:pt idx="77">
                  <c:v>21</c:v>
                </c:pt>
                <c:pt idx="78">
                  <c:v>17</c:v>
                </c:pt>
                <c:pt idx="79">
                  <c:v>3</c:v>
                </c:pt>
                <c:pt idx="80">
                  <c:v>12</c:v>
                </c:pt>
                <c:pt idx="81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F9A-4A60-9563-D781A00A551B}"/>
            </c:ext>
          </c:extLst>
        </c:ser>
        <c:ser>
          <c:idx val="3"/>
          <c:order val="3"/>
          <c:tx>
            <c:strRef>
              <c:f>Feuil6!$E$1</c:f>
              <c:strCache>
                <c:ptCount val="1"/>
                <c:pt idx="0">
                  <c:v>Leucobacter_chromiireducens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Feuil6!$A$2:$A$83</c:f>
              <c:strCache>
                <c:ptCount val="82"/>
                <c:pt idx="0">
                  <c:v>[A]</c:v>
                </c:pt>
                <c:pt idx="1">
                  <c:v>[BQ]</c:v>
                </c:pt>
                <c:pt idx="2">
                  <c:v>[C]</c:v>
                </c:pt>
                <c:pt idx="3">
                  <c:v>[CE]</c:v>
                </c:pt>
                <c:pt idx="4">
                  <c:v>[CHR]</c:v>
                </c:pt>
                <c:pt idx="5">
                  <c:v>[CO]</c:v>
                </c:pt>
                <c:pt idx="6">
                  <c:v>[CP]</c:v>
                </c:pt>
                <c:pt idx="7">
                  <c:v>[CR]</c:v>
                </c:pt>
                <c:pt idx="8">
                  <c:v>[D]</c:v>
                </c:pt>
                <c:pt idx="9">
                  <c:v>[E]</c:v>
                </c:pt>
                <c:pt idx="10">
                  <c:v>[EF]</c:v>
                </c:pt>
                <c:pt idx="11">
                  <c:v>[EG]</c:v>
                </c:pt>
                <c:pt idx="12">
                  <c:v>[EH]</c:v>
                </c:pt>
                <c:pt idx="13">
                  <c:v>[EJ]</c:v>
                </c:pt>
                <c:pt idx="14">
                  <c:v>[EM]</c:v>
                </c:pt>
                <c:pt idx="15">
                  <c:v>[EP]</c:v>
                </c:pt>
                <c:pt idx="16">
                  <c:v>[EQ]</c:v>
                </c:pt>
                <c:pt idx="17">
                  <c:v>[ER]</c:v>
                </c:pt>
                <c:pt idx="18">
                  <c:v>[ET]</c:v>
                </c:pt>
                <c:pt idx="19">
                  <c:v>[F]</c:v>
                </c:pt>
                <c:pt idx="20">
                  <c:v>[FE]</c:v>
                </c:pt>
                <c:pt idx="21">
                  <c:v>[FGR]</c:v>
                </c:pt>
                <c:pt idx="22">
                  <c:v>[FJ]</c:v>
                </c:pt>
                <c:pt idx="23">
                  <c:v>[FP]</c:v>
                </c:pt>
                <c:pt idx="24">
                  <c:v>[FR]</c:v>
                </c:pt>
                <c:pt idx="25">
                  <c:v>[G]</c:v>
                </c:pt>
                <c:pt idx="26">
                  <c:v>[GC]</c:v>
                </c:pt>
                <c:pt idx="27">
                  <c:v>[GE]</c:v>
                </c:pt>
                <c:pt idx="28">
                  <c:v>[GEPR]</c:v>
                </c:pt>
                <c:pt idx="29">
                  <c:v>[GER]</c:v>
                </c:pt>
                <c:pt idx="30">
                  <c:v>[GM]</c:v>
                </c:pt>
                <c:pt idx="31">
                  <c:v>[GR]</c:v>
                </c:pt>
                <c:pt idx="32">
                  <c:v>[GT]</c:v>
                </c:pt>
                <c:pt idx="33">
                  <c:v>[H]</c:v>
                </c:pt>
                <c:pt idx="34">
                  <c:v>[HC]</c:v>
                </c:pt>
                <c:pt idx="35">
                  <c:v>[HE]</c:v>
                </c:pt>
                <c:pt idx="36">
                  <c:v>[HI]</c:v>
                </c:pt>
                <c:pt idx="37">
                  <c:v>[HJ]</c:v>
                </c:pt>
                <c:pt idx="38">
                  <c:v>[HQ]</c:v>
                </c:pt>
                <c:pt idx="39">
                  <c:v>[I]</c:v>
                </c:pt>
                <c:pt idx="40">
                  <c:v>[IM]</c:v>
                </c:pt>
                <c:pt idx="41">
                  <c:v>[IQ]</c:v>
                </c:pt>
                <c:pt idx="42">
                  <c:v>[IQR]</c:v>
                </c:pt>
                <c:pt idx="43">
                  <c:v>[IR]</c:v>
                </c:pt>
                <c:pt idx="44">
                  <c:v>[J]</c:v>
                </c:pt>
                <c:pt idx="45">
                  <c:v>[JD]</c:v>
                </c:pt>
                <c:pt idx="46">
                  <c:v>[K]</c:v>
                </c:pt>
                <c:pt idx="47">
                  <c:v>[KE]</c:v>
                </c:pt>
                <c:pt idx="48">
                  <c:v>[KG]</c:v>
                </c:pt>
                <c:pt idx="49">
                  <c:v>[KL]</c:v>
                </c:pt>
                <c:pt idx="50">
                  <c:v>[KR]</c:v>
                </c:pt>
                <c:pt idx="51">
                  <c:v>[KT]</c:v>
                </c:pt>
                <c:pt idx="52">
                  <c:v>[L]</c:v>
                </c:pt>
                <c:pt idx="53">
                  <c:v>[LK]</c:v>
                </c:pt>
                <c:pt idx="54">
                  <c:v>[LKJ]</c:v>
                </c:pt>
                <c:pt idx="55">
                  <c:v>[LR]</c:v>
                </c:pt>
                <c:pt idx="56">
                  <c:v>[LU]</c:v>
                </c:pt>
                <c:pt idx="57">
                  <c:v>[M]</c:v>
                </c:pt>
                <c:pt idx="58">
                  <c:v>[MG]</c:v>
                </c:pt>
                <c:pt idx="59">
                  <c:v>[MI]</c:v>
                </c:pt>
                <c:pt idx="60">
                  <c:v>[MR]</c:v>
                </c:pt>
                <c:pt idx="61">
                  <c:v>[MU]</c:v>
                </c:pt>
                <c:pt idx="62">
                  <c:v>[NOU]</c:v>
                </c:pt>
                <c:pt idx="63">
                  <c:v>[O]</c:v>
                </c:pt>
                <c:pt idx="64">
                  <c:v>[OC]</c:v>
                </c:pt>
                <c:pt idx="65">
                  <c:v>[OT]</c:v>
                </c:pt>
                <c:pt idx="66">
                  <c:v>[OU]</c:v>
                </c:pt>
                <c:pt idx="67">
                  <c:v>[P]</c:v>
                </c:pt>
                <c:pt idx="68">
                  <c:v>[PH]</c:v>
                </c:pt>
                <c:pt idx="69">
                  <c:v>[PR]</c:v>
                </c:pt>
                <c:pt idx="70">
                  <c:v>[Q]</c:v>
                </c:pt>
                <c:pt idx="71">
                  <c:v>[QK]</c:v>
                </c:pt>
                <c:pt idx="72">
                  <c:v>[QP]</c:v>
                </c:pt>
                <c:pt idx="73">
                  <c:v>[QR]</c:v>
                </c:pt>
                <c:pt idx="74">
                  <c:v>[R]</c:v>
                </c:pt>
                <c:pt idx="75">
                  <c:v>[RTKL]</c:v>
                </c:pt>
                <c:pt idx="76">
                  <c:v>[S]</c:v>
                </c:pt>
                <c:pt idx="77">
                  <c:v>[T]</c:v>
                </c:pt>
                <c:pt idx="78">
                  <c:v>[TK]</c:v>
                </c:pt>
                <c:pt idx="79">
                  <c:v>[TQ]</c:v>
                </c:pt>
                <c:pt idx="80">
                  <c:v>[U]</c:v>
                </c:pt>
                <c:pt idx="81">
                  <c:v>[V]</c:v>
                </c:pt>
              </c:strCache>
            </c:strRef>
          </c:cat>
          <c:val>
            <c:numRef>
              <c:f>Feuil6!$E$2:$E$83</c:f>
              <c:numCache>
                <c:formatCode>General</c:formatCode>
                <c:ptCount val="82"/>
                <c:pt idx="0">
                  <c:v>1</c:v>
                </c:pt>
                <c:pt idx="1">
                  <c:v>0</c:v>
                </c:pt>
                <c:pt idx="2">
                  <c:v>95</c:v>
                </c:pt>
                <c:pt idx="3">
                  <c:v>2</c:v>
                </c:pt>
                <c:pt idx="4">
                  <c:v>0</c:v>
                </c:pt>
                <c:pt idx="5">
                  <c:v>2</c:v>
                </c:pt>
                <c:pt idx="6">
                  <c:v>2</c:v>
                </c:pt>
                <c:pt idx="7">
                  <c:v>1</c:v>
                </c:pt>
                <c:pt idx="8">
                  <c:v>15</c:v>
                </c:pt>
                <c:pt idx="9">
                  <c:v>263</c:v>
                </c:pt>
                <c:pt idx="10">
                  <c:v>2</c:v>
                </c:pt>
                <c:pt idx="11">
                  <c:v>2</c:v>
                </c:pt>
                <c:pt idx="12">
                  <c:v>11</c:v>
                </c:pt>
                <c:pt idx="13">
                  <c:v>1</c:v>
                </c:pt>
                <c:pt idx="14">
                  <c:v>2</c:v>
                </c:pt>
                <c:pt idx="15">
                  <c:v>32</c:v>
                </c:pt>
                <c:pt idx="16">
                  <c:v>5</c:v>
                </c:pt>
                <c:pt idx="17">
                  <c:v>7</c:v>
                </c:pt>
                <c:pt idx="18">
                  <c:v>12</c:v>
                </c:pt>
                <c:pt idx="19">
                  <c:v>54</c:v>
                </c:pt>
                <c:pt idx="20">
                  <c:v>1</c:v>
                </c:pt>
                <c:pt idx="21">
                  <c:v>2</c:v>
                </c:pt>
                <c:pt idx="22">
                  <c:v>3</c:v>
                </c:pt>
                <c:pt idx="23">
                  <c:v>1</c:v>
                </c:pt>
                <c:pt idx="24">
                  <c:v>4</c:v>
                </c:pt>
                <c:pt idx="25">
                  <c:v>55</c:v>
                </c:pt>
                <c:pt idx="26">
                  <c:v>1</c:v>
                </c:pt>
                <c:pt idx="27">
                  <c:v>0</c:v>
                </c:pt>
                <c:pt idx="28">
                  <c:v>44</c:v>
                </c:pt>
                <c:pt idx="29">
                  <c:v>4</c:v>
                </c:pt>
                <c:pt idx="30">
                  <c:v>3</c:v>
                </c:pt>
                <c:pt idx="31">
                  <c:v>0</c:v>
                </c:pt>
                <c:pt idx="32">
                  <c:v>0</c:v>
                </c:pt>
                <c:pt idx="33">
                  <c:v>60</c:v>
                </c:pt>
                <c:pt idx="34">
                  <c:v>2</c:v>
                </c:pt>
                <c:pt idx="35">
                  <c:v>7</c:v>
                </c:pt>
                <c:pt idx="36">
                  <c:v>1</c:v>
                </c:pt>
                <c:pt idx="37">
                  <c:v>1</c:v>
                </c:pt>
                <c:pt idx="38">
                  <c:v>0</c:v>
                </c:pt>
                <c:pt idx="39">
                  <c:v>57</c:v>
                </c:pt>
                <c:pt idx="40">
                  <c:v>1</c:v>
                </c:pt>
                <c:pt idx="41">
                  <c:v>6</c:v>
                </c:pt>
                <c:pt idx="42">
                  <c:v>18</c:v>
                </c:pt>
                <c:pt idx="43">
                  <c:v>2</c:v>
                </c:pt>
                <c:pt idx="44">
                  <c:v>148</c:v>
                </c:pt>
                <c:pt idx="45">
                  <c:v>0</c:v>
                </c:pt>
                <c:pt idx="46">
                  <c:v>165</c:v>
                </c:pt>
                <c:pt idx="47">
                  <c:v>6</c:v>
                </c:pt>
                <c:pt idx="48">
                  <c:v>2</c:v>
                </c:pt>
                <c:pt idx="49">
                  <c:v>2</c:v>
                </c:pt>
                <c:pt idx="50">
                  <c:v>7</c:v>
                </c:pt>
                <c:pt idx="51">
                  <c:v>3</c:v>
                </c:pt>
                <c:pt idx="52">
                  <c:v>77</c:v>
                </c:pt>
                <c:pt idx="53">
                  <c:v>2</c:v>
                </c:pt>
                <c:pt idx="54">
                  <c:v>4</c:v>
                </c:pt>
                <c:pt idx="55">
                  <c:v>3</c:v>
                </c:pt>
                <c:pt idx="56">
                  <c:v>3</c:v>
                </c:pt>
                <c:pt idx="57">
                  <c:v>60</c:v>
                </c:pt>
                <c:pt idx="58">
                  <c:v>3</c:v>
                </c:pt>
                <c:pt idx="59">
                  <c:v>1</c:v>
                </c:pt>
                <c:pt idx="60">
                  <c:v>3</c:v>
                </c:pt>
                <c:pt idx="61">
                  <c:v>2</c:v>
                </c:pt>
                <c:pt idx="62">
                  <c:v>0</c:v>
                </c:pt>
                <c:pt idx="63">
                  <c:v>50</c:v>
                </c:pt>
                <c:pt idx="64">
                  <c:v>6</c:v>
                </c:pt>
                <c:pt idx="65">
                  <c:v>1</c:v>
                </c:pt>
                <c:pt idx="66">
                  <c:v>2</c:v>
                </c:pt>
                <c:pt idx="67">
                  <c:v>148</c:v>
                </c:pt>
                <c:pt idx="68">
                  <c:v>5</c:v>
                </c:pt>
                <c:pt idx="69">
                  <c:v>1</c:v>
                </c:pt>
                <c:pt idx="70">
                  <c:v>17</c:v>
                </c:pt>
                <c:pt idx="71">
                  <c:v>0</c:v>
                </c:pt>
                <c:pt idx="72">
                  <c:v>1</c:v>
                </c:pt>
                <c:pt idx="73">
                  <c:v>2</c:v>
                </c:pt>
                <c:pt idx="74">
                  <c:v>219</c:v>
                </c:pt>
                <c:pt idx="75">
                  <c:v>2</c:v>
                </c:pt>
                <c:pt idx="76">
                  <c:v>115</c:v>
                </c:pt>
                <c:pt idx="77">
                  <c:v>30</c:v>
                </c:pt>
                <c:pt idx="78">
                  <c:v>22</c:v>
                </c:pt>
                <c:pt idx="79">
                  <c:v>6</c:v>
                </c:pt>
                <c:pt idx="80">
                  <c:v>14</c:v>
                </c:pt>
                <c:pt idx="81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F9A-4A60-9563-D781A00A551B}"/>
            </c:ext>
          </c:extLst>
        </c:ser>
        <c:ser>
          <c:idx val="4"/>
          <c:order val="4"/>
          <c:tx>
            <c:strRef>
              <c:f>Feuil6!$F$1</c:f>
              <c:strCache>
                <c:ptCount val="1"/>
                <c:pt idx="0">
                  <c:v>Leucobacter_celer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Feuil6!$A$2:$A$83</c:f>
              <c:strCache>
                <c:ptCount val="82"/>
                <c:pt idx="0">
                  <c:v>[A]</c:v>
                </c:pt>
                <c:pt idx="1">
                  <c:v>[BQ]</c:v>
                </c:pt>
                <c:pt idx="2">
                  <c:v>[C]</c:v>
                </c:pt>
                <c:pt idx="3">
                  <c:v>[CE]</c:v>
                </c:pt>
                <c:pt idx="4">
                  <c:v>[CHR]</c:v>
                </c:pt>
                <c:pt idx="5">
                  <c:v>[CO]</c:v>
                </c:pt>
                <c:pt idx="6">
                  <c:v>[CP]</c:v>
                </c:pt>
                <c:pt idx="7">
                  <c:v>[CR]</c:v>
                </c:pt>
                <c:pt idx="8">
                  <c:v>[D]</c:v>
                </c:pt>
                <c:pt idx="9">
                  <c:v>[E]</c:v>
                </c:pt>
                <c:pt idx="10">
                  <c:v>[EF]</c:v>
                </c:pt>
                <c:pt idx="11">
                  <c:v>[EG]</c:v>
                </c:pt>
                <c:pt idx="12">
                  <c:v>[EH]</c:v>
                </c:pt>
                <c:pt idx="13">
                  <c:v>[EJ]</c:v>
                </c:pt>
                <c:pt idx="14">
                  <c:v>[EM]</c:v>
                </c:pt>
                <c:pt idx="15">
                  <c:v>[EP]</c:v>
                </c:pt>
                <c:pt idx="16">
                  <c:v>[EQ]</c:v>
                </c:pt>
                <c:pt idx="17">
                  <c:v>[ER]</c:v>
                </c:pt>
                <c:pt idx="18">
                  <c:v>[ET]</c:v>
                </c:pt>
                <c:pt idx="19">
                  <c:v>[F]</c:v>
                </c:pt>
                <c:pt idx="20">
                  <c:v>[FE]</c:v>
                </c:pt>
                <c:pt idx="21">
                  <c:v>[FGR]</c:v>
                </c:pt>
                <c:pt idx="22">
                  <c:v>[FJ]</c:v>
                </c:pt>
                <c:pt idx="23">
                  <c:v>[FP]</c:v>
                </c:pt>
                <c:pt idx="24">
                  <c:v>[FR]</c:v>
                </c:pt>
                <c:pt idx="25">
                  <c:v>[G]</c:v>
                </c:pt>
                <c:pt idx="26">
                  <c:v>[GC]</c:v>
                </c:pt>
                <c:pt idx="27">
                  <c:v>[GE]</c:v>
                </c:pt>
                <c:pt idx="28">
                  <c:v>[GEPR]</c:v>
                </c:pt>
                <c:pt idx="29">
                  <c:v>[GER]</c:v>
                </c:pt>
                <c:pt idx="30">
                  <c:v>[GM]</c:v>
                </c:pt>
                <c:pt idx="31">
                  <c:v>[GR]</c:v>
                </c:pt>
                <c:pt idx="32">
                  <c:v>[GT]</c:v>
                </c:pt>
                <c:pt idx="33">
                  <c:v>[H]</c:v>
                </c:pt>
                <c:pt idx="34">
                  <c:v>[HC]</c:v>
                </c:pt>
                <c:pt idx="35">
                  <c:v>[HE]</c:v>
                </c:pt>
                <c:pt idx="36">
                  <c:v>[HI]</c:v>
                </c:pt>
                <c:pt idx="37">
                  <c:v>[HJ]</c:v>
                </c:pt>
                <c:pt idx="38">
                  <c:v>[HQ]</c:v>
                </c:pt>
                <c:pt idx="39">
                  <c:v>[I]</c:v>
                </c:pt>
                <c:pt idx="40">
                  <c:v>[IM]</c:v>
                </c:pt>
                <c:pt idx="41">
                  <c:v>[IQ]</c:v>
                </c:pt>
                <c:pt idx="42">
                  <c:v>[IQR]</c:v>
                </c:pt>
                <c:pt idx="43">
                  <c:v>[IR]</c:v>
                </c:pt>
                <c:pt idx="44">
                  <c:v>[J]</c:v>
                </c:pt>
                <c:pt idx="45">
                  <c:v>[JD]</c:v>
                </c:pt>
                <c:pt idx="46">
                  <c:v>[K]</c:v>
                </c:pt>
                <c:pt idx="47">
                  <c:v>[KE]</c:v>
                </c:pt>
                <c:pt idx="48">
                  <c:v>[KG]</c:v>
                </c:pt>
                <c:pt idx="49">
                  <c:v>[KL]</c:v>
                </c:pt>
                <c:pt idx="50">
                  <c:v>[KR]</c:v>
                </c:pt>
                <c:pt idx="51">
                  <c:v>[KT]</c:v>
                </c:pt>
                <c:pt idx="52">
                  <c:v>[L]</c:v>
                </c:pt>
                <c:pt idx="53">
                  <c:v>[LK]</c:v>
                </c:pt>
                <c:pt idx="54">
                  <c:v>[LKJ]</c:v>
                </c:pt>
                <c:pt idx="55">
                  <c:v>[LR]</c:v>
                </c:pt>
                <c:pt idx="56">
                  <c:v>[LU]</c:v>
                </c:pt>
                <c:pt idx="57">
                  <c:v>[M]</c:v>
                </c:pt>
                <c:pt idx="58">
                  <c:v>[MG]</c:v>
                </c:pt>
                <c:pt idx="59">
                  <c:v>[MI]</c:v>
                </c:pt>
                <c:pt idx="60">
                  <c:v>[MR]</c:v>
                </c:pt>
                <c:pt idx="61">
                  <c:v>[MU]</c:v>
                </c:pt>
                <c:pt idx="62">
                  <c:v>[NOU]</c:v>
                </c:pt>
                <c:pt idx="63">
                  <c:v>[O]</c:v>
                </c:pt>
                <c:pt idx="64">
                  <c:v>[OC]</c:v>
                </c:pt>
                <c:pt idx="65">
                  <c:v>[OT]</c:v>
                </c:pt>
                <c:pt idx="66">
                  <c:v>[OU]</c:v>
                </c:pt>
                <c:pt idx="67">
                  <c:v>[P]</c:v>
                </c:pt>
                <c:pt idx="68">
                  <c:v>[PH]</c:v>
                </c:pt>
                <c:pt idx="69">
                  <c:v>[PR]</c:v>
                </c:pt>
                <c:pt idx="70">
                  <c:v>[Q]</c:v>
                </c:pt>
                <c:pt idx="71">
                  <c:v>[QK]</c:v>
                </c:pt>
                <c:pt idx="72">
                  <c:v>[QP]</c:v>
                </c:pt>
                <c:pt idx="73">
                  <c:v>[QR]</c:v>
                </c:pt>
                <c:pt idx="74">
                  <c:v>[R]</c:v>
                </c:pt>
                <c:pt idx="75">
                  <c:v>[RTKL]</c:v>
                </c:pt>
                <c:pt idx="76">
                  <c:v>[S]</c:v>
                </c:pt>
                <c:pt idx="77">
                  <c:v>[T]</c:v>
                </c:pt>
                <c:pt idx="78">
                  <c:v>[TK]</c:v>
                </c:pt>
                <c:pt idx="79">
                  <c:v>[TQ]</c:v>
                </c:pt>
                <c:pt idx="80">
                  <c:v>[U]</c:v>
                </c:pt>
                <c:pt idx="81">
                  <c:v>[V]</c:v>
                </c:pt>
              </c:strCache>
            </c:strRef>
          </c:cat>
          <c:val>
            <c:numRef>
              <c:f>Feuil6!$F$2:$F$83</c:f>
              <c:numCache>
                <c:formatCode>General</c:formatCode>
                <c:ptCount val="82"/>
                <c:pt idx="0">
                  <c:v>1</c:v>
                </c:pt>
                <c:pt idx="1">
                  <c:v>1</c:v>
                </c:pt>
                <c:pt idx="2">
                  <c:v>162</c:v>
                </c:pt>
                <c:pt idx="3">
                  <c:v>3</c:v>
                </c:pt>
                <c:pt idx="4">
                  <c:v>0</c:v>
                </c:pt>
                <c:pt idx="5">
                  <c:v>2</c:v>
                </c:pt>
                <c:pt idx="6">
                  <c:v>3</c:v>
                </c:pt>
                <c:pt idx="7">
                  <c:v>4</c:v>
                </c:pt>
                <c:pt idx="8">
                  <c:v>18</c:v>
                </c:pt>
                <c:pt idx="9">
                  <c:v>339</c:v>
                </c:pt>
                <c:pt idx="10">
                  <c:v>2</c:v>
                </c:pt>
                <c:pt idx="11">
                  <c:v>1</c:v>
                </c:pt>
                <c:pt idx="12">
                  <c:v>12</c:v>
                </c:pt>
                <c:pt idx="13">
                  <c:v>2</c:v>
                </c:pt>
                <c:pt idx="14">
                  <c:v>3</c:v>
                </c:pt>
                <c:pt idx="15">
                  <c:v>46</c:v>
                </c:pt>
                <c:pt idx="16">
                  <c:v>9</c:v>
                </c:pt>
                <c:pt idx="17">
                  <c:v>21</c:v>
                </c:pt>
                <c:pt idx="18">
                  <c:v>12</c:v>
                </c:pt>
                <c:pt idx="19">
                  <c:v>64</c:v>
                </c:pt>
                <c:pt idx="20">
                  <c:v>1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4</c:v>
                </c:pt>
                <c:pt idx="25">
                  <c:v>157</c:v>
                </c:pt>
                <c:pt idx="26">
                  <c:v>0</c:v>
                </c:pt>
                <c:pt idx="27">
                  <c:v>1</c:v>
                </c:pt>
                <c:pt idx="28">
                  <c:v>47</c:v>
                </c:pt>
                <c:pt idx="29">
                  <c:v>3</c:v>
                </c:pt>
                <c:pt idx="30">
                  <c:v>3</c:v>
                </c:pt>
                <c:pt idx="31">
                  <c:v>1</c:v>
                </c:pt>
                <c:pt idx="32">
                  <c:v>0</c:v>
                </c:pt>
                <c:pt idx="33">
                  <c:v>79</c:v>
                </c:pt>
                <c:pt idx="34">
                  <c:v>3</c:v>
                </c:pt>
                <c:pt idx="35">
                  <c:v>1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95</c:v>
                </c:pt>
                <c:pt idx="40">
                  <c:v>1</c:v>
                </c:pt>
                <c:pt idx="41">
                  <c:v>6</c:v>
                </c:pt>
                <c:pt idx="42">
                  <c:v>54</c:v>
                </c:pt>
                <c:pt idx="43">
                  <c:v>4</c:v>
                </c:pt>
                <c:pt idx="44">
                  <c:v>157</c:v>
                </c:pt>
                <c:pt idx="45">
                  <c:v>0</c:v>
                </c:pt>
                <c:pt idx="46">
                  <c:v>215</c:v>
                </c:pt>
                <c:pt idx="47">
                  <c:v>3</c:v>
                </c:pt>
                <c:pt idx="48">
                  <c:v>8</c:v>
                </c:pt>
                <c:pt idx="49">
                  <c:v>2</c:v>
                </c:pt>
                <c:pt idx="50">
                  <c:v>8</c:v>
                </c:pt>
                <c:pt idx="51">
                  <c:v>2</c:v>
                </c:pt>
                <c:pt idx="52">
                  <c:v>108</c:v>
                </c:pt>
                <c:pt idx="53">
                  <c:v>2</c:v>
                </c:pt>
                <c:pt idx="54">
                  <c:v>4</c:v>
                </c:pt>
                <c:pt idx="55">
                  <c:v>3</c:v>
                </c:pt>
                <c:pt idx="56">
                  <c:v>2</c:v>
                </c:pt>
                <c:pt idx="57">
                  <c:v>70</c:v>
                </c:pt>
                <c:pt idx="58">
                  <c:v>5</c:v>
                </c:pt>
                <c:pt idx="59">
                  <c:v>2</c:v>
                </c:pt>
                <c:pt idx="60">
                  <c:v>1</c:v>
                </c:pt>
                <c:pt idx="61">
                  <c:v>1</c:v>
                </c:pt>
                <c:pt idx="62">
                  <c:v>1</c:v>
                </c:pt>
                <c:pt idx="63">
                  <c:v>51</c:v>
                </c:pt>
                <c:pt idx="64">
                  <c:v>3</c:v>
                </c:pt>
                <c:pt idx="65">
                  <c:v>1</c:v>
                </c:pt>
                <c:pt idx="66">
                  <c:v>2</c:v>
                </c:pt>
                <c:pt idx="67">
                  <c:v>141</c:v>
                </c:pt>
                <c:pt idx="68">
                  <c:v>6</c:v>
                </c:pt>
                <c:pt idx="69">
                  <c:v>1</c:v>
                </c:pt>
                <c:pt idx="70">
                  <c:v>36</c:v>
                </c:pt>
                <c:pt idx="71">
                  <c:v>0</c:v>
                </c:pt>
                <c:pt idx="72">
                  <c:v>0</c:v>
                </c:pt>
                <c:pt idx="73">
                  <c:v>4</c:v>
                </c:pt>
                <c:pt idx="74">
                  <c:v>265</c:v>
                </c:pt>
                <c:pt idx="75">
                  <c:v>2</c:v>
                </c:pt>
                <c:pt idx="76">
                  <c:v>163</c:v>
                </c:pt>
                <c:pt idx="77">
                  <c:v>27</c:v>
                </c:pt>
                <c:pt idx="78">
                  <c:v>26</c:v>
                </c:pt>
                <c:pt idx="79">
                  <c:v>7</c:v>
                </c:pt>
                <c:pt idx="80">
                  <c:v>16</c:v>
                </c:pt>
                <c:pt idx="81">
                  <c:v>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F9A-4A60-9563-D781A00A55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1630720"/>
        <c:axId val="511634984"/>
      </c:radarChart>
      <c:catAx>
        <c:axId val="511630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1634984"/>
        <c:crosses val="autoZero"/>
        <c:auto val="1"/>
        <c:lblAlgn val="ctr"/>
        <c:lblOffset val="100"/>
        <c:noMultiLvlLbl val="0"/>
      </c:catAx>
      <c:valAx>
        <c:axId val="5116349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116307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FDB5909-429D-4766-9D7F-0C341A3D46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EA3E1C0-498E-4520-BA13-98FB86C9CD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1638232-01AD-4F1B-8AB9-FF9FC5155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8187462-6615-4A95-8B25-E59F08165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5551A43-1E73-4C4B-9D22-2F3CC9E069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2710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E416EF0-EC83-489B-9AAE-2F6C37C4F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6A5ADCE-3071-4EB2-B178-FC7268FFED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E9C60C6-3168-4516-98AC-D7BBB8EF68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E980109-9C04-4500-B679-C2EFFBB6E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30C990-83E1-4975-9EE8-D7734EAD2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9893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F3157F1-DBF2-49CD-95D3-AF6BA0A0DF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9002C5B-1B54-40E9-841D-85D04E7C3B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4F871D3-F6C5-47D2-82A3-43D100E77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9642848-949B-4468-B8CC-D505FA5C8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54C39CF-B9DE-405B-B600-DF537733E6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1538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64842A-E82F-4DD1-8AEA-BFC3F45D58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E0F4E7C-A446-4DE2-96CB-64F65A6173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7C6BEAE-1A55-488F-B605-EA69382E8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1EAEFC4-91FA-4EA8-B629-8843ABA5E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9DAF22-B803-497C-8503-8E6C34342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684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D3E51C-7CDA-417B-85A0-6DA53836F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7EE147F-6DD9-4F48-A9F8-7AC03FADC0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8E3DC4-9BEA-4C8E-8D7A-8C45A5BA8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7A44B74-3DBD-484B-9C79-23C4CB9B8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31AABF9-C449-4198-A5EC-7E02A072A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3492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A1BEA2-7B59-4DEF-93DC-C80B8D026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264580B-8945-4FEE-8DB4-6D9C989D63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5D00077-7518-4016-B631-3CD72B92FB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18F3F0B-823C-41C2-AA07-B4307D8BE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18C92-4434-4020-AB12-8D1104495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8321FB9-5DD5-48AA-827E-059116E3D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1957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8DC81A8-EF43-4D69-8CB1-025B92E54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ED91F75-EC4F-4166-961A-2D39AC30E0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44D31DD-844C-48FE-92C7-8243CFBB88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7058688-F440-48D5-B58C-164D6E3CDD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9E2503D-4C29-4E90-B383-C45C825424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A43CF3A-C956-4D9E-BB60-321FB73F5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C844CB3-16CE-4382-B9A5-6D093C8D5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53B5CEE-315F-4BDD-9B4A-0472BF9EE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0842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1CD106D-24E8-45B5-B8A2-3E9F38B20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D174D6C-9986-416E-9F8D-CE8F15503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F1753F3-F503-469A-9C35-653679CC2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5F32595-D85B-482F-A279-12D539287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8691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BF6B600-43F9-4299-8F19-5CB4C93B9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C144729-7733-41FE-AD57-EE8E3CE02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33699F2-8C7E-4BAC-B21F-7B6A3B08F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1470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EC58E1A-030C-40EF-8475-8D2ABA339B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7363173-ADAB-4F7C-B77D-7228FD5F6C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53A2259-6A54-4EF2-B2AA-B9118D1D44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71D13E1-691C-4C17-9D86-51759C675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B1BD2C5-2447-4D41-8793-7535DFA7B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E2A9BD7-493C-4AA6-8B10-ED3672538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6672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5B040C-6724-4BFE-833E-2873340F1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362B4CF-CD62-4552-AB84-CB4132BE48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3AB4AE8-D261-4F9C-8957-617779AEBB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4718211-C4FB-468A-B68E-AC66C892C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18E52-756F-479D-A4B8-519AB62C1794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8C28452-B5D2-452E-B50A-7DC4E208E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0DDA009-DEF1-4920-8CB9-7D9B3BB77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15A3C-B0AF-434B-8821-79CF47F59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3524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8B240C8-90A6-4FAA-A2A0-588D23395B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BB7D057-E7BA-459B-82D1-E27FB94029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1089191-0AED-48A5-820B-77F132F7F3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fld id="{FD918E52-756F-479D-A4B8-519AB62C1794}" type="datetimeFigureOut">
              <a:rPr lang="fr-FR" smtClean="0"/>
              <a:pPr/>
              <a:t>10/10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1FEE242-5238-425D-9414-DA500B1101C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A96E2BA-978B-4EEF-922B-10C180320D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pitchFamily="18" charset="0"/>
              </a:defRPr>
            </a:lvl1pPr>
          </a:lstStyle>
          <a:p>
            <a:fld id="{E8515A3C-B0AF-434B-8821-79CF47F59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4835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Times New Roman" panose="02020603050405020304" pitchFamily="18" charset="0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828E9F6-DE85-48ED-9FC7-8D9346584008}"/>
              </a:ext>
            </a:extLst>
          </p:cNvPr>
          <p:cNvSpPr/>
          <p:nvPr/>
        </p:nvSpPr>
        <p:spPr>
          <a:xfrm>
            <a:off x="838200" y="935136"/>
            <a:ext cx="10515600" cy="1189493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fr-FR" sz="5400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Supplementary</a:t>
            </a:r>
            <a:r>
              <a:rPr lang="fr-FR" sz="5400" b="1" dirty="0">
                <a:latin typeface="Times New Roman"/>
                <a:ea typeface="Times New Roman" panose="02020603050405020304" pitchFamily="18" charset="0"/>
                <a:cs typeface="Times New Roman"/>
              </a:rPr>
              <a:t> Data</a:t>
            </a:r>
            <a:endParaRPr lang="fr-FR" sz="5400" dirty="0">
              <a:latin typeface="Times New Roman"/>
              <a:ea typeface="Times New Roman" panose="02020603050405020304" pitchFamily="18" charset="0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0837638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20A18186-EEBC-4F1E-9B8C-29EBEB8217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0928963"/>
              </p:ext>
            </p:extLst>
          </p:nvPr>
        </p:nvGraphicFramePr>
        <p:xfrm>
          <a:off x="1285087" y="1031998"/>
          <a:ext cx="9512969" cy="5351565"/>
        </p:xfrm>
        <a:graphic>
          <a:graphicData uri="http://schemas.openxmlformats.org/drawingml/2006/table">
            <a:tbl>
              <a:tblPr/>
              <a:tblGrid>
                <a:gridCol w="4300384">
                  <a:extLst>
                    <a:ext uri="{9D8B030D-6E8A-4147-A177-3AD203B41FA5}">
                      <a16:colId xmlns:a16="http://schemas.microsoft.com/office/drawing/2014/main" val="1406955227"/>
                    </a:ext>
                  </a:extLst>
                </a:gridCol>
                <a:gridCol w="2193629">
                  <a:extLst>
                    <a:ext uri="{9D8B030D-6E8A-4147-A177-3AD203B41FA5}">
                      <a16:colId xmlns:a16="http://schemas.microsoft.com/office/drawing/2014/main" val="283838006"/>
                    </a:ext>
                  </a:extLst>
                </a:gridCol>
                <a:gridCol w="1433461">
                  <a:extLst>
                    <a:ext uri="{9D8B030D-6E8A-4147-A177-3AD203B41FA5}">
                      <a16:colId xmlns:a16="http://schemas.microsoft.com/office/drawing/2014/main" val="517638639"/>
                    </a:ext>
                  </a:extLst>
                </a:gridCol>
                <a:gridCol w="1585495">
                  <a:extLst>
                    <a:ext uri="{9D8B030D-6E8A-4147-A177-3AD203B41FA5}">
                      <a16:colId xmlns:a16="http://schemas.microsoft.com/office/drawing/2014/main" val="1801436921"/>
                    </a:ext>
                  </a:extLst>
                </a:gridCol>
              </a:tblGrid>
              <a:tr h="1673678">
                <a:tc>
                  <a:txBody>
                    <a:bodyPr/>
                    <a:lstStyle/>
                    <a:p>
                      <a:pPr algn="ctr" fontAlgn="ctr"/>
                      <a:endParaRPr lang="fr-FR" sz="1100" b="1" i="0" u="none" strike="noStrike" dirty="0"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effectLst/>
                          <a:latin typeface="Times New Roman"/>
                        </a:rPr>
                        <a:t>dDDH</a:t>
                      </a:r>
                      <a:r>
                        <a:rPr lang="fr-FR" sz="1100" b="1" i="0" u="none" strike="noStrike">
                          <a:effectLst/>
                          <a:latin typeface="Times New Roman"/>
                        </a:rPr>
                        <a:t> (in %) </a:t>
                      </a:r>
                      <a:r>
                        <a:rPr lang="fr-FR" sz="1100" b="1" i="0" u="none" strike="noStrike" err="1">
                          <a:effectLst/>
                          <a:latin typeface="Times New Roman"/>
                        </a:rPr>
                        <a:t>with</a:t>
                      </a:r>
                      <a:r>
                        <a:rPr lang="fr-FR" sz="1100" b="1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1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1" i="1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1" i="1" u="none" strike="noStrike" err="1">
                          <a:effectLst/>
                          <a:latin typeface="Times New Roman"/>
                        </a:rPr>
                        <a:t>manosquensis</a:t>
                      </a:r>
                      <a:r>
                        <a:rPr lang="fr-FR" sz="1100" b="1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1" i="0" u="none" strike="noStrike" err="1">
                          <a:effectLst/>
                          <a:latin typeface="Times New Roman"/>
                        </a:rPr>
                        <a:t>strain</a:t>
                      </a:r>
                      <a:r>
                        <a:rPr lang="fr-FR" sz="1100" b="1" i="0" u="none" strike="noStrike">
                          <a:effectLst/>
                          <a:latin typeface="Times New Roman"/>
                        </a:rPr>
                        <a:t> Marseille-Q4368</a:t>
                      </a:r>
                      <a:endParaRPr lang="fr-FR" sz="1100" b="1" i="0" u="none" strike="noStrike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effectLst/>
                          <a:latin typeface="Times New Roman"/>
                        </a:rPr>
                        <a:t>C.I. (in 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effectLst/>
                          <a:latin typeface="Times New Roman"/>
                        </a:rPr>
                        <a:t>G+C content difference (in 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9361655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chromiiresistens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JG 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7,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25.1 - 29.9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,9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3380720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chromiiresistens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DSM 2278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6,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24.5 - 29.4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,9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9669172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japonicus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DSM 271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2,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20.5 - 25.2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0,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3210138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musarum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DSM 271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2,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20.3 - 25.0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0,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903270"/>
                  </a:ext>
                </a:extLst>
              </a:tr>
              <a:tr h="615817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>
                          <a:effectLst/>
                          <a:latin typeface="Times New Roman"/>
                        </a:rPr>
                        <a:t>celer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subsp</a:t>
                      </a:r>
                      <a:r>
                        <a:rPr lang="fr-FR" sz="1100" b="0" i="1" u="none" strike="noStrike">
                          <a:effectLst/>
                          <a:latin typeface="Times New Roman"/>
                        </a:rPr>
                        <a:t>.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astrifacien</a:t>
                      </a:r>
                      <a:r>
                        <a:rPr lang="fr-FR" sz="1100" b="0" i="0" u="none" strike="noStrike" err="1">
                          <a:effectLst/>
                          <a:latin typeface="Times New Roman"/>
                        </a:rPr>
                        <a:t>s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DSM 271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2,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20.4 - 25.1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1,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845894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>
                          <a:effectLst/>
                          <a:latin typeface="Times New Roman"/>
                        </a:rPr>
                        <a:t>muris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DSM 1019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2,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20.2 - 24.9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3,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8340312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chironomi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DSM 198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2,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19.9 - 24.6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,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6597207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massiliensis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122RC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19.7 - 24.4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3,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3407991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triazinivorans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JW-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1,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19.6 - 24.3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,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0115423"/>
                  </a:ext>
                </a:extLst>
              </a:tr>
              <a:tr h="34023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1" u="none" strike="noStrike" err="1">
                          <a:effectLst/>
                          <a:latin typeface="Times New Roman"/>
                        </a:rPr>
                        <a:t>luti</a:t>
                      </a:r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 RF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21,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effectLst/>
                          <a:latin typeface="Times New Roman"/>
                        </a:rPr>
                        <a:t>[19.2 - 23.9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effectLst/>
                          <a:latin typeface="Times New Roman"/>
                        </a:rPr>
                        <a:t>2,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54787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285B274B-D595-4BF1-9789-CDBAB0B6BBFA}"/>
              </a:ext>
            </a:extLst>
          </p:cNvPr>
          <p:cNvSpPr/>
          <p:nvPr/>
        </p:nvSpPr>
        <p:spPr>
          <a:xfrm>
            <a:off x="782481" y="486438"/>
            <a:ext cx="10554397" cy="276999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fr-FR" sz="1200" b="1" dirty="0">
                <a:latin typeface="Times New Roman"/>
                <a:cs typeface="Times New Roman"/>
              </a:rPr>
              <a:t>Table S1 </a:t>
            </a:r>
            <a:r>
              <a:rPr lang="fr-FR" sz="1200" dirty="0">
                <a:latin typeface="Times New Roman"/>
                <a:cs typeface="Times New Roman"/>
              </a:rPr>
              <a:t>: Digital DNA–DNA </a:t>
            </a:r>
            <a:r>
              <a:rPr lang="fr-FR" sz="1200" dirty="0" err="1">
                <a:latin typeface="Times New Roman"/>
                <a:cs typeface="Times New Roman"/>
              </a:rPr>
              <a:t>hybridization</a:t>
            </a:r>
            <a:r>
              <a:rPr lang="fr-FR" sz="1200" dirty="0">
                <a:latin typeface="Times New Roman"/>
                <a:cs typeface="Times New Roman"/>
              </a:rPr>
              <a:t> values </a:t>
            </a:r>
            <a:r>
              <a:rPr lang="fr-FR" sz="1200" dirty="0" err="1">
                <a:latin typeface="Times New Roman"/>
                <a:cs typeface="Times New Roman"/>
              </a:rPr>
              <a:t>obtained</a:t>
            </a:r>
            <a:r>
              <a:rPr lang="fr-FR" sz="1200" dirty="0">
                <a:latin typeface="Times New Roman"/>
                <a:cs typeface="Times New Roman"/>
              </a:rPr>
              <a:t> by </a:t>
            </a:r>
            <a:r>
              <a:rPr lang="fr-FR" sz="1200" dirty="0" err="1">
                <a:latin typeface="Times New Roman"/>
                <a:cs typeface="Times New Roman"/>
              </a:rPr>
              <a:t>sequenc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omparison</a:t>
            </a:r>
            <a:r>
              <a:rPr lang="fr-FR" sz="1200" dirty="0">
                <a:latin typeface="Times New Roman"/>
                <a:cs typeface="Times New Roman"/>
              </a:rPr>
              <a:t> of all </a:t>
            </a:r>
            <a:r>
              <a:rPr lang="fr-FR" sz="1200" dirty="0" err="1">
                <a:latin typeface="Times New Roman"/>
                <a:cs typeface="Times New Roman"/>
              </a:rPr>
              <a:t>studi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genome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using</a:t>
            </a:r>
            <a:r>
              <a:rPr lang="fr-FR" sz="1200" dirty="0">
                <a:latin typeface="Times New Roman"/>
                <a:cs typeface="Times New Roman"/>
              </a:rPr>
              <a:t> TYGS second value</a:t>
            </a:r>
          </a:p>
        </p:txBody>
      </p:sp>
    </p:spTree>
    <p:extLst>
      <p:ext uri="{BB962C8B-B14F-4D97-AF65-F5344CB8AC3E}">
        <p14:creationId xmlns:p14="http://schemas.microsoft.com/office/powerpoint/2010/main" val="17883060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latin typeface="Times New Roman" panose="02020603050405020304" pitchFamily="18" charset="0"/>
            </a:endParaRP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4C15C493-40D4-CE24-C4AC-C39C95A4A30D}"/>
              </a:ext>
            </a:extLst>
          </p:cNvPr>
          <p:cNvGrpSpPr/>
          <p:nvPr/>
        </p:nvGrpSpPr>
        <p:grpSpPr>
          <a:xfrm>
            <a:off x="1312164" y="782477"/>
            <a:ext cx="9249621" cy="3649054"/>
            <a:chOff x="1312164" y="782477"/>
            <a:chExt cx="9249621" cy="3649054"/>
          </a:xfrm>
        </p:grpSpPr>
        <p:pic>
          <p:nvPicPr>
            <p:cNvPr id="4" name="Image 3" descr="Une image contenant mur, intérieur&#10;&#10;Description générée automatiquement">
              <a:extLst>
                <a:ext uri="{FF2B5EF4-FFF2-40B4-BE49-F238E27FC236}">
                  <a16:creationId xmlns:a16="http://schemas.microsoft.com/office/drawing/2014/main" id="{2EA5F898-C2DC-417D-8EE9-F734E93E02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-2" b="19741"/>
            <a:stretch/>
          </p:blipFill>
          <p:spPr>
            <a:xfrm rot="5400000">
              <a:off x="7639021" y="1508767"/>
              <a:ext cx="3649052" cy="2196475"/>
            </a:xfrm>
            <a:prstGeom prst="rect">
              <a:avLst/>
            </a:prstGeom>
          </p:spPr>
        </p:pic>
        <p:pic>
          <p:nvPicPr>
            <p:cNvPr id="3" name="Image 2" descr="Une image contenant tasse, fermer&#10;&#10;Description générée automatiquement">
              <a:extLst>
                <a:ext uri="{FF2B5EF4-FFF2-40B4-BE49-F238E27FC236}">
                  <a16:creationId xmlns:a16="http://schemas.microsoft.com/office/drawing/2014/main" id="{95B8B648-7E18-4F64-A2D0-EECAF9545D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-1671" r="-3011" b="-2"/>
            <a:stretch/>
          </p:blipFill>
          <p:spPr>
            <a:xfrm>
              <a:off x="4572001" y="782478"/>
              <a:ext cx="3819813" cy="3649052"/>
            </a:xfrm>
            <a:prstGeom prst="rect">
              <a:avLst/>
            </a:prstGeom>
          </p:spPr>
        </p:pic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5E02375A-D473-4FFB-8770-72FEC08D29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33271" b="-2"/>
            <a:stretch/>
          </p:blipFill>
          <p:spPr>
            <a:xfrm>
              <a:off x="1312164" y="782478"/>
              <a:ext cx="3246585" cy="3649052"/>
            </a:xfrm>
            <a:prstGeom prst="rect">
              <a:avLst/>
            </a:prstGeom>
          </p:spPr>
        </p:pic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248D695B-8F56-47D7-8171-D37F349DBBB1}"/>
                </a:ext>
              </a:extLst>
            </p:cNvPr>
            <p:cNvSpPr txBox="1"/>
            <p:nvPr/>
          </p:nvSpPr>
          <p:spPr>
            <a:xfrm>
              <a:off x="1312164" y="782477"/>
              <a:ext cx="9249621" cy="369332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fr-FR" b="1" dirty="0">
                  <a:latin typeface="Times New Roman"/>
                  <a:cs typeface="Times New Roman"/>
                </a:rPr>
                <a:t>A)</a:t>
              </a:r>
              <a:r>
                <a:rPr lang="fr-FR" b="1" dirty="0">
                  <a:solidFill>
                    <a:schemeClr val="bg2"/>
                  </a:solidFill>
                  <a:latin typeface="Times New Roman"/>
                  <a:cs typeface="Times New Roman"/>
                </a:rPr>
                <a:t>			          B)				           C)</a:t>
              </a:r>
            </a:p>
          </p:txBody>
        </p:sp>
      </p:grpSp>
      <p:sp>
        <p:nvSpPr>
          <p:cNvPr id="8" name="Rectangle 7">
            <a:extLst>
              <a:ext uri="{FF2B5EF4-FFF2-40B4-BE49-F238E27FC236}">
                <a16:creationId xmlns:a16="http://schemas.microsoft.com/office/drawing/2014/main" id="{D030491D-5864-4845-B3B7-82ABD38F0071}"/>
              </a:ext>
            </a:extLst>
          </p:cNvPr>
          <p:cNvSpPr/>
          <p:nvPr/>
        </p:nvSpPr>
        <p:spPr>
          <a:xfrm>
            <a:off x="1312164" y="4555147"/>
            <a:ext cx="10684509" cy="461665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fr-FR" sz="1200" b="1" dirty="0">
                <a:latin typeface="Times New Roman"/>
                <a:cs typeface="Times New Roman"/>
              </a:rPr>
              <a:t>Figure S1 : </a:t>
            </a:r>
            <a:r>
              <a:rPr lang="fr-FR" sz="1200" dirty="0" err="1">
                <a:latin typeface="Times New Roman"/>
                <a:cs typeface="Times New Roman"/>
              </a:rPr>
              <a:t>Phenotypic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haracteristics</a:t>
            </a:r>
            <a:r>
              <a:rPr lang="fr-FR" sz="1200" dirty="0">
                <a:latin typeface="Times New Roman"/>
                <a:cs typeface="Times New Roman"/>
              </a:rPr>
              <a:t> of </a:t>
            </a:r>
            <a:r>
              <a:rPr lang="fr-FR" sz="1200" i="1" dirty="0">
                <a:latin typeface="Times New Roman"/>
                <a:cs typeface="Times New Roman"/>
              </a:rPr>
              <a:t>Leucobacter manosquensis</a:t>
            </a:r>
            <a:endParaRPr lang="fr-FR" sz="1200" dirty="0">
              <a:latin typeface="Times New Roman"/>
              <a:cs typeface="Times New Roman"/>
            </a:endParaRPr>
          </a:p>
          <a:p>
            <a:r>
              <a:rPr lang="fr-FR" sz="1200" dirty="0">
                <a:latin typeface="Times New Roman"/>
                <a:cs typeface="Times New Roman"/>
              </a:rPr>
              <a:t>A) Gram </a:t>
            </a:r>
            <a:r>
              <a:rPr lang="fr-FR" sz="1200" dirty="0" err="1">
                <a:latin typeface="Times New Roman"/>
                <a:cs typeface="Times New Roman"/>
              </a:rPr>
              <a:t>staining</a:t>
            </a:r>
            <a:r>
              <a:rPr lang="fr-FR" sz="1200" dirty="0">
                <a:latin typeface="Times New Roman"/>
                <a:cs typeface="Times New Roman"/>
              </a:rPr>
              <a:t> B) Colonies C) </a:t>
            </a:r>
            <a:r>
              <a:rPr lang="fr-FR" sz="1200" dirty="0" err="1">
                <a:latin typeface="Times New Roman"/>
                <a:cs typeface="Times New Roman"/>
              </a:rPr>
              <a:t>Motility</a:t>
            </a:r>
            <a:r>
              <a:rPr lang="fr-FR" sz="1200" dirty="0">
                <a:latin typeface="Times New Roman"/>
                <a:cs typeface="Times New Roman"/>
              </a:rPr>
              <a:t> test</a:t>
            </a:r>
          </a:p>
        </p:txBody>
      </p:sp>
    </p:spTree>
    <p:extLst>
      <p:ext uri="{BB962C8B-B14F-4D97-AF65-F5344CB8AC3E}">
        <p14:creationId xmlns:p14="http://schemas.microsoft.com/office/powerpoint/2010/main" val="11267451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7B38FB36-4974-43E8-ADFA-476761BF3B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187" y="1879710"/>
            <a:ext cx="7624917" cy="3889954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1967B0A9-1895-478D-93AC-44B5B1D0F4FA}"/>
              </a:ext>
            </a:extLst>
          </p:cNvPr>
          <p:cNvSpPr txBox="1"/>
          <p:nvPr/>
        </p:nvSpPr>
        <p:spPr>
          <a:xfrm>
            <a:off x="915051" y="1053836"/>
            <a:ext cx="1057890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fr-FR" sz="1200" b="1" dirty="0">
                <a:latin typeface="Times New Roman"/>
                <a:cs typeface="Times New Roman"/>
              </a:rPr>
              <a:t>Table S2 : </a:t>
            </a:r>
            <a:r>
              <a:rPr lang="fr-FR" sz="1200" dirty="0">
                <a:latin typeface="Times New Roman"/>
                <a:cs typeface="Times New Roman"/>
              </a:rPr>
              <a:t>Cellular </a:t>
            </a:r>
            <a:r>
              <a:rPr lang="fr-FR" sz="1200" dirty="0" err="1">
                <a:latin typeface="Times New Roman"/>
                <a:cs typeface="Times New Roman"/>
              </a:rPr>
              <a:t>fatty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acid</a:t>
            </a:r>
            <a:r>
              <a:rPr lang="fr-FR" sz="1200" dirty="0">
                <a:latin typeface="Times New Roman"/>
                <a:cs typeface="Times New Roman"/>
              </a:rPr>
              <a:t> composition (%) of </a:t>
            </a:r>
            <a:r>
              <a:rPr lang="fr-FR" sz="1200" i="1" dirty="0">
                <a:latin typeface="Times New Roman"/>
                <a:cs typeface="Times New Roman"/>
              </a:rPr>
              <a:t>Leucobacter manosquensis</a:t>
            </a:r>
          </a:p>
        </p:txBody>
      </p:sp>
    </p:spTree>
    <p:extLst>
      <p:ext uri="{BB962C8B-B14F-4D97-AF65-F5344CB8AC3E}">
        <p14:creationId xmlns:p14="http://schemas.microsoft.com/office/powerpoint/2010/main" val="2950954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14197C3D-3E89-4E21-BBF2-BC658EC0E9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7052945"/>
              </p:ext>
            </p:extLst>
          </p:nvPr>
        </p:nvGraphicFramePr>
        <p:xfrm>
          <a:off x="1051226" y="1156905"/>
          <a:ext cx="9164674" cy="5601709"/>
        </p:xfrm>
        <a:graphic>
          <a:graphicData uri="http://schemas.openxmlformats.org/drawingml/2006/table">
            <a:tbl>
              <a:tblPr/>
              <a:tblGrid>
                <a:gridCol w="2969896">
                  <a:extLst>
                    <a:ext uri="{9D8B030D-6E8A-4147-A177-3AD203B41FA5}">
                      <a16:colId xmlns:a16="http://schemas.microsoft.com/office/drawing/2014/main" val="2161329147"/>
                    </a:ext>
                  </a:extLst>
                </a:gridCol>
                <a:gridCol w="1439948">
                  <a:extLst>
                    <a:ext uri="{9D8B030D-6E8A-4147-A177-3AD203B41FA5}">
                      <a16:colId xmlns:a16="http://schemas.microsoft.com/office/drawing/2014/main" val="2929162794"/>
                    </a:ext>
                  </a:extLst>
                </a:gridCol>
                <a:gridCol w="1904932">
                  <a:extLst>
                    <a:ext uri="{9D8B030D-6E8A-4147-A177-3AD203B41FA5}">
                      <a16:colId xmlns:a16="http://schemas.microsoft.com/office/drawing/2014/main" val="881258321"/>
                    </a:ext>
                  </a:extLst>
                </a:gridCol>
                <a:gridCol w="1454948">
                  <a:extLst>
                    <a:ext uri="{9D8B030D-6E8A-4147-A177-3AD203B41FA5}">
                      <a16:colId xmlns:a16="http://schemas.microsoft.com/office/drawing/2014/main" val="2535386025"/>
                    </a:ext>
                  </a:extLst>
                </a:gridCol>
                <a:gridCol w="1394950">
                  <a:extLst>
                    <a:ext uri="{9D8B030D-6E8A-4147-A177-3AD203B41FA5}">
                      <a16:colId xmlns:a16="http://schemas.microsoft.com/office/drawing/2014/main" val="3154880208"/>
                    </a:ext>
                  </a:extLst>
                </a:gridCol>
              </a:tblGrid>
              <a:tr h="456087"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</a:t>
                      </a:r>
                      <a:r>
                        <a:rPr lang="fr-FR" sz="11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nosquensis</a:t>
                      </a:r>
                      <a:r>
                        <a:rPr lang="fr-FR" sz="11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</a:t>
                      </a:r>
                      <a:r>
                        <a:rPr lang="fr-FR" sz="11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hromiiresistens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</a:t>
                      </a:r>
                      <a:r>
                        <a:rPr lang="fr-FR" sz="11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usarum</a:t>
                      </a:r>
                      <a:r>
                        <a:rPr lang="fr-FR" sz="11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bsp</a:t>
                      </a:r>
                      <a:r>
                        <a:rPr lang="fr-FR" sz="11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. </a:t>
                      </a:r>
                      <a:r>
                        <a:rPr lang="fr-FR" sz="11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Japonicus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</a:t>
                      </a:r>
                      <a:r>
                        <a:rPr lang="fr-FR" sz="11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usarum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528478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operties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rseille-Q4368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JG 31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BX 130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BX 152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3260771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ell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ameter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µm )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4 x 0.3 µm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3-0.4 x 0.74-1.4 µm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149824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xygen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equirement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acultativ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erobic</a:t>
                      </a:r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erobic</a:t>
                      </a:r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erobic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9987433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am </a:t>
                      </a:r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ain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7263953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otility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3515896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ndospore formation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580499"/>
                  </a:ext>
                </a:extLst>
              </a:tr>
              <a:tr h="335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ptimum temperature for growth (°C)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0-37°C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0°C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0°C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0°C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8574224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Production of :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1621550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lkaline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phosphatase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/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8334119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tala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1341663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xidase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8363836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α-g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ucosida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4567745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β-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alactosida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 </a:t>
                      </a:r>
                      <a:endParaRPr lang="fr-FR"/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3826699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Acid </a:t>
                      </a:r>
                      <a:r>
                        <a:rPr lang="fr-FR" sz="1100" b="1" i="0" u="none" strike="noStrike" dirty="0" err="1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from</a:t>
                      </a:r>
                      <a:r>
                        <a:rPr lang="fr-FR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/>
                        </a:rPr>
                        <a:t> :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338279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-acetylglucosamine</a:t>
                      </a:r>
                      <a:r>
                        <a:rPr lang="fr-FR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7855054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-arabinose</a:t>
                      </a:r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1847150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-ribo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9427962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-manno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1461504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-mannitol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820914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-gluco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2249994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-fructo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693526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-malto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+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/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3315994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-lactos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5419586"/>
                  </a:ext>
                </a:extLst>
              </a:tr>
              <a:tr h="16797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+C content (mol%)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7.34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6.76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6.77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1013828"/>
                  </a:ext>
                </a:extLst>
              </a:tr>
              <a:tr h="69291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solation source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uman </a:t>
                      </a:r>
                      <a:r>
                        <a:rPr lang="fr-F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ealthy</a:t>
                      </a:r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skin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fr-FR" sz="1100" b="0" i="0" u="none" strike="noStrike" noProof="0">
                          <a:effectLst/>
                          <a:latin typeface="Times New Roman"/>
                        </a:rPr>
                        <a:t>An </a:t>
                      </a:r>
                      <a:r>
                        <a:rPr lang="fr-FR" sz="1100" b="0" i="0" u="none" strike="noStrike" noProof="0" err="1">
                          <a:effectLst/>
                          <a:latin typeface="Times New Roman"/>
                        </a:rPr>
                        <a:t>uncontaminated</a:t>
                      </a:r>
                      <a:r>
                        <a:rPr lang="fr-FR" sz="1100" b="0" i="0" u="none" strike="noStrike" noProof="0"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1100" b="0" i="0" u="none" strike="noStrike" noProof="0" err="1">
                          <a:effectLst/>
                          <a:latin typeface="Times New Roman"/>
                        </a:rPr>
                        <a:t>soil</a:t>
                      </a:r>
                      <a:r>
                        <a:rPr lang="fr-FR" sz="1100" b="0" i="0" u="none" strike="noStrike" noProof="0">
                          <a:effectLst/>
                          <a:latin typeface="Times New Roman"/>
                        </a:rPr>
                        <a:t> at the </a:t>
                      </a:r>
                      <a:r>
                        <a:rPr lang="fr-FR" sz="1100" b="0" i="0" u="none" strike="noStrike" noProof="0" err="1">
                          <a:effectLst/>
                          <a:latin typeface="Times New Roman"/>
                        </a:rPr>
                        <a:t>University</a:t>
                      </a:r>
                      <a:r>
                        <a:rPr lang="fr-FR" sz="1100" b="0" i="0" u="none" strike="noStrike" noProof="0">
                          <a:effectLst/>
                          <a:latin typeface="Times New Roman"/>
                        </a:rPr>
                        <a:t> of Freiburg, Germany</a:t>
                      </a:r>
                      <a:endParaRPr lang="fr-FR" sz="1100">
                        <a:latin typeface="Times New Roman"/>
                      </a:endParaRP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matodes</a:t>
                      </a:r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pt-B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llected</a:t>
                      </a:r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pt-B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rom</a:t>
                      </a:r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Santa </a:t>
                      </a:r>
                      <a:r>
                        <a:rPr lang="pt-BR" sz="11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o</a:t>
                      </a:r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Cabo Verd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matodes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llected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rom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Santa </a:t>
                      </a:r>
                      <a:r>
                        <a:rPr lang="pt-B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tao</a:t>
                      </a:r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Cabo Verde </a:t>
                      </a:r>
                    </a:p>
                  </a:txBody>
                  <a:tcPr marL="6711" marR="6711" marT="67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361263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B41B8D2F-CDBE-4D9D-A08A-1E598664E786}"/>
              </a:ext>
            </a:extLst>
          </p:cNvPr>
          <p:cNvSpPr txBox="1"/>
          <p:nvPr/>
        </p:nvSpPr>
        <p:spPr>
          <a:xfrm>
            <a:off x="853142" y="552306"/>
            <a:ext cx="10370773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fr-FR" sz="1200" b="1" dirty="0">
                <a:latin typeface="Times New Roman"/>
                <a:cs typeface="Times New Roman"/>
              </a:rPr>
              <a:t>Table S3 : </a:t>
            </a:r>
            <a:r>
              <a:rPr lang="fr-FR" sz="1200" dirty="0" err="1">
                <a:latin typeface="Times New Roman"/>
                <a:cs typeface="Times New Roman"/>
              </a:rPr>
              <a:t>Differential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phenotypic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haracteristics</a:t>
            </a:r>
            <a:r>
              <a:rPr lang="fr-FR" sz="1200" dirty="0">
                <a:latin typeface="Times New Roman"/>
                <a:cs typeface="Times New Roman"/>
              </a:rPr>
              <a:t> of </a:t>
            </a:r>
            <a:r>
              <a:rPr lang="fr-FR" sz="1200" i="1" dirty="0">
                <a:latin typeface="Times New Roman"/>
                <a:cs typeface="Times New Roman"/>
              </a:rPr>
              <a:t>Leucobacter manosquensis</a:t>
            </a:r>
            <a:r>
              <a:rPr lang="fr-FR" sz="1200" dirty="0">
                <a:latin typeface="Times New Roman"/>
                <a:cs typeface="Times New Roman"/>
              </a:rPr>
              <a:t> strain Marseille-Q4368 and </a:t>
            </a:r>
            <a:r>
              <a:rPr lang="fr-FR" sz="1200" dirty="0" err="1">
                <a:latin typeface="Times New Roman"/>
                <a:cs typeface="Times New Roman"/>
              </a:rPr>
              <a:t>closely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relat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pecies</a:t>
            </a:r>
            <a:endParaRPr lang="fr-FR" sz="1200" i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517287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C66A288E-44D7-4AA3-9AFC-9356997877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6949712"/>
              </p:ext>
            </p:extLst>
          </p:nvPr>
        </p:nvGraphicFramePr>
        <p:xfrm>
          <a:off x="1004866" y="285059"/>
          <a:ext cx="10455965" cy="5645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4AF18DD0-3CDE-46F3-B12F-7718A385427E}"/>
              </a:ext>
            </a:extLst>
          </p:cNvPr>
          <p:cNvSpPr/>
          <p:nvPr/>
        </p:nvSpPr>
        <p:spPr>
          <a:xfrm>
            <a:off x="843677" y="6106818"/>
            <a:ext cx="10272056" cy="461665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200" b="1" dirty="0">
                <a:latin typeface="Times New Roman"/>
                <a:ea typeface="Times New Roman" panose="02020603050405020304" pitchFamily="18" charset="0"/>
                <a:cs typeface="Times New Roman"/>
              </a:rPr>
              <a:t>Figure S2 :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Distribution of functional classes of predicted genes according to the clusters of orthologous groups of proteins of Marseille-Q4368 and its closely related species. 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84661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au 2">
            <a:extLst>
              <a:ext uri="{FF2B5EF4-FFF2-40B4-BE49-F238E27FC236}">
                <a16:creationId xmlns:a16="http://schemas.microsoft.com/office/drawing/2014/main" id="{7EEC5E58-FCD5-432E-943B-2CB4B7D5FF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9110718"/>
              </p:ext>
            </p:extLst>
          </p:nvPr>
        </p:nvGraphicFramePr>
        <p:xfrm>
          <a:off x="1252116" y="791806"/>
          <a:ext cx="4835815" cy="5826119"/>
        </p:xfrm>
        <a:graphic>
          <a:graphicData uri="http://schemas.openxmlformats.org/drawingml/2006/table">
            <a:tbl>
              <a:tblPr/>
              <a:tblGrid>
                <a:gridCol w="2295903">
                  <a:extLst>
                    <a:ext uri="{9D8B030D-6E8A-4147-A177-3AD203B41FA5}">
                      <a16:colId xmlns:a16="http://schemas.microsoft.com/office/drawing/2014/main" val="4067011850"/>
                    </a:ext>
                  </a:extLst>
                </a:gridCol>
                <a:gridCol w="2539912">
                  <a:extLst>
                    <a:ext uri="{9D8B030D-6E8A-4147-A177-3AD203B41FA5}">
                      <a16:colId xmlns:a16="http://schemas.microsoft.com/office/drawing/2014/main" val="1811833406"/>
                    </a:ext>
                  </a:extLst>
                </a:gridCol>
              </a:tblGrid>
              <a:tr h="102946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ype of description </a:t>
                      </a:r>
                      <a:endParaRPr lang="fr-FR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w description </a:t>
                      </a:r>
                      <a:endParaRPr lang="fr-FR" sz="7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6250736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ecies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me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nosquensis</a:t>
                      </a:r>
                      <a:r>
                        <a:rPr lang="fr-FR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3186981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us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am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7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2179190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ecific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pithet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5923847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ecies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atus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.nov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.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1242434"/>
                  </a:ext>
                </a:extLst>
              </a:tr>
              <a:tr h="1016594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ecies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tymology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. masc. adj. [</a:t>
                      </a:r>
                      <a:r>
                        <a:rPr lang="el-G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λευκός</a:t>
                      </a:r>
                      <a:r>
                        <a:rPr lang="el-G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]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eukos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lear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light; N.L. masc. n.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acter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od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; N.L. masc. n.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eucobacter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lorless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od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.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nosquenseis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ranslitt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. L. adj., ‘of Manosque,’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eferring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to the place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where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M&amp;L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aboratories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one of the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ounders</a:t>
                      </a:r>
                      <a:r>
                        <a:rPr lang="fr-FR" sz="7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 are </a:t>
                      </a:r>
                      <a:r>
                        <a:rPr lang="fr-FR" sz="700" b="1" i="1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ocated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844546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esignation of the type strain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rseille-Q4368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3549992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rain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collection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umber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SUR Q4368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5831848"/>
                  </a:ext>
                </a:extLst>
              </a:tr>
              <a:tr h="154419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6S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RNA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accession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umber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W583464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5624910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om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accession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umber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JAFEVO000000000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3867082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om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atus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Whol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om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3824364"/>
                  </a:ext>
                </a:extLst>
              </a:tr>
              <a:tr h="1801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om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size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,184,602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7616784"/>
                  </a:ext>
                </a:extLst>
              </a:tr>
              <a:tr h="1801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C%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7.34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9900585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untry of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rigin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rseille, France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7051674"/>
                  </a:ext>
                </a:extLst>
              </a:tr>
              <a:tr h="154419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ate of isolation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ugust 2020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8380320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ource of isolation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uman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ealthy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skin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508641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medium, incubation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outinely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COS, 31°C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8258033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ditions used for standard cultivation 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1°C in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erobiosis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6826740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am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ain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ositive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4187319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ell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hap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acille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4122663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ell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size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 x 1.4 µm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6397759"/>
                  </a:ext>
                </a:extLst>
              </a:tr>
              <a:tr h="1801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otility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gative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2437809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orulation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gativ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4554903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lony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orphology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ircular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1724616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emperatur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range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0-56°C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3916559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emperature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optimum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0-37°C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3668103"/>
                  </a:ext>
                </a:extLst>
              </a:tr>
              <a:tr h="154419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elationship to O2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acultative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1582325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2 for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train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esting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naerobiosis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icroaerophilic</a:t>
                      </a:r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</a:t>
                      </a:r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erobiosis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1821332"/>
                  </a:ext>
                </a:extLst>
              </a:tr>
              <a:tr h="16728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Oxidase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egative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1710837"/>
                  </a:ext>
                </a:extLst>
              </a:tr>
              <a:tr h="1801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atalase </a:t>
                      </a:r>
                      <a:endParaRPr lang="fr-FR" sz="7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fr-F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ositive</a:t>
                      </a:r>
                    </a:p>
                  </a:txBody>
                  <a:tcPr marL="5920" marR="5920" marT="59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7783285"/>
                  </a:ext>
                </a:extLst>
              </a:tr>
            </a:tbl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892DF8FF-4D99-4526-BA88-A2AC6772D690}"/>
              </a:ext>
            </a:extLst>
          </p:cNvPr>
          <p:cNvSpPr txBox="1"/>
          <p:nvPr/>
        </p:nvSpPr>
        <p:spPr>
          <a:xfrm>
            <a:off x="977900" y="266959"/>
            <a:ext cx="788670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b="1" dirty="0">
                <a:solidFill>
                  <a:srgbClr val="333333"/>
                </a:solidFill>
                <a:latin typeface="Times New Roman"/>
                <a:cs typeface="Segoe UI"/>
              </a:rPr>
              <a:t>Table S4 : </a:t>
            </a:r>
            <a:r>
              <a:rPr lang="en-US" sz="1200" dirty="0">
                <a:solidFill>
                  <a:srgbClr val="333333"/>
                </a:solidFill>
                <a:latin typeface="Times New Roman"/>
                <a:cs typeface="Segoe UI"/>
              </a:rPr>
              <a:t>Description of</a:t>
            </a:r>
            <a:r>
              <a:rPr lang="en-US" sz="1200" i="1" dirty="0">
                <a:solidFill>
                  <a:srgbClr val="333333"/>
                </a:solidFill>
                <a:latin typeface="Times New Roman"/>
                <a:cs typeface="Segoe UI"/>
              </a:rPr>
              <a:t> </a:t>
            </a:r>
            <a:r>
              <a:rPr lang="en-US" sz="1200" i="1" dirty="0" err="1">
                <a:solidFill>
                  <a:srgbClr val="333333"/>
                </a:solidFill>
                <a:latin typeface="Times New Roman"/>
                <a:cs typeface="Segoe UI"/>
              </a:rPr>
              <a:t>Leucobacter</a:t>
            </a:r>
            <a:r>
              <a:rPr lang="en-US" sz="1200" i="1" dirty="0">
                <a:solidFill>
                  <a:srgbClr val="333333"/>
                </a:solidFill>
                <a:latin typeface="Times New Roman"/>
                <a:cs typeface="Segoe UI"/>
              </a:rPr>
              <a:t> </a:t>
            </a:r>
            <a:r>
              <a:rPr lang="en-US" sz="1200" i="1" dirty="0" err="1">
                <a:solidFill>
                  <a:srgbClr val="333333"/>
                </a:solidFill>
                <a:latin typeface="Times New Roman"/>
                <a:cs typeface="Segoe UI"/>
              </a:rPr>
              <a:t>manosquensis</a:t>
            </a:r>
            <a:r>
              <a:rPr lang="en-US" sz="1200" i="1" dirty="0">
                <a:solidFill>
                  <a:srgbClr val="333333"/>
                </a:solidFill>
                <a:latin typeface="Times New Roman"/>
                <a:cs typeface="Segoe UI"/>
              </a:rPr>
              <a:t> </a:t>
            </a:r>
            <a:r>
              <a:rPr lang="en-US" sz="1200" dirty="0">
                <a:solidFill>
                  <a:srgbClr val="333333"/>
                </a:solidFill>
                <a:latin typeface="Times New Roman"/>
                <a:cs typeface="Segoe UI"/>
              </a:rPr>
              <a:t>strain Marseille-Q4368</a:t>
            </a:r>
            <a:endParaRPr lang="en-US" sz="1200" dirty="0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8042447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683B863A5EF7B47BD2E30A7A67D94D8" ma:contentTypeVersion="4" ma:contentTypeDescription="Crée un document." ma:contentTypeScope="" ma:versionID="6ca8464e056e85a62a5876f570e7a913">
  <xsd:schema xmlns:xsd="http://www.w3.org/2001/XMLSchema" xmlns:xs="http://www.w3.org/2001/XMLSchema" xmlns:p="http://schemas.microsoft.com/office/2006/metadata/properties" xmlns:ns2="98a462f8-a1c4-4cd5-b7c3-7675423ba460" targetNamespace="http://schemas.microsoft.com/office/2006/metadata/properties" ma:root="true" ma:fieldsID="e7a7c1a956a3bee49a5834539ea574bc" ns2:_="">
    <xsd:import namespace="98a462f8-a1c4-4cd5-b7c3-7675423ba46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8a462f8-a1c4-4cd5-b7c3-7675423ba46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EBA3B47-9DE2-49FC-A53A-B7E614B8D541}">
  <ds:schemaRefs>
    <ds:schemaRef ds:uri="98a462f8-a1c4-4cd5-b7c3-7675423ba460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ADA8D9FA-38D0-42ED-8454-3E14A77C8E4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E0C9183-6C1C-4413-9A10-F8D1730310BE}">
  <ds:schemaRefs>
    <ds:schemaRef ds:uri="98a462f8-a1c4-4cd5-b7c3-7675423ba460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266</TotalTime>
  <Words>659</Words>
  <Application>Microsoft Macintosh PowerPoint</Application>
  <PresentationFormat>Grand écran</PresentationFormat>
  <Paragraphs>233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viewer</dc:creator>
  <cp:lastModifiedBy>Nadim Cassir</cp:lastModifiedBy>
  <cp:revision>4</cp:revision>
  <dcterms:created xsi:type="dcterms:W3CDTF">2021-06-02T07:47:17Z</dcterms:created>
  <dcterms:modified xsi:type="dcterms:W3CDTF">2023-10-10T21:12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683B863A5EF7B47BD2E30A7A67D94D8</vt:lpwstr>
  </property>
</Properties>
</file>